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5"/>
  </p:sldMasterIdLst>
  <p:notesMasterIdLst>
    <p:notesMasterId r:id="rId14"/>
  </p:notesMasterIdLst>
  <p:sldIdLst>
    <p:sldId id="270" r:id="rId6"/>
    <p:sldId id="264" r:id="rId7"/>
    <p:sldId id="263" r:id="rId8"/>
    <p:sldId id="266" r:id="rId9"/>
    <p:sldId id="268" r:id="rId10"/>
    <p:sldId id="269" r:id="rId11"/>
    <p:sldId id="272" r:id="rId12"/>
    <p:sldId id="273"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element" id="{E0DCD054-5B35-4DBB-8C09-D608708D9393}">
          <p14:sldIdLst>
            <p14:sldId id="270"/>
            <p14:sldId id="264"/>
            <p14:sldId id="263"/>
            <p14:sldId id="266"/>
            <p14:sldId id="268"/>
            <p14:sldId id="269"/>
            <p14:sldId id="272"/>
            <p14:sldId id="273"/>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01F00F05-B3BA-BB28-4C4D-3A3BC2EFB8B7}" name="LC" initials="LC" userId="LC" providerId="None"/>
  <p188:author id="{B87DD3E3-274E-9DE3-6698-6A9749772ED8}" name="Hayashida, Ayaka" initials="AH" userId="S::wnx6396@corp.jti.com::14cb5ab0-815a-4b6d-80c2-d4f49147893d"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1BB96"/>
    <a:srgbClr val="FF8856"/>
    <a:srgbClr val="2AAC86"/>
    <a:srgbClr val="3E7DC9"/>
    <a:srgbClr val="3D454F"/>
    <a:srgbClr val="31B08C"/>
    <a:srgbClr val="000000"/>
    <a:srgbClr val="434343"/>
    <a:srgbClr val="515153"/>
    <a:srgbClr val="60606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CC6FF14-8068-4DC5-9295-7ED55786EBF1}" v="20" dt="2025-08-24T23:32:47.167"/>
    <p1510:client id="{4E5FC6B4-A1D5-43AE-AB4E-E2E652BA8DC8}" v="37" dt="2025-08-25T04:36:51.19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367" autoAdjust="0"/>
    <p:restoredTop sz="75061" autoAdjust="0"/>
  </p:normalViewPr>
  <p:slideViewPr>
    <p:cSldViewPr snapToGrid="0">
      <p:cViewPr>
        <p:scale>
          <a:sx n="33" d="100"/>
          <a:sy n="33" d="100"/>
        </p:scale>
        <p:origin x="2788"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tableStyles" Target="tableStyles.xml"/><Relationship Id="rId3" Type="http://schemas.openxmlformats.org/officeDocument/2006/relationships/customXml" Target="../customXml/item3.xml"/><Relationship Id="rId21" Type="http://schemas.microsoft.com/office/2018/10/relationships/authors" Target="author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1.xml"/><Relationship Id="rId15" Type="http://schemas.openxmlformats.org/officeDocument/2006/relationships/presProps" Target="presProps.xml"/><Relationship Id="rId10" Type="http://schemas.openxmlformats.org/officeDocument/2006/relationships/slide" Target="slides/slide5.xml"/><Relationship Id="rId19" Type="http://schemas.microsoft.com/office/2016/11/relationships/changesInfo" Target="changesInfos/changesInfo1.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ayashida, Ayaka" userId="14cb5ab0-815a-4b6d-80c2-d4f49147893d" providerId="ADAL" clId="{4CC6FF14-8068-4DC5-9295-7ED55786EBF1}"/>
    <pc:docChg chg="undo redo custSel modSld">
      <pc:chgData name="Hayashida, Ayaka" userId="14cb5ab0-815a-4b6d-80c2-d4f49147893d" providerId="ADAL" clId="{4CC6FF14-8068-4DC5-9295-7ED55786EBF1}" dt="2025-08-24T23:32:47.167" v="62" actId="164"/>
      <pc:docMkLst>
        <pc:docMk/>
      </pc:docMkLst>
      <pc:sldChg chg="addSp delSp modSp mod modCm">
        <pc:chgData name="Hayashida, Ayaka" userId="14cb5ab0-815a-4b6d-80c2-d4f49147893d" providerId="ADAL" clId="{4CC6FF14-8068-4DC5-9295-7ED55786EBF1}" dt="2025-08-24T23:26:00.579" v="19" actId="1076"/>
        <pc:sldMkLst>
          <pc:docMk/>
          <pc:sldMk cId="4055272036" sldId="263"/>
        </pc:sldMkLst>
        <pc:spChg chg="add">
          <ac:chgData name="Hayashida, Ayaka" userId="14cb5ab0-815a-4b6d-80c2-d4f49147893d" providerId="ADAL" clId="{4CC6FF14-8068-4DC5-9295-7ED55786EBF1}" dt="2025-08-24T23:25:08.932" v="0"/>
          <ac:spMkLst>
            <pc:docMk/>
            <pc:sldMk cId="4055272036" sldId="263"/>
            <ac:spMk id="2" creationId="{636E73D1-DFBA-8123-BC78-975A8856CEC4}"/>
          </ac:spMkLst>
        </pc:spChg>
        <pc:spChg chg="mod">
          <ac:chgData name="Hayashida, Ayaka" userId="14cb5ab0-815a-4b6d-80c2-d4f49147893d" providerId="ADAL" clId="{4CC6FF14-8068-4DC5-9295-7ED55786EBF1}" dt="2025-08-24T23:25:26.094" v="6" actId="1076"/>
          <ac:spMkLst>
            <pc:docMk/>
            <pc:sldMk cId="4055272036" sldId="263"/>
            <ac:spMk id="5" creationId="{9AC43297-D3EC-0A43-4B1F-2DE8051F344D}"/>
          </ac:spMkLst>
        </pc:spChg>
        <pc:spChg chg="add mod">
          <ac:chgData name="Hayashida, Ayaka" userId="14cb5ab0-815a-4b6d-80c2-d4f49147893d" providerId="ADAL" clId="{4CC6FF14-8068-4DC5-9295-7ED55786EBF1}" dt="2025-08-24T23:25:55.315" v="18" actId="164"/>
          <ac:spMkLst>
            <pc:docMk/>
            <pc:sldMk cId="4055272036" sldId="263"/>
            <ac:spMk id="7" creationId="{FA9735AB-CBA9-0CEB-832A-7FFAB7329E8D}"/>
          </ac:spMkLst>
        </pc:spChg>
        <pc:grpChg chg="add del mod">
          <ac:chgData name="Hayashida, Ayaka" userId="14cb5ab0-815a-4b6d-80c2-d4f49147893d" providerId="ADAL" clId="{4CC6FF14-8068-4DC5-9295-7ED55786EBF1}" dt="2025-08-24T23:25:47.734" v="16" actId="478"/>
          <ac:grpSpMkLst>
            <pc:docMk/>
            <pc:sldMk cId="4055272036" sldId="263"/>
            <ac:grpSpMk id="18" creationId="{E097CA58-A34D-A581-3F24-407213775052}"/>
          </ac:grpSpMkLst>
        </pc:grpChg>
        <pc:grpChg chg="add mod">
          <ac:chgData name="Hayashida, Ayaka" userId="14cb5ab0-815a-4b6d-80c2-d4f49147893d" providerId="ADAL" clId="{4CC6FF14-8068-4DC5-9295-7ED55786EBF1}" dt="2025-08-24T23:26:00.579" v="19" actId="1076"/>
          <ac:grpSpMkLst>
            <pc:docMk/>
            <pc:sldMk cId="4055272036" sldId="263"/>
            <ac:grpSpMk id="19" creationId="{44CAFAD8-35E2-9E06-C045-12433DE2913A}"/>
          </ac:grpSpMkLst>
        </pc:grpChg>
        <pc:picChg chg="add mod ord">
          <ac:chgData name="Hayashida, Ayaka" userId="14cb5ab0-815a-4b6d-80c2-d4f49147893d" providerId="ADAL" clId="{4CC6FF14-8068-4DC5-9295-7ED55786EBF1}" dt="2025-08-24T23:25:55.315" v="18" actId="164"/>
          <ac:picMkLst>
            <pc:docMk/>
            <pc:sldMk cId="4055272036" sldId="263"/>
            <ac:picMk id="3" creationId="{F9C9F729-9EBA-6A26-19AE-79737A1656D8}"/>
          </ac:picMkLst>
        </pc:picChg>
        <pc:extLst>
          <p:ext xmlns:p="http://schemas.openxmlformats.org/presentationml/2006/main" uri="{D6D511B9-2390-475A-947B-AFAB55BFBCF1}">
            <pc226:cmChg xmlns:pc226="http://schemas.microsoft.com/office/powerpoint/2022/06/main/command" chg="mod">
              <pc226:chgData name="Hayashida, Ayaka" userId="14cb5ab0-815a-4b6d-80c2-d4f49147893d" providerId="ADAL" clId="{4CC6FF14-8068-4DC5-9295-7ED55786EBF1}" dt="2025-08-24T23:25:38.624" v="10" actId="478"/>
              <pc2:cmMkLst xmlns:pc2="http://schemas.microsoft.com/office/powerpoint/2019/9/main/command">
                <pc:docMk/>
                <pc:sldMk cId="4055272036" sldId="263"/>
                <pc2:cmMk id="{96AA7CE2-5937-403D-B89A-2DE490C1349C}"/>
              </pc2:cmMkLst>
            </pc226:cmChg>
          </p:ext>
        </pc:extLst>
      </pc:sldChg>
      <pc:sldChg chg="addSp delSp modSp mod">
        <pc:chgData name="Hayashida, Ayaka" userId="14cb5ab0-815a-4b6d-80c2-d4f49147893d" providerId="ADAL" clId="{4CC6FF14-8068-4DC5-9295-7ED55786EBF1}" dt="2025-08-24T23:32:47.167" v="62" actId="164"/>
        <pc:sldMkLst>
          <pc:docMk/>
          <pc:sldMk cId="2777100696" sldId="266"/>
        </pc:sldMkLst>
        <pc:spChg chg="add">
          <ac:chgData name="Hayashida, Ayaka" userId="14cb5ab0-815a-4b6d-80c2-d4f49147893d" providerId="ADAL" clId="{4CC6FF14-8068-4DC5-9295-7ED55786EBF1}" dt="2025-08-24T23:29:09.983" v="20"/>
          <ac:spMkLst>
            <pc:docMk/>
            <pc:sldMk cId="2777100696" sldId="266"/>
            <ac:spMk id="2" creationId="{A9D7A5E1-9E7E-9571-3D88-C455C1C2C8FC}"/>
          </ac:spMkLst>
        </pc:spChg>
        <pc:spChg chg="add">
          <ac:chgData name="Hayashida, Ayaka" userId="14cb5ab0-815a-4b6d-80c2-d4f49147893d" providerId="ADAL" clId="{4CC6FF14-8068-4DC5-9295-7ED55786EBF1}" dt="2025-08-24T23:29:50.482" v="25"/>
          <ac:spMkLst>
            <pc:docMk/>
            <pc:sldMk cId="2777100696" sldId="266"/>
            <ac:spMk id="6" creationId="{A24D02C9-FC94-731D-BC9E-EFB944437DF4}"/>
          </ac:spMkLst>
        </pc:spChg>
        <pc:spChg chg="mod">
          <ac:chgData name="Hayashida, Ayaka" userId="14cb5ab0-815a-4b6d-80c2-d4f49147893d" providerId="ADAL" clId="{4CC6FF14-8068-4DC5-9295-7ED55786EBF1}" dt="2025-08-24T23:30:43.377" v="36" actId="165"/>
          <ac:spMkLst>
            <pc:docMk/>
            <pc:sldMk cId="2777100696" sldId="266"/>
            <ac:spMk id="11" creationId="{CFF4E15B-4DAC-7103-5E33-0C9A4284767D}"/>
          </ac:spMkLst>
        </pc:spChg>
        <pc:spChg chg="mod">
          <ac:chgData name="Hayashida, Ayaka" userId="14cb5ab0-815a-4b6d-80c2-d4f49147893d" providerId="ADAL" clId="{4CC6FF14-8068-4DC5-9295-7ED55786EBF1}" dt="2025-08-24T23:30:43.377" v="36" actId="165"/>
          <ac:spMkLst>
            <pc:docMk/>
            <pc:sldMk cId="2777100696" sldId="266"/>
            <ac:spMk id="12" creationId="{AA7319B3-B9CF-7665-8A01-4BDCA6746633}"/>
          </ac:spMkLst>
        </pc:spChg>
        <pc:spChg chg="mod">
          <ac:chgData name="Hayashida, Ayaka" userId="14cb5ab0-815a-4b6d-80c2-d4f49147893d" providerId="ADAL" clId="{4CC6FF14-8068-4DC5-9295-7ED55786EBF1}" dt="2025-08-24T23:30:43.377" v="36" actId="165"/>
          <ac:spMkLst>
            <pc:docMk/>
            <pc:sldMk cId="2777100696" sldId="266"/>
            <ac:spMk id="13" creationId="{6D6E0EA5-2796-3E0D-BE68-39EB184A2561}"/>
          </ac:spMkLst>
        </pc:spChg>
        <pc:spChg chg="mod">
          <ac:chgData name="Hayashida, Ayaka" userId="14cb5ab0-815a-4b6d-80c2-d4f49147893d" providerId="ADAL" clId="{4CC6FF14-8068-4DC5-9295-7ED55786EBF1}" dt="2025-08-24T23:31:37.026" v="45" actId="165"/>
          <ac:spMkLst>
            <pc:docMk/>
            <pc:sldMk cId="2777100696" sldId="266"/>
            <ac:spMk id="15" creationId="{D4194885-6230-8B12-F8CA-734FD635E17F}"/>
          </ac:spMkLst>
        </pc:spChg>
        <pc:spChg chg="mod">
          <ac:chgData name="Hayashida, Ayaka" userId="14cb5ab0-815a-4b6d-80c2-d4f49147893d" providerId="ADAL" clId="{4CC6FF14-8068-4DC5-9295-7ED55786EBF1}" dt="2025-08-24T23:31:37.026" v="45" actId="165"/>
          <ac:spMkLst>
            <pc:docMk/>
            <pc:sldMk cId="2777100696" sldId="266"/>
            <ac:spMk id="16" creationId="{B994FBEE-96E6-4A82-50F9-4E26713C011C}"/>
          </ac:spMkLst>
        </pc:spChg>
        <pc:spChg chg="mod">
          <ac:chgData name="Hayashida, Ayaka" userId="14cb5ab0-815a-4b6d-80c2-d4f49147893d" providerId="ADAL" clId="{4CC6FF14-8068-4DC5-9295-7ED55786EBF1}" dt="2025-08-24T23:31:37.026" v="45" actId="165"/>
          <ac:spMkLst>
            <pc:docMk/>
            <pc:sldMk cId="2777100696" sldId="266"/>
            <ac:spMk id="18" creationId="{9AD89FE1-1F9D-B039-9181-F7AFFDCDEDBD}"/>
          </ac:spMkLst>
        </pc:spChg>
        <pc:spChg chg="mod">
          <ac:chgData name="Hayashida, Ayaka" userId="14cb5ab0-815a-4b6d-80c2-d4f49147893d" providerId="ADAL" clId="{4CC6FF14-8068-4DC5-9295-7ED55786EBF1}" dt="2025-08-24T23:31:37.026" v="45" actId="165"/>
          <ac:spMkLst>
            <pc:docMk/>
            <pc:sldMk cId="2777100696" sldId="266"/>
            <ac:spMk id="19" creationId="{231B018A-8F7C-2FBC-2645-CC0A90051C0D}"/>
          </ac:spMkLst>
        </pc:spChg>
        <pc:spChg chg="add">
          <ac:chgData name="Hayashida, Ayaka" userId="14cb5ab0-815a-4b6d-80c2-d4f49147893d" providerId="ADAL" clId="{4CC6FF14-8068-4DC5-9295-7ED55786EBF1}" dt="2025-08-24T23:30:15.369" v="27"/>
          <ac:spMkLst>
            <pc:docMk/>
            <pc:sldMk cId="2777100696" sldId="266"/>
            <ac:spMk id="21" creationId="{6D34A286-2C60-269F-32EC-54B7D1F8E9FF}"/>
          </ac:spMkLst>
        </pc:spChg>
        <pc:spChg chg="mod">
          <ac:chgData name="Hayashida, Ayaka" userId="14cb5ab0-815a-4b6d-80c2-d4f49147893d" providerId="ADAL" clId="{4CC6FF14-8068-4DC5-9295-7ED55786EBF1}" dt="2025-08-24T23:32:03.008" v="52" actId="165"/>
          <ac:spMkLst>
            <pc:docMk/>
            <pc:sldMk cId="2777100696" sldId="266"/>
            <ac:spMk id="22" creationId="{7F3DE597-6BFF-99C3-E8C6-3AD932453CB3}"/>
          </ac:spMkLst>
        </pc:spChg>
        <pc:spChg chg="mod">
          <ac:chgData name="Hayashida, Ayaka" userId="14cb5ab0-815a-4b6d-80c2-d4f49147893d" providerId="ADAL" clId="{4CC6FF14-8068-4DC5-9295-7ED55786EBF1}" dt="2025-08-24T23:32:03.008" v="52" actId="165"/>
          <ac:spMkLst>
            <pc:docMk/>
            <pc:sldMk cId="2777100696" sldId="266"/>
            <ac:spMk id="23" creationId="{3DC8F4D2-39D5-7ABF-B2EC-48B973C5AE28}"/>
          </ac:spMkLst>
        </pc:spChg>
        <pc:spChg chg="mod">
          <ac:chgData name="Hayashida, Ayaka" userId="14cb5ab0-815a-4b6d-80c2-d4f49147893d" providerId="ADAL" clId="{4CC6FF14-8068-4DC5-9295-7ED55786EBF1}" dt="2025-08-24T23:32:03.008" v="52" actId="165"/>
          <ac:spMkLst>
            <pc:docMk/>
            <pc:sldMk cId="2777100696" sldId="266"/>
            <ac:spMk id="24" creationId="{613DF2FF-CF46-6878-DF2C-577B11083052}"/>
          </ac:spMkLst>
        </pc:spChg>
        <pc:spChg chg="mod">
          <ac:chgData name="Hayashida, Ayaka" userId="14cb5ab0-815a-4b6d-80c2-d4f49147893d" providerId="ADAL" clId="{4CC6FF14-8068-4DC5-9295-7ED55786EBF1}" dt="2025-08-24T23:32:03.008" v="52" actId="165"/>
          <ac:spMkLst>
            <pc:docMk/>
            <pc:sldMk cId="2777100696" sldId="266"/>
            <ac:spMk id="25" creationId="{AC7CD5C7-5223-5870-9A48-AFB43F719233}"/>
          </ac:spMkLst>
        </pc:spChg>
        <pc:grpChg chg="mod topLvl">
          <ac:chgData name="Hayashida, Ayaka" userId="14cb5ab0-815a-4b6d-80c2-d4f49147893d" providerId="ADAL" clId="{4CC6FF14-8068-4DC5-9295-7ED55786EBF1}" dt="2025-08-24T23:32:47.167" v="62" actId="164"/>
          <ac:grpSpMkLst>
            <pc:docMk/>
            <pc:sldMk cId="2777100696" sldId="266"/>
            <ac:grpSpMk id="14" creationId="{6BA71F63-4D2A-133E-AA7E-17060ECE12C5}"/>
          </ac:grpSpMkLst>
        </pc:grpChg>
        <pc:grpChg chg="mod topLvl">
          <ac:chgData name="Hayashida, Ayaka" userId="14cb5ab0-815a-4b6d-80c2-d4f49147893d" providerId="ADAL" clId="{4CC6FF14-8068-4DC5-9295-7ED55786EBF1}" dt="2025-08-24T23:32:37.500" v="61" actId="164"/>
          <ac:grpSpMkLst>
            <pc:docMk/>
            <pc:sldMk cId="2777100696" sldId="266"/>
            <ac:grpSpMk id="20" creationId="{C0A522D0-E399-FD28-BE49-7F80F7629254}"/>
          </ac:grpSpMkLst>
        </pc:grpChg>
        <pc:grpChg chg="mod topLvl">
          <ac:chgData name="Hayashida, Ayaka" userId="14cb5ab0-815a-4b6d-80c2-d4f49147893d" providerId="ADAL" clId="{4CC6FF14-8068-4DC5-9295-7ED55786EBF1}" dt="2025-08-24T23:32:32.070" v="60" actId="164"/>
          <ac:grpSpMkLst>
            <pc:docMk/>
            <pc:sldMk cId="2777100696" sldId="266"/>
            <ac:grpSpMk id="26" creationId="{79ADFE1E-9527-FD4B-AF7D-DC2487A7A49C}"/>
          </ac:grpSpMkLst>
        </pc:grpChg>
        <pc:grpChg chg="del">
          <ac:chgData name="Hayashida, Ayaka" userId="14cb5ab0-815a-4b6d-80c2-d4f49147893d" providerId="ADAL" clId="{4CC6FF14-8068-4DC5-9295-7ED55786EBF1}" dt="2025-08-24T23:30:43.377" v="36" actId="165"/>
          <ac:grpSpMkLst>
            <pc:docMk/>
            <pc:sldMk cId="2777100696" sldId="266"/>
            <ac:grpSpMk id="28" creationId="{E04271CB-F2AF-7E1C-160E-3B2B720F0A27}"/>
          </ac:grpSpMkLst>
        </pc:grpChg>
        <pc:grpChg chg="del">
          <ac:chgData name="Hayashida, Ayaka" userId="14cb5ab0-815a-4b6d-80c2-d4f49147893d" providerId="ADAL" clId="{4CC6FF14-8068-4DC5-9295-7ED55786EBF1}" dt="2025-08-24T23:31:37.026" v="45" actId="165"/>
          <ac:grpSpMkLst>
            <pc:docMk/>
            <pc:sldMk cId="2777100696" sldId="266"/>
            <ac:grpSpMk id="30" creationId="{9E131C21-9C0D-4DFA-B845-9316AB0FC356}"/>
          </ac:grpSpMkLst>
        </pc:grpChg>
        <pc:grpChg chg="del">
          <ac:chgData name="Hayashida, Ayaka" userId="14cb5ab0-815a-4b6d-80c2-d4f49147893d" providerId="ADAL" clId="{4CC6FF14-8068-4DC5-9295-7ED55786EBF1}" dt="2025-08-24T23:32:03.008" v="52" actId="165"/>
          <ac:grpSpMkLst>
            <pc:docMk/>
            <pc:sldMk cId="2777100696" sldId="266"/>
            <ac:grpSpMk id="32" creationId="{0704C5AD-448F-B82E-0F54-CB8069A803E5}"/>
          </ac:grpSpMkLst>
        </pc:grpChg>
        <pc:grpChg chg="add mod">
          <ac:chgData name="Hayashida, Ayaka" userId="14cb5ab0-815a-4b6d-80c2-d4f49147893d" providerId="ADAL" clId="{4CC6FF14-8068-4DC5-9295-7ED55786EBF1}" dt="2025-08-24T23:32:32.070" v="60" actId="164"/>
          <ac:grpSpMkLst>
            <pc:docMk/>
            <pc:sldMk cId="2777100696" sldId="266"/>
            <ac:grpSpMk id="34" creationId="{8FF872E4-CBEB-9023-C7B1-59FC7C792542}"/>
          </ac:grpSpMkLst>
        </pc:grpChg>
        <pc:grpChg chg="add mod">
          <ac:chgData name="Hayashida, Ayaka" userId="14cb5ab0-815a-4b6d-80c2-d4f49147893d" providerId="ADAL" clId="{4CC6FF14-8068-4DC5-9295-7ED55786EBF1}" dt="2025-08-24T23:32:37.500" v="61" actId="164"/>
          <ac:grpSpMkLst>
            <pc:docMk/>
            <pc:sldMk cId="2777100696" sldId="266"/>
            <ac:grpSpMk id="35" creationId="{77B9DD99-2B03-A2D0-7BB1-B026D75F4A93}"/>
          </ac:grpSpMkLst>
        </pc:grpChg>
        <pc:grpChg chg="add mod">
          <ac:chgData name="Hayashida, Ayaka" userId="14cb5ab0-815a-4b6d-80c2-d4f49147893d" providerId="ADAL" clId="{4CC6FF14-8068-4DC5-9295-7ED55786EBF1}" dt="2025-08-24T23:32:47.167" v="62" actId="164"/>
          <ac:grpSpMkLst>
            <pc:docMk/>
            <pc:sldMk cId="2777100696" sldId="266"/>
            <ac:grpSpMk id="36" creationId="{16FD9AAA-E7D1-43FA-7CDD-46AC7829FCBA}"/>
          </ac:grpSpMkLst>
        </pc:grpChg>
        <pc:picChg chg="del mod">
          <ac:chgData name="Hayashida, Ayaka" userId="14cb5ab0-815a-4b6d-80c2-d4f49147893d" providerId="ADAL" clId="{4CC6FF14-8068-4DC5-9295-7ED55786EBF1}" dt="2025-08-24T23:30:47.152" v="37" actId="478"/>
          <ac:picMkLst>
            <pc:docMk/>
            <pc:sldMk cId="2777100696" sldId="266"/>
            <ac:picMk id="3" creationId="{06171934-81D2-C3D9-BDF8-F6A08B64B439}"/>
          </ac:picMkLst>
        </pc:picChg>
        <pc:picChg chg="add mod ord">
          <ac:chgData name="Hayashida, Ayaka" userId="14cb5ab0-815a-4b6d-80c2-d4f49147893d" providerId="ADAL" clId="{4CC6FF14-8068-4DC5-9295-7ED55786EBF1}" dt="2025-08-24T23:32:47.167" v="62" actId="164"/>
          <ac:picMkLst>
            <pc:docMk/>
            <pc:sldMk cId="2777100696" sldId="266"/>
            <ac:picMk id="4" creationId="{9FBDA6F0-3D07-FF39-6CF3-4C92B72F684E}"/>
          </ac:picMkLst>
        </pc:picChg>
        <pc:picChg chg="del mod">
          <ac:chgData name="Hayashida, Ayaka" userId="14cb5ab0-815a-4b6d-80c2-d4f49147893d" providerId="ADAL" clId="{4CC6FF14-8068-4DC5-9295-7ED55786EBF1}" dt="2025-08-24T23:31:39.749" v="46" actId="478"/>
          <ac:picMkLst>
            <pc:docMk/>
            <pc:sldMk cId="2777100696" sldId="266"/>
            <ac:picMk id="5" creationId="{8F09A53D-A592-763D-EF49-18BCF30AD046}"/>
          </ac:picMkLst>
        </pc:picChg>
        <pc:picChg chg="del mod">
          <ac:chgData name="Hayashida, Ayaka" userId="14cb5ab0-815a-4b6d-80c2-d4f49147893d" providerId="ADAL" clId="{4CC6FF14-8068-4DC5-9295-7ED55786EBF1}" dt="2025-08-24T23:32:04.890" v="53" actId="478"/>
          <ac:picMkLst>
            <pc:docMk/>
            <pc:sldMk cId="2777100696" sldId="266"/>
            <ac:picMk id="7" creationId="{603244E6-417E-3AE9-86DF-E7A5B05A9A0B}"/>
          </ac:picMkLst>
        </pc:picChg>
        <pc:picChg chg="add mod ord">
          <ac:chgData name="Hayashida, Ayaka" userId="14cb5ab0-815a-4b6d-80c2-d4f49147893d" providerId="ADAL" clId="{4CC6FF14-8068-4DC5-9295-7ED55786EBF1}" dt="2025-08-24T23:32:37.500" v="61" actId="164"/>
          <ac:picMkLst>
            <pc:docMk/>
            <pc:sldMk cId="2777100696" sldId="266"/>
            <ac:picMk id="17" creationId="{0568C328-390D-3A33-A7AD-1EC9B725BA5D}"/>
          </ac:picMkLst>
        </pc:picChg>
        <pc:picChg chg="mod topLvl">
          <ac:chgData name="Hayashida, Ayaka" userId="14cb5ab0-815a-4b6d-80c2-d4f49147893d" providerId="ADAL" clId="{4CC6FF14-8068-4DC5-9295-7ED55786EBF1}" dt="2025-08-24T23:32:47.167" v="62" actId="164"/>
          <ac:picMkLst>
            <pc:docMk/>
            <pc:sldMk cId="2777100696" sldId="266"/>
            <ac:picMk id="27" creationId="{70CC1B64-C0F3-218A-0C51-A79FC0595816}"/>
          </ac:picMkLst>
        </pc:picChg>
        <pc:picChg chg="mod topLvl">
          <ac:chgData name="Hayashida, Ayaka" userId="14cb5ab0-815a-4b6d-80c2-d4f49147893d" providerId="ADAL" clId="{4CC6FF14-8068-4DC5-9295-7ED55786EBF1}" dt="2025-08-24T23:32:37.500" v="61" actId="164"/>
          <ac:picMkLst>
            <pc:docMk/>
            <pc:sldMk cId="2777100696" sldId="266"/>
            <ac:picMk id="29" creationId="{E26A5A91-DEC8-C128-B9A2-38D6D4AB3E37}"/>
          </ac:picMkLst>
        </pc:picChg>
        <pc:picChg chg="mod topLvl">
          <ac:chgData name="Hayashida, Ayaka" userId="14cb5ab0-815a-4b6d-80c2-d4f49147893d" providerId="ADAL" clId="{4CC6FF14-8068-4DC5-9295-7ED55786EBF1}" dt="2025-08-24T23:32:32.070" v="60" actId="164"/>
          <ac:picMkLst>
            <pc:docMk/>
            <pc:sldMk cId="2777100696" sldId="266"/>
            <ac:picMk id="31" creationId="{8EBD80EC-D5FF-F020-BE19-E52D29DD76C7}"/>
          </ac:picMkLst>
        </pc:picChg>
        <pc:picChg chg="add mod ord">
          <ac:chgData name="Hayashida, Ayaka" userId="14cb5ab0-815a-4b6d-80c2-d4f49147893d" providerId="ADAL" clId="{4CC6FF14-8068-4DC5-9295-7ED55786EBF1}" dt="2025-08-24T23:32:32.070" v="60" actId="164"/>
          <ac:picMkLst>
            <pc:docMk/>
            <pc:sldMk cId="2777100696" sldId="266"/>
            <ac:picMk id="33" creationId="{209DF8D3-CBE1-A9FA-D25C-5347BCBA8B22}"/>
          </ac:picMkLst>
        </pc:picChg>
      </pc:sldChg>
    </pc:docChg>
  </pc:docChgLst>
  <pc:docChgLst>
    <pc:chgData name="Hayashida, Ayaka" userId="14cb5ab0-815a-4b6d-80c2-d4f49147893d" providerId="ADAL" clId="{4E5FC6B4-A1D5-43AE-AB4E-E2E652BA8DC8}"/>
    <pc:docChg chg="custSel modSld">
      <pc:chgData name="Hayashida, Ayaka" userId="14cb5ab0-815a-4b6d-80c2-d4f49147893d" providerId="ADAL" clId="{4E5FC6B4-A1D5-43AE-AB4E-E2E652BA8DC8}" dt="2025-08-25T04:36:51.015" v="75" actId="20577"/>
      <pc:docMkLst>
        <pc:docMk/>
      </pc:docMkLst>
      <pc:sldChg chg="addSp delSp modSp mod modNotesTx">
        <pc:chgData name="Hayashida, Ayaka" userId="14cb5ab0-815a-4b6d-80c2-d4f49147893d" providerId="ADAL" clId="{4E5FC6B4-A1D5-43AE-AB4E-E2E652BA8DC8}" dt="2025-08-25T04:36:32.489" v="73" actId="20577"/>
        <pc:sldMkLst>
          <pc:docMk/>
          <pc:sldMk cId="4055272036" sldId="263"/>
        </pc:sldMkLst>
        <pc:spChg chg="mod">
          <ac:chgData name="Hayashida, Ayaka" userId="14cb5ab0-815a-4b6d-80c2-d4f49147893d" providerId="ADAL" clId="{4E5FC6B4-A1D5-43AE-AB4E-E2E652BA8DC8}" dt="2025-08-25T04:29:53.289" v="0"/>
          <ac:spMkLst>
            <pc:docMk/>
            <pc:sldMk cId="4055272036" sldId="263"/>
            <ac:spMk id="5" creationId="{38112678-EB4B-CC87-5CC2-1CE22B163841}"/>
          </ac:spMkLst>
        </pc:spChg>
        <pc:spChg chg="mod">
          <ac:chgData name="Hayashida, Ayaka" userId="14cb5ab0-815a-4b6d-80c2-d4f49147893d" providerId="ADAL" clId="{4E5FC6B4-A1D5-43AE-AB4E-E2E652BA8DC8}" dt="2025-08-25T04:33:28.914" v="36"/>
          <ac:spMkLst>
            <pc:docMk/>
            <pc:sldMk cId="4055272036" sldId="263"/>
            <ac:spMk id="22" creationId="{1A6BCDC3-624B-D1A7-56F6-2A71EA5BE886}"/>
          </ac:spMkLst>
        </pc:spChg>
        <pc:spChg chg="mod">
          <ac:chgData name="Hayashida, Ayaka" userId="14cb5ab0-815a-4b6d-80c2-d4f49147893d" providerId="ADAL" clId="{4E5FC6B4-A1D5-43AE-AB4E-E2E652BA8DC8}" dt="2025-08-25T04:33:28.914" v="36"/>
          <ac:spMkLst>
            <pc:docMk/>
            <pc:sldMk cId="4055272036" sldId="263"/>
            <ac:spMk id="23" creationId="{88782279-BAC0-3592-3087-106CCA9F7EFB}"/>
          </ac:spMkLst>
        </pc:spChg>
        <pc:spChg chg="mod">
          <ac:chgData name="Hayashida, Ayaka" userId="14cb5ab0-815a-4b6d-80c2-d4f49147893d" providerId="ADAL" clId="{4E5FC6B4-A1D5-43AE-AB4E-E2E652BA8DC8}" dt="2025-08-25T04:33:28.914" v="36"/>
          <ac:spMkLst>
            <pc:docMk/>
            <pc:sldMk cId="4055272036" sldId="263"/>
            <ac:spMk id="24" creationId="{7C14D16F-A660-3781-6B5C-082CA3DEBC6C}"/>
          </ac:spMkLst>
        </pc:spChg>
        <pc:grpChg chg="add mod">
          <ac:chgData name="Hayashida, Ayaka" userId="14cb5ab0-815a-4b6d-80c2-d4f49147893d" providerId="ADAL" clId="{4E5FC6B4-A1D5-43AE-AB4E-E2E652BA8DC8}" dt="2025-08-25T04:29:53.289" v="0"/>
          <ac:grpSpMkLst>
            <pc:docMk/>
            <pc:sldMk cId="4055272036" sldId="263"/>
            <ac:grpSpMk id="2" creationId="{BA2A05BC-8610-987E-6A41-91B633460A94}"/>
          </ac:grpSpMkLst>
        </pc:grpChg>
        <pc:grpChg chg="del">
          <ac:chgData name="Hayashida, Ayaka" userId="14cb5ab0-815a-4b6d-80c2-d4f49147893d" providerId="ADAL" clId="{4E5FC6B4-A1D5-43AE-AB4E-E2E652BA8DC8}" dt="2025-08-25T04:33:32.010" v="38" actId="478"/>
          <ac:grpSpMkLst>
            <pc:docMk/>
            <pc:sldMk cId="4055272036" sldId="263"/>
            <ac:grpSpMk id="8" creationId="{09F59DB3-7685-928B-30F2-267B0E6F2355}"/>
          </ac:grpSpMkLst>
        </pc:grpChg>
        <pc:grpChg chg="add mod">
          <ac:chgData name="Hayashida, Ayaka" userId="14cb5ab0-815a-4b6d-80c2-d4f49147893d" providerId="ADAL" clId="{4E5FC6B4-A1D5-43AE-AB4E-E2E652BA8DC8}" dt="2025-08-25T04:33:28.914" v="36"/>
          <ac:grpSpMkLst>
            <pc:docMk/>
            <pc:sldMk cId="4055272036" sldId="263"/>
            <ac:grpSpMk id="18" creationId="{B7823E4C-756C-A159-32A0-CD6D9F7D2A27}"/>
          </ac:grpSpMkLst>
        </pc:grpChg>
        <pc:grpChg chg="del">
          <ac:chgData name="Hayashida, Ayaka" userId="14cb5ab0-815a-4b6d-80c2-d4f49147893d" providerId="ADAL" clId="{4E5FC6B4-A1D5-43AE-AB4E-E2E652BA8DC8}" dt="2025-08-25T04:29:57.090" v="2" actId="478"/>
          <ac:grpSpMkLst>
            <pc:docMk/>
            <pc:sldMk cId="4055272036" sldId="263"/>
            <ac:grpSpMk id="19" creationId="{44CAFAD8-35E2-9E06-C045-12433DE2913A}"/>
          </ac:grpSpMkLst>
        </pc:grpChg>
        <pc:picChg chg="mod">
          <ac:chgData name="Hayashida, Ayaka" userId="14cb5ab0-815a-4b6d-80c2-d4f49147893d" providerId="ADAL" clId="{4E5FC6B4-A1D5-43AE-AB4E-E2E652BA8DC8}" dt="2025-08-25T04:29:53.289" v="0"/>
          <ac:picMkLst>
            <pc:docMk/>
            <pc:sldMk cId="4055272036" sldId="263"/>
            <ac:picMk id="4" creationId="{DD1439AF-DA87-FD05-E11E-318CF2AD1453}"/>
          </ac:picMkLst>
        </pc:picChg>
        <pc:picChg chg="add mod">
          <ac:chgData name="Hayashida, Ayaka" userId="14cb5ab0-815a-4b6d-80c2-d4f49147893d" providerId="ADAL" clId="{4E5FC6B4-A1D5-43AE-AB4E-E2E652BA8DC8}" dt="2025-08-25T04:29:59.006" v="3" actId="1076"/>
          <ac:picMkLst>
            <pc:docMk/>
            <pc:sldMk cId="4055272036" sldId="263"/>
            <ac:picMk id="6" creationId="{207A7DBF-60BB-3763-AFCB-223D309A74C9}"/>
          </ac:picMkLst>
        </pc:picChg>
        <pc:picChg chg="mod">
          <ac:chgData name="Hayashida, Ayaka" userId="14cb5ab0-815a-4b6d-80c2-d4f49147893d" providerId="ADAL" clId="{4E5FC6B4-A1D5-43AE-AB4E-E2E652BA8DC8}" dt="2025-08-25T04:33:28.914" v="36"/>
          <ac:picMkLst>
            <pc:docMk/>
            <pc:sldMk cId="4055272036" sldId="263"/>
            <ac:picMk id="20" creationId="{31A5C0FF-D82F-8D6E-D770-2726CDB8844E}"/>
          </ac:picMkLst>
        </pc:picChg>
        <pc:picChg chg="mod">
          <ac:chgData name="Hayashida, Ayaka" userId="14cb5ab0-815a-4b6d-80c2-d4f49147893d" providerId="ADAL" clId="{4E5FC6B4-A1D5-43AE-AB4E-E2E652BA8DC8}" dt="2025-08-25T04:33:28.914" v="36"/>
          <ac:picMkLst>
            <pc:docMk/>
            <pc:sldMk cId="4055272036" sldId="263"/>
            <ac:picMk id="21" creationId="{956B1C20-D0F0-1C7C-F3BE-7C0FD2E49586}"/>
          </ac:picMkLst>
        </pc:picChg>
        <pc:picChg chg="add mod">
          <ac:chgData name="Hayashida, Ayaka" userId="14cb5ab0-815a-4b6d-80c2-d4f49147893d" providerId="ADAL" clId="{4E5FC6B4-A1D5-43AE-AB4E-E2E652BA8DC8}" dt="2025-08-25T04:33:36.997" v="39" actId="1076"/>
          <ac:picMkLst>
            <pc:docMk/>
            <pc:sldMk cId="4055272036" sldId="263"/>
            <ac:picMk id="27" creationId="{5BE19124-CE45-F7ED-F6FF-D1438E0FD34E}"/>
          </ac:picMkLst>
        </pc:picChg>
        <pc:cxnChg chg="mod">
          <ac:chgData name="Hayashida, Ayaka" userId="14cb5ab0-815a-4b6d-80c2-d4f49147893d" providerId="ADAL" clId="{4E5FC6B4-A1D5-43AE-AB4E-E2E652BA8DC8}" dt="2025-08-25T04:33:28.914" v="36"/>
          <ac:cxnSpMkLst>
            <pc:docMk/>
            <pc:sldMk cId="4055272036" sldId="263"/>
            <ac:cxnSpMk id="25" creationId="{F471C228-CABC-D061-7E1F-2268CEFE4DCD}"/>
          </ac:cxnSpMkLst>
        </pc:cxnChg>
        <pc:cxnChg chg="mod">
          <ac:chgData name="Hayashida, Ayaka" userId="14cb5ab0-815a-4b6d-80c2-d4f49147893d" providerId="ADAL" clId="{4E5FC6B4-A1D5-43AE-AB4E-E2E652BA8DC8}" dt="2025-08-25T04:33:28.914" v="36"/>
          <ac:cxnSpMkLst>
            <pc:docMk/>
            <pc:sldMk cId="4055272036" sldId="263"/>
            <ac:cxnSpMk id="26" creationId="{91C6BF11-CCA8-5A78-5AFD-914EC7687042}"/>
          </ac:cxnSpMkLst>
        </pc:cxnChg>
      </pc:sldChg>
      <pc:sldChg chg="modNotesTx">
        <pc:chgData name="Hayashida, Ayaka" userId="14cb5ab0-815a-4b6d-80c2-d4f49147893d" providerId="ADAL" clId="{4E5FC6B4-A1D5-43AE-AB4E-E2E652BA8DC8}" dt="2025-08-25T04:36:41.830" v="74" actId="20577"/>
        <pc:sldMkLst>
          <pc:docMk/>
          <pc:sldMk cId="2305607861" sldId="264"/>
        </pc:sldMkLst>
      </pc:sldChg>
      <pc:sldChg chg="addSp delSp modSp mod modNotesTx">
        <pc:chgData name="Hayashida, Ayaka" userId="14cb5ab0-815a-4b6d-80c2-d4f49147893d" providerId="ADAL" clId="{4E5FC6B4-A1D5-43AE-AB4E-E2E652BA8DC8}" dt="2025-08-25T04:36:20.104" v="72" actId="20577"/>
        <pc:sldMkLst>
          <pc:docMk/>
          <pc:sldMk cId="2777100696" sldId="266"/>
        </pc:sldMkLst>
        <pc:spChg chg="mod">
          <ac:chgData name="Hayashida, Ayaka" userId="14cb5ab0-815a-4b6d-80c2-d4f49147893d" providerId="ADAL" clId="{4E5FC6B4-A1D5-43AE-AB4E-E2E652BA8DC8}" dt="2025-08-25T04:30:04.162" v="4"/>
          <ac:spMkLst>
            <pc:docMk/>
            <pc:sldMk cId="2777100696" sldId="266"/>
            <ac:spMk id="7" creationId="{76913203-B14D-B91F-B8B6-8080C327D136}"/>
          </ac:spMkLst>
        </pc:spChg>
        <pc:spChg chg="mod">
          <ac:chgData name="Hayashida, Ayaka" userId="14cb5ab0-815a-4b6d-80c2-d4f49147893d" providerId="ADAL" clId="{4E5FC6B4-A1D5-43AE-AB4E-E2E652BA8DC8}" dt="2025-08-25T04:30:04.162" v="4"/>
          <ac:spMkLst>
            <pc:docMk/>
            <pc:sldMk cId="2777100696" sldId="266"/>
            <ac:spMk id="21" creationId="{C681139D-CB96-055A-2F51-C5048F689AD5}"/>
          </ac:spMkLst>
        </pc:spChg>
        <pc:spChg chg="mod">
          <ac:chgData name="Hayashida, Ayaka" userId="14cb5ab0-815a-4b6d-80c2-d4f49147893d" providerId="ADAL" clId="{4E5FC6B4-A1D5-43AE-AB4E-E2E652BA8DC8}" dt="2025-08-25T04:30:04.162" v="4"/>
          <ac:spMkLst>
            <pc:docMk/>
            <pc:sldMk cId="2777100696" sldId="266"/>
            <ac:spMk id="28" creationId="{1D20FDAD-47D4-18D0-998A-8DE065895FFA}"/>
          </ac:spMkLst>
        </pc:spChg>
        <pc:spChg chg="mod">
          <ac:chgData name="Hayashida, Ayaka" userId="14cb5ab0-815a-4b6d-80c2-d4f49147893d" providerId="ADAL" clId="{4E5FC6B4-A1D5-43AE-AB4E-E2E652BA8DC8}" dt="2025-08-25T04:30:13.048" v="8"/>
          <ac:spMkLst>
            <pc:docMk/>
            <pc:sldMk cId="2777100696" sldId="266"/>
            <ac:spMk id="40" creationId="{6CDE5DAB-0892-C5F4-F4D8-2F36C4D12905}"/>
          </ac:spMkLst>
        </pc:spChg>
        <pc:spChg chg="mod">
          <ac:chgData name="Hayashida, Ayaka" userId="14cb5ab0-815a-4b6d-80c2-d4f49147893d" providerId="ADAL" clId="{4E5FC6B4-A1D5-43AE-AB4E-E2E652BA8DC8}" dt="2025-08-25T04:30:13.048" v="8"/>
          <ac:spMkLst>
            <pc:docMk/>
            <pc:sldMk cId="2777100696" sldId="266"/>
            <ac:spMk id="41" creationId="{749F2D90-1052-CAC7-979F-435DE77039AA}"/>
          </ac:spMkLst>
        </pc:spChg>
        <pc:spChg chg="mod">
          <ac:chgData name="Hayashida, Ayaka" userId="14cb5ab0-815a-4b6d-80c2-d4f49147893d" providerId="ADAL" clId="{4E5FC6B4-A1D5-43AE-AB4E-E2E652BA8DC8}" dt="2025-08-25T04:30:13.048" v="8"/>
          <ac:spMkLst>
            <pc:docMk/>
            <pc:sldMk cId="2777100696" sldId="266"/>
            <ac:spMk id="42" creationId="{693D23BC-E338-7BB1-3452-A137D829F0DF}"/>
          </ac:spMkLst>
        </pc:spChg>
        <pc:spChg chg="mod">
          <ac:chgData name="Hayashida, Ayaka" userId="14cb5ab0-815a-4b6d-80c2-d4f49147893d" providerId="ADAL" clId="{4E5FC6B4-A1D5-43AE-AB4E-E2E652BA8DC8}" dt="2025-08-25T04:30:13.048" v="8"/>
          <ac:spMkLst>
            <pc:docMk/>
            <pc:sldMk cId="2777100696" sldId="266"/>
            <ac:spMk id="43" creationId="{504A6B2C-8C92-56D5-37A9-4AD87D54FA78}"/>
          </ac:spMkLst>
        </pc:spChg>
        <pc:spChg chg="mod">
          <ac:chgData name="Hayashida, Ayaka" userId="14cb5ab0-815a-4b6d-80c2-d4f49147893d" providerId="ADAL" clId="{4E5FC6B4-A1D5-43AE-AB4E-E2E652BA8DC8}" dt="2025-08-25T04:30:19.818" v="13"/>
          <ac:spMkLst>
            <pc:docMk/>
            <pc:sldMk cId="2777100696" sldId="266"/>
            <ac:spMk id="49" creationId="{8B5A7FB9-51EA-D033-76BD-238677B5C9CD}"/>
          </ac:spMkLst>
        </pc:spChg>
        <pc:spChg chg="mod">
          <ac:chgData name="Hayashida, Ayaka" userId="14cb5ab0-815a-4b6d-80c2-d4f49147893d" providerId="ADAL" clId="{4E5FC6B4-A1D5-43AE-AB4E-E2E652BA8DC8}" dt="2025-08-25T04:30:19.818" v="13"/>
          <ac:spMkLst>
            <pc:docMk/>
            <pc:sldMk cId="2777100696" sldId="266"/>
            <ac:spMk id="50" creationId="{D340FC63-AABB-B0CB-8C87-44A04D877E40}"/>
          </ac:spMkLst>
        </pc:spChg>
        <pc:spChg chg="mod">
          <ac:chgData name="Hayashida, Ayaka" userId="14cb5ab0-815a-4b6d-80c2-d4f49147893d" providerId="ADAL" clId="{4E5FC6B4-A1D5-43AE-AB4E-E2E652BA8DC8}" dt="2025-08-25T04:30:19.818" v="13"/>
          <ac:spMkLst>
            <pc:docMk/>
            <pc:sldMk cId="2777100696" sldId="266"/>
            <ac:spMk id="51" creationId="{ECAC907D-6905-90CD-6288-FA069C2EA05B}"/>
          </ac:spMkLst>
        </pc:spChg>
        <pc:spChg chg="mod">
          <ac:chgData name="Hayashida, Ayaka" userId="14cb5ab0-815a-4b6d-80c2-d4f49147893d" providerId="ADAL" clId="{4E5FC6B4-A1D5-43AE-AB4E-E2E652BA8DC8}" dt="2025-08-25T04:30:19.818" v="13"/>
          <ac:spMkLst>
            <pc:docMk/>
            <pc:sldMk cId="2777100696" sldId="266"/>
            <ac:spMk id="52" creationId="{71ED6D79-9B16-747B-A77B-602A85B4B776}"/>
          </ac:spMkLst>
        </pc:spChg>
        <pc:grpChg chg="add mod">
          <ac:chgData name="Hayashida, Ayaka" userId="14cb5ab0-815a-4b6d-80c2-d4f49147893d" providerId="ADAL" clId="{4E5FC6B4-A1D5-43AE-AB4E-E2E652BA8DC8}" dt="2025-08-25T04:30:04.162" v="4"/>
          <ac:grpSpMkLst>
            <pc:docMk/>
            <pc:sldMk cId="2777100696" sldId="266"/>
            <ac:grpSpMk id="2" creationId="{32D22DB1-7588-C8E0-32C0-DA1F51567A0A}"/>
          </ac:grpSpMkLst>
        </pc:grpChg>
        <pc:grpChg chg="mod">
          <ac:chgData name="Hayashida, Ayaka" userId="14cb5ab0-815a-4b6d-80c2-d4f49147893d" providerId="ADAL" clId="{4E5FC6B4-A1D5-43AE-AB4E-E2E652BA8DC8}" dt="2025-08-25T04:30:04.162" v="4"/>
          <ac:grpSpMkLst>
            <pc:docMk/>
            <pc:sldMk cId="2777100696" sldId="266"/>
            <ac:grpSpMk id="5" creationId="{83A78851-19AE-66F7-99FA-4027AA3EEE35}"/>
          </ac:grpSpMkLst>
        </pc:grpChg>
        <pc:grpChg chg="add mod">
          <ac:chgData name="Hayashida, Ayaka" userId="14cb5ab0-815a-4b6d-80c2-d4f49147893d" providerId="ADAL" clId="{4E5FC6B4-A1D5-43AE-AB4E-E2E652BA8DC8}" dt="2025-08-25T04:30:13.048" v="8"/>
          <ac:grpSpMkLst>
            <pc:docMk/>
            <pc:sldMk cId="2777100696" sldId="266"/>
            <ac:grpSpMk id="32" creationId="{DD72BEDF-E364-DE85-3447-1EBF21DD23BE}"/>
          </ac:grpSpMkLst>
        </pc:grpChg>
        <pc:grpChg chg="del">
          <ac:chgData name="Hayashida, Ayaka" userId="14cb5ab0-815a-4b6d-80c2-d4f49147893d" providerId="ADAL" clId="{4E5FC6B4-A1D5-43AE-AB4E-E2E652BA8DC8}" dt="2025-08-25T04:30:23.261" v="16" actId="478"/>
          <ac:grpSpMkLst>
            <pc:docMk/>
            <pc:sldMk cId="2777100696" sldId="266"/>
            <ac:grpSpMk id="34" creationId="{8FF872E4-CBEB-9023-C7B1-59FC7C792542}"/>
          </ac:grpSpMkLst>
        </pc:grpChg>
        <pc:grpChg chg="del">
          <ac:chgData name="Hayashida, Ayaka" userId="14cb5ab0-815a-4b6d-80c2-d4f49147893d" providerId="ADAL" clId="{4E5FC6B4-A1D5-43AE-AB4E-E2E652BA8DC8}" dt="2025-08-25T04:30:15.654" v="11" actId="478"/>
          <ac:grpSpMkLst>
            <pc:docMk/>
            <pc:sldMk cId="2777100696" sldId="266"/>
            <ac:grpSpMk id="35" creationId="{77B9DD99-2B03-A2D0-7BB1-B026D75F4A93}"/>
          </ac:grpSpMkLst>
        </pc:grpChg>
        <pc:grpChg chg="del">
          <ac:chgData name="Hayashida, Ayaka" userId="14cb5ab0-815a-4b6d-80c2-d4f49147893d" providerId="ADAL" clId="{4E5FC6B4-A1D5-43AE-AB4E-E2E652BA8DC8}" dt="2025-08-25T04:30:07.450" v="6" actId="478"/>
          <ac:grpSpMkLst>
            <pc:docMk/>
            <pc:sldMk cId="2777100696" sldId="266"/>
            <ac:grpSpMk id="36" creationId="{16FD9AAA-E7D1-43FA-7CDD-46AC7829FCBA}"/>
          </ac:grpSpMkLst>
        </pc:grpChg>
        <pc:grpChg chg="mod">
          <ac:chgData name="Hayashida, Ayaka" userId="14cb5ab0-815a-4b6d-80c2-d4f49147893d" providerId="ADAL" clId="{4E5FC6B4-A1D5-43AE-AB4E-E2E652BA8DC8}" dt="2025-08-25T04:30:13.048" v="8"/>
          <ac:grpSpMkLst>
            <pc:docMk/>
            <pc:sldMk cId="2777100696" sldId="266"/>
            <ac:grpSpMk id="38" creationId="{2BC9BF06-9AA4-66A3-A963-7AFB087BB0F2}"/>
          </ac:grpSpMkLst>
        </pc:grpChg>
        <pc:grpChg chg="add mod">
          <ac:chgData name="Hayashida, Ayaka" userId="14cb5ab0-815a-4b6d-80c2-d4f49147893d" providerId="ADAL" clId="{4E5FC6B4-A1D5-43AE-AB4E-E2E652BA8DC8}" dt="2025-08-25T04:30:19.818" v="13"/>
          <ac:grpSpMkLst>
            <pc:docMk/>
            <pc:sldMk cId="2777100696" sldId="266"/>
            <ac:grpSpMk id="45" creationId="{37901023-6700-1D05-19C5-CBF0140AEB7F}"/>
          </ac:grpSpMkLst>
        </pc:grpChg>
        <pc:grpChg chg="mod">
          <ac:chgData name="Hayashida, Ayaka" userId="14cb5ab0-815a-4b6d-80c2-d4f49147893d" providerId="ADAL" clId="{4E5FC6B4-A1D5-43AE-AB4E-E2E652BA8DC8}" dt="2025-08-25T04:30:19.818" v="13"/>
          <ac:grpSpMkLst>
            <pc:docMk/>
            <pc:sldMk cId="2777100696" sldId="266"/>
            <ac:grpSpMk id="47" creationId="{6C52460C-D5AA-7771-8A52-EA9D4CA13721}"/>
          </ac:grpSpMkLst>
        </pc:grpChg>
        <pc:picChg chg="mod">
          <ac:chgData name="Hayashida, Ayaka" userId="14cb5ab0-815a-4b6d-80c2-d4f49147893d" providerId="ADAL" clId="{4E5FC6B4-A1D5-43AE-AB4E-E2E652BA8DC8}" dt="2025-08-25T04:30:04.162" v="4"/>
          <ac:picMkLst>
            <pc:docMk/>
            <pc:sldMk cId="2777100696" sldId="266"/>
            <ac:picMk id="3" creationId="{792AEA98-D0B5-4152-29A2-B0A1D3931CDE}"/>
          </ac:picMkLst>
        </pc:picChg>
        <pc:picChg chg="mod">
          <ac:chgData name="Hayashida, Ayaka" userId="14cb5ab0-815a-4b6d-80c2-d4f49147893d" providerId="ADAL" clId="{4E5FC6B4-A1D5-43AE-AB4E-E2E652BA8DC8}" dt="2025-08-25T04:30:04.162" v="4"/>
          <ac:picMkLst>
            <pc:docMk/>
            <pc:sldMk cId="2777100696" sldId="266"/>
            <ac:picMk id="6" creationId="{4C4EE393-16E7-C8EF-A42B-6399B0BDFF85}"/>
          </ac:picMkLst>
        </pc:picChg>
        <pc:picChg chg="add mod">
          <ac:chgData name="Hayashida, Ayaka" userId="14cb5ab0-815a-4b6d-80c2-d4f49147893d" providerId="ADAL" clId="{4E5FC6B4-A1D5-43AE-AB4E-E2E652BA8DC8}" dt="2025-08-25T04:30:11.436" v="7" actId="1076"/>
          <ac:picMkLst>
            <pc:docMk/>
            <pc:sldMk cId="2777100696" sldId="266"/>
            <ac:picMk id="30" creationId="{A4C44FFB-5258-AE7A-C550-F44EA5BAA0DE}"/>
          </ac:picMkLst>
        </pc:picChg>
        <pc:picChg chg="mod">
          <ac:chgData name="Hayashida, Ayaka" userId="14cb5ab0-815a-4b6d-80c2-d4f49147893d" providerId="ADAL" clId="{4E5FC6B4-A1D5-43AE-AB4E-E2E652BA8DC8}" dt="2025-08-25T04:30:13.048" v="8"/>
          <ac:picMkLst>
            <pc:docMk/>
            <pc:sldMk cId="2777100696" sldId="266"/>
            <ac:picMk id="37" creationId="{9B9293F2-D682-5D2C-C2D8-7E8B9D14A954}"/>
          </ac:picMkLst>
        </pc:picChg>
        <pc:picChg chg="mod">
          <ac:chgData name="Hayashida, Ayaka" userId="14cb5ab0-815a-4b6d-80c2-d4f49147893d" providerId="ADAL" clId="{4E5FC6B4-A1D5-43AE-AB4E-E2E652BA8DC8}" dt="2025-08-25T04:30:13.048" v="8"/>
          <ac:picMkLst>
            <pc:docMk/>
            <pc:sldMk cId="2777100696" sldId="266"/>
            <ac:picMk id="39" creationId="{71748B1E-ACA3-CFCD-98B5-86A62C23FA4F}"/>
          </ac:picMkLst>
        </pc:picChg>
        <pc:picChg chg="add mod">
          <ac:chgData name="Hayashida, Ayaka" userId="14cb5ab0-815a-4b6d-80c2-d4f49147893d" providerId="ADAL" clId="{4E5FC6B4-A1D5-43AE-AB4E-E2E652BA8DC8}" dt="2025-08-25T04:30:18.432" v="12" actId="1076"/>
          <ac:picMkLst>
            <pc:docMk/>
            <pc:sldMk cId="2777100696" sldId="266"/>
            <ac:picMk id="44" creationId="{E0546C3B-788C-2C61-F52D-03CA6D87B4C2}"/>
          </ac:picMkLst>
        </pc:picChg>
        <pc:picChg chg="mod">
          <ac:chgData name="Hayashida, Ayaka" userId="14cb5ab0-815a-4b6d-80c2-d4f49147893d" providerId="ADAL" clId="{4E5FC6B4-A1D5-43AE-AB4E-E2E652BA8DC8}" dt="2025-08-25T04:30:19.818" v="13"/>
          <ac:picMkLst>
            <pc:docMk/>
            <pc:sldMk cId="2777100696" sldId="266"/>
            <ac:picMk id="46" creationId="{B737F57D-5969-0FC5-DC9E-CCA965168660}"/>
          </ac:picMkLst>
        </pc:picChg>
        <pc:picChg chg="mod">
          <ac:chgData name="Hayashida, Ayaka" userId="14cb5ab0-815a-4b6d-80c2-d4f49147893d" providerId="ADAL" clId="{4E5FC6B4-A1D5-43AE-AB4E-E2E652BA8DC8}" dt="2025-08-25T04:30:19.818" v="13"/>
          <ac:picMkLst>
            <pc:docMk/>
            <pc:sldMk cId="2777100696" sldId="266"/>
            <ac:picMk id="48" creationId="{02489510-1921-EF38-5A78-F859A7B95A5A}"/>
          </ac:picMkLst>
        </pc:picChg>
        <pc:picChg chg="add mod">
          <ac:chgData name="Hayashida, Ayaka" userId="14cb5ab0-815a-4b6d-80c2-d4f49147893d" providerId="ADAL" clId="{4E5FC6B4-A1D5-43AE-AB4E-E2E652BA8DC8}" dt="2025-08-25T04:30:28.257" v="17" actId="1076"/>
          <ac:picMkLst>
            <pc:docMk/>
            <pc:sldMk cId="2777100696" sldId="266"/>
            <ac:picMk id="53" creationId="{75AE9F69-D628-8C99-C444-920D14336D3A}"/>
          </ac:picMkLst>
        </pc:picChg>
      </pc:sldChg>
      <pc:sldChg chg="addSp delSp modSp mod modNotesTx">
        <pc:chgData name="Hayashida, Ayaka" userId="14cb5ab0-815a-4b6d-80c2-d4f49147893d" providerId="ADAL" clId="{4E5FC6B4-A1D5-43AE-AB4E-E2E652BA8DC8}" dt="2025-08-25T04:36:12.143" v="71" actId="20577"/>
        <pc:sldMkLst>
          <pc:docMk/>
          <pc:sldMk cId="3263944414" sldId="268"/>
        </pc:sldMkLst>
        <pc:spChg chg="mod">
          <ac:chgData name="Hayashida, Ayaka" userId="14cb5ab0-815a-4b6d-80c2-d4f49147893d" providerId="ADAL" clId="{4E5FC6B4-A1D5-43AE-AB4E-E2E652BA8DC8}" dt="2025-08-25T04:31:53.208" v="18"/>
          <ac:spMkLst>
            <pc:docMk/>
            <pc:sldMk cId="3263944414" sldId="268"/>
            <ac:spMk id="6" creationId="{B99761DD-61A8-ADB6-398A-00CD6B6D6635}"/>
          </ac:spMkLst>
        </pc:spChg>
        <pc:grpChg chg="add mod">
          <ac:chgData name="Hayashida, Ayaka" userId="14cb5ab0-815a-4b6d-80c2-d4f49147893d" providerId="ADAL" clId="{4E5FC6B4-A1D5-43AE-AB4E-E2E652BA8DC8}" dt="2025-08-25T04:31:53.208" v="18"/>
          <ac:grpSpMkLst>
            <pc:docMk/>
            <pc:sldMk cId="3263944414" sldId="268"/>
            <ac:grpSpMk id="2" creationId="{59909002-D1DF-5C21-DDD9-45B70DCED7EB}"/>
          </ac:grpSpMkLst>
        </pc:grpChg>
        <pc:grpChg chg="del">
          <ac:chgData name="Hayashida, Ayaka" userId="14cb5ab0-815a-4b6d-80c2-d4f49147893d" providerId="ADAL" clId="{4E5FC6B4-A1D5-43AE-AB4E-E2E652BA8DC8}" dt="2025-08-25T04:31:56.205" v="20" actId="478"/>
          <ac:grpSpMkLst>
            <pc:docMk/>
            <pc:sldMk cId="3263944414" sldId="268"/>
            <ac:grpSpMk id="9" creationId="{0FC9E429-B897-6DFE-56F0-E504E468438D}"/>
          </ac:grpSpMkLst>
        </pc:grpChg>
        <pc:picChg chg="mod">
          <ac:chgData name="Hayashida, Ayaka" userId="14cb5ab0-815a-4b6d-80c2-d4f49147893d" providerId="ADAL" clId="{4E5FC6B4-A1D5-43AE-AB4E-E2E652BA8DC8}" dt="2025-08-25T04:31:53.208" v="18"/>
          <ac:picMkLst>
            <pc:docMk/>
            <pc:sldMk cId="3263944414" sldId="268"/>
            <ac:picMk id="4" creationId="{6FF975C5-6F44-6115-0672-94B10B7B47F2}"/>
          </ac:picMkLst>
        </pc:picChg>
        <pc:picChg chg="add mod">
          <ac:chgData name="Hayashida, Ayaka" userId="14cb5ab0-815a-4b6d-80c2-d4f49147893d" providerId="ADAL" clId="{4E5FC6B4-A1D5-43AE-AB4E-E2E652BA8DC8}" dt="2025-08-25T04:31:59.495" v="21" actId="1076"/>
          <ac:picMkLst>
            <pc:docMk/>
            <pc:sldMk cId="3263944414" sldId="268"/>
            <ac:picMk id="13" creationId="{B1B43D1E-B00A-2BFB-24B4-8EB429D19101}"/>
          </ac:picMkLst>
        </pc:picChg>
      </pc:sldChg>
      <pc:sldChg chg="addSp delSp modSp mod modNotesTx">
        <pc:chgData name="Hayashida, Ayaka" userId="14cb5ab0-815a-4b6d-80c2-d4f49147893d" providerId="ADAL" clId="{4E5FC6B4-A1D5-43AE-AB4E-E2E652BA8DC8}" dt="2025-08-25T04:36:03.607" v="70" actId="20577"/>
        <pc:sldMkLst>
          <pc:docMk/>
          <pc:sldMk cId="2697823394" sldId="269"/>
        </pc:sldMkLst>
        <pc:spChg chg="mod">
          <ac:chgData name="Hayashida, Ayaka" userId="14cb5ab0-815a-4b6d-80c2-d4f49147893d" providerId="ADAL" clId="{4E5FC6B4-A1D5-43AE-AB4E-E2E652BA8DC8}" dt="2025-08-25T04:32:10.595" v="22"/>
          <ac:spMkLst>
            <pc:docMk/>
            <pc:sldMk cId="2697823394" sldId="269"/>
            <ac:spMk id="6" creationId="{58F33AF1-1D33-B984-806C-1F7B399581A6}"/>
          </ac:spMkLst>
        </pc:spChg>
        <pc:grpChg chg="add mod">
          <ac:chgData name="Hayashida, Ayaka" userId="14cb5ab0-815a-4b6d-80c2-d4f49147893d" providerId="ADAL" clId="{4E5FC6B4-A1D5-43AE-AB4E-E2E652BA8DC8}" dt="2025-08-25T04:32:10.595" v="22"/>
          <ac:grpSpMkLst>
            <pc:docMk/>
            <pc:sldMk cId="2697823394" sldId="269"/>
            <ac:grpSpMk id="2" creationId="{DCE11B4A-96B6-793A-9F7F-94422EC7947E}"/>
          </ac:grpSpMkLst>
        </pc:grpChg>
        <pc:grpChg chg="del">
          <ac:chgData name="Hayashida, Ayaka" userId="14cb5ab0-815a-4b6d-80c2-d4f49147893d" providerId="ADAL" clId="{4E5FC6B4-A1D5-43AE-AB4E-E2E652BA8DC8}" dt="2025-08-25T04:32:13.214" v="24" actId="478"/>
          <ac:grpSpMkLst>
            <pc:docMk/>
            <pc:sldMk cId="2697823394" sldId="269"/>
            <ac:grpSpMk id="12" creationId="{FA1273EC-9F2B-0026-D9C5-B2FDBA7910D6}"/>
          </ac:grpSpMkLst>
        </pc:grpChg>
        <pc:picChg chg="mod">
          <ac:chgData name="Hayashida, Ayaka" userId="14cb5ab0-815a-4b6d-80c2-d4f49147893d" providerId="ADAL" clId="{4E5FC6B4-A1D5-43AE-AB4E-E2E652BA8DC8}" dt="2025-08-25T04:32:10.595" v="22"/>
          <ac:picMkLst>
            <pc:docMk/>
            <pc:sldMk cId="2697823394" sldId="269"/>
            <ac:picMk id="4" creationId="{6E6CB9F9-64A8-F90B-E9DC-4062A75DA007}"/>
          </ac:picMkLst>
        </pc:picChg>
        <pc:picChg chg="add mod">
          <ac:chgData name="Hayashida, Ayaka" userId="14cb5ab0-815a-4b6d-80c2-d4f49147893d" providerId="ADAL" clId="{4E5FC6B4-A1D5-43AE-AB4E-E2E652BA8DC8}" dt="2025-08-25T04:32:17.289" v="25" actId="1076"/>
          <ac:picMkLst>
            <pc:docMk/>
            <pc:sldMk cId="2697823394" sldId="269"/>
            <ac:picMk id="13" creationId="{4A10FC01-7598-B481-7858-B5DD516C5EF6}"/>
          </ac:picMkLst>
        </pc:picChg>
      </pc:sldChg>
      <pc:sldChg chg="modSp mod modNotesTx">
        <pc:chgData name="Hayashida, Ayaka" userId="14cb5ab0-815a-4b6d-80c2-d4f49147893d" providerId="ADAL" clId="{4E5FC6B4-A1D5-43AE-AB4E-E2E652BA8DC8}" dt="2025-08-25T04:36:51.015" v="75" actId="20577"/>
        <pc:sldMkLst>
          <pc:docMk/>
          <pc:sldMk cId="3226107819" sldId="270"/>
        </pc:sldMkLst>
        <pc:spChg chg="mod">
          <ac:chgData name="Hayashida, Ayaka" userId="14cb5ab0-815a-4b6d-80c2-d4f49147893d" providerId="ADAL" clId="{4E5FC6B4-A1D5-43AE-AB4E-E2E652BA8DC8}" dt="2025-08-25T04:34:01.129" v="66" actId="1076"/>
          <ac:spMkLst>
            <pc:docMk/>
            <pc:sldMk cId="3226107819" sldId="270"/>
            <ac:spMk id="3" creationId="{7D6086AA-E371-1FE4-C9F9-A54DD8760962}"/>
          </ac:spMkLst>
        </pc:spChg>
      </pc:sldChg>
      <pc:sldChg chg="addSp delSp modSp mod modNotesTx">
        <pc:chgData name="Hayashida, Ayaka" userId="14cb5ab0-815a-4b6d-80c2-d4f49147893d" providerId="ADAL" clId="{4E5FC6B4-A1D5-43AE-AB4E-E2E652BA8DC8}" dt="2025-08-25T04:35:52.212" v="69" actId="20577"/>
        <pc:sldMkLst>
          <pc:docMk/>
          <pc:sldMk cId="3484593726" sldId="272"/>
        </pc:sldMkLst>
        <pc:spChg chg="mod">
          <ac:chgData name="Hayashida, Ayaka" userId="14cb5ab0-815a-4b6d-80c2-d4f49147893d" providerId="ADAL" clId="{4E5FC6B4-A1D5-43AE-AB4E-E2E652BA8DC8}" dt="2025-08-25T04:32:28.963" v="27"/>
          <ac:spMkLst>
            <pc:docMk/>
            <pc:sldMk cId="3484593726" sldId="272"/>
            <ac:spMk id="13" creationId="{90196A80-1C4F-CD50-AD0E-35BBC9E89EA7}"/>
          </ac:spMkLst>
        </pc:spChg>
        <pc:spChg chg="mod">
          <ac:chgData name="Hayashida, Ayaka" userId="14cb5ab0-815a-4b6d-80c2-d4f49147893d" providerId="ADAL" clId="{4E5FC6B4-A1D5-43AE-AB4E-E2E652BA8DC8}" dt="2025-08-25T04:32:28.097" v="26" actId="164"/>
          <ac:spMkLst>
            <pc:docMk/>
            <pc:sldMk cId="3484593726" sldId="272"/>
            <ac:spMk id="15" creationId="{19D9DD07-F390-EB47-86A5-CA6251523BCC}"/>
          </ac:spMkLst>
        </pc:spChg>
        <pc:spChg chg="mod">
          <ac:chgData name="Hayashida, Ayaka" userId="14cb5ab0-815a-4b6d-80c2-d4f49147893d" providerId="ADAL" clId="{4E5FC6B4-A1D5-43AE-AB4E-E2E652BA8DC8}" dt="2025-08-25T04:32:28.963" v="27"/>
          <ac:spMkLst>
            <pc:docMk/>
            <pc:sldMk cId="3484593726" sldId="272"/>
            <ac:spMk id="16" creationId="{6FA07836-AFC4-FCF5-5A0D-E5B23210FC24}"/>
          </ac:spMkLst>
        </pc:spChg>
        <pc:spChg chg="mod">
          <ac:chgData name="Hayashida, Ayaka" userId="14cb5ab0-815a-4b6d-80c2-d4f49147893d" providerId="ADAL" clId="{4E5FC6B4-A1D5-43AE-AB4E-E2E652BA8DC8}" dt="2025-08-25T04:32:28.097" v="26" actId="164"/>
          <ac:spMkLst>
            <pc:docMk/>
            <pc:sldMk cId="3484593726" sldId="272"/>
            <ac:spMk id="17" creationId="{99735DF6-84B1-2016-EAFB-5556F2EDA6FA}"/>
          </ac:spMkLst>
        </pc:spChg>
        <pc:spChg chg="mod">
          <ac:chgData name="Hayashida, Ayaka" userId="14cb5ab0-815a-4b6d-80c2-d4f49147893d" providerId="ADAL" clId="{4E5FC6B4-A1D5-43AE-AB4E-E2E652BA8DC8}" dt="2025-08-25T04:32:41.448" v="31" actId="164"/>
          <ac:spMkLst>
            <pc:docMk/>
            <pc:sldMk cId="3484593726" sldId="272"/>
            <ac:spMk id="18" creationId="{F80A2CF9-E182-5F6D-B9C5-30B30978F255}"/>
          </ac:spMkLst>
        </pc:spChg>
        <pc:spChg chg="mod">
          <ac:chgData name="Hayashida, Ayaka" userId="14cb5ab0-815a-4b6d-80c2-d4f49147893d" providerId="ADAL" clId="{4E5FC6B4-A1D5-43AE-AB4E-E2E652BA8DC8}" dt="2025-08-25T04:32:41.448" v="31" actId="164"/>
          <ac:spMkLst>
            <pc:docMk/>
            <pc:sldMk cId="3484593726" sldId="272"/>
            <ac:spMk id="19" creationId="{3D66311B-F72B-56F5-E90D-A5A003550769}"/>
          </ac:spMkLst>
        </pc:spChg>
        <pc:spChg chg="mod">
          <ac:chgData name="Hayashida, Ayaka" userId="14cb5ab0-815a-4b6d-80c2-d4f49147893d" providerId="ADAL" clId="{4E5FC6B4-A1D5-43AE-AB4E-E2E652BA8DC8}" dt="2025-08-25T04:32:28.963" v="27"/>
          <ac:spMkLst>
            <pc:docMk/>
            <pc:sldMk cId="3484593726" sldId="272"/>
            <ac:spMk id="20" creationId="{0669FFB9-AA52-3E5A-EC3C-F0FB02720FB8}"/>
          </ac:spMkLst>
        </pc:spChg>
        <pc:spChg chg="mod">
          <ac:chgData name="Hayashida, Ayaka" userId="14cb5ab0-815a-4b6d-80c2-d4f49147893d" providerId="ADAL" clId="{4E5FC6B4-A1D5-43AE-AB4E-E2E652BA8DC8}" dt="2025-08-25T04:32:28.097" v="26" actId="164"/>
          <ac:spMkLst>
            <pc:docMk/>
            <pc:sldMk cId="3484593726" sldId="272"/>
            <ac:spMk id="22" creationId="{4129B1DF-EEA9-043A-BEB0-FDD798E228E6}"/>
          </ac:spMkLst>
        </pc:spChg>
        <pc:spChg chg="mod">
          <ac:chgData name="Hayashida, Ayaka" userId="14cb5ab0-815a-4b6d-80c2-d4f49147893d" providerId="ADAL" clId="{4E5FC6B4-A1D5-43AE-AB4E-E2E652BA8DC8}" dt="2025-08-25T04:32:28.097" v="26" actId="164"/>
          <ac:spMkLst>
            <pc:docMk/>
            <pc:sldMk cId="3484593726" sldId="272"/>
            <ac:spMk id="23" creationId="{A5D26B60-78C1-F795-6809-7CDF868C5177}"/>
          </ac:spMkLst>
        </pc:spChg>
        <pc:spChg chg="mod">
          <ac:chgData name="Hayashida, Ayaka" userId="14cb5ab0-815a-4b6d-80c2-d4f49147893d" providerId="ADAL" clId="{4E5FC6B4-A1D5-43AE-AB4E-E2E652BA8DC8}" dt="2025-08-25T04:32:41.448" v="31" actId="164"/>
          <ac:spMkLst>
            <pc:docMk/>
            <pc:sldMk cId="3484593726" sldId="272"/>
            <ac:spMk id="24" creationId="{C5CD33AE-C1AA-C823-1F1C-4EA33E6EC9E7}"/>
          </ac:spMkLst>
        </pc:spChg>
        <pc:spChg chg="mod">
          <ac:chgData name="Hayashida, Ayaka" userId="14cb5ab0-815a-4b6d-80c2-d4f49147893d" providerId="ADAL" clId="{4E5FC6B4-A1D5-43AE-AB4E-E2E652BA8DC8}" dt="2025-08-25T04:32:41.448" v="31" actId="164"/>
          <ac:spMkLst>
            <pc:docMk/>
            <pc:sldMk cId="3484593726" sldId="272"/>
            <ac:spMk id="25" creationId="{5D9C8F9F-3D21-5375-776C-749044BC7926}"/>
          </ac:spMkLst>
        </pc:spChg>
        <pc:spChg chg="mod">
          <ac:chgData name="Hayashida, Ayaka" userId="14cb5ab0-815a-4b6d-80c2-d4f49147893d" providerId="ADAL" clId="{4E5FC6B4-A1D5-43AE-AB4E-E2E652BA8DC8}" dt="2025-08-25T04:32:28.963" v="27"/>
          <ac:spMkLst>
            <pc:docMk/>
            <pc:sldMk cId="3484593726" sldId="272"/>
            <ac:spMk id="26" creationId="{5EFC497E-050A-4AB0-AEAC-410A693FE4E1}"/>
          </ac:spMkLst>
        </pc:spChg>
        <pc:spChg chg="mod">
          <ac:chgData name="Hayashida, Ayaka" userId="14cb5ab0-815a-4b6d-80c2-d4f49147893d" providerId="ADAL" clId="{4E5FC6B4-A1D5-43AE-AB4E-E2E652BA8DC8}" dt="2025-08-25T04:32:43.021" v="32"/>
          <ac:spMkLst>
            <pc:docMk/>
            <pc:sldMk cId="3484593726" sldId="272"/>
            <ac:spMk id="32" creationId="{7B831A1E-BFF9-AB67-C74E-B6EA2C66C00E}"/>
          </ac:spMkLst>
        </pc:spChg>
        <pc:spChg chg="mod">
          <ac:chgData name="Hayashida, Ayaka" userId="14cb5ab0-815a-4b6d-80c2-d4f49147893d" providerId="ADAL" clId="{4E5FC6B4-A1D5-43AE-AB4E-E2E652BA8DC8}" dt="2025-08-25T04:32:43.021" v="32"/>
          <ac:spMkLst>
            <pc:docMk/>
            <pc:sldMk cId="3484593726" sldId="272"/>
            <ac:spMk id="33" creationId="{759DA549-7EFA-F45E-09D2-32588BD8FFFF}"/>
          </ac:spMkLst>
        </pc:spChg>
        <pc:spChg chg="mod">
          <ac:chgData name="Hayashida, Ayaka" userId="14cb5ab0-815a-4b6d-80c2-d4f49147893d" providerId="ADAL" clId="{4E5FC6B4-A1D5-43AE-AB4E-E2E652BA8DC8}" dt="2025-08-25T04:32:43.021" v="32"/>
          <ac:spMkLst>
            <pc:docMk/>
            <pc:sldMk cId="3484593726" sldId="272"/>
            <ac:spMk id="35" creationId="{60E4FCE3-5950-34C1-2C37-197F75CA78A4}"/>
          </ac:spMkLst>
        </pc:spChg>
        <pc:spChg chg="mod">
          <ac:chgData name="Hayashida, Ayaka" userId="14cb5ab0-815a-4b6d-80c2-d4f49147893d" providerId="ADAL" clId="{4E5FC6B4-A1D5-43AE-AB4E-E2E652BA8DC8}" dt="2025-08-25T04:32:43.021" v="32"/>
          <ac:spMkLst>
            <pc:docMk/>
            <pc:sldMk cId="3484593726" sldId="272"/>
            <ac:spMk id="36" creationId="{A7771379-B773-5DFB-30F3-08708B92E9FB}"/>
          </ac:spMkLst>
        </pc:spChg>
        <pc:grpChg chg="add del mod">
          <ac:chgData name="Hayashida, Ayaka" userId="14cb5ab0-815a-4b6d-80c2-d4f49147893d" providerId="ADAL" clId="{4E5FC6B4-A1D5-43AE-AB4E-E2E652BA8DC8}" dt="2025-08-25T04:32:32.246" v="29" actId="478"/>
          <ac:grpSpMkLst>
            <pc:docMk/>
            <pc:sldMk cId="3484593726" sldId="272"/>
            <ac:grpSpMk id="6" creationId="{C66B2C8F-2663-D385-0F69-2F7A0A4BEA53}"/>
          </ac:grpSpMkLst>
        </pc:grpChg>
        <pc:grpChg chg="add mod">
          <ac:chgData name="Hayashida, Ayaka" userId="14cb5ab0-815a-4b6d-80c2-d4f49147893d" providerId="ADAL" clId="{4E5FC6B4-A1D5-43AE-AB4E-E2E652BA8DC8}" dt="2025-08-25T04:32:28.963" v="27"/>
          <ac:grpSpMkLst>
            <pc:docMk/>
            <pc:sldMk cId="3484593726" sldId="272"/>
            <ac:grpSpMk id="8" creationId="{DC4A821C-918C-9EA5-92F4-2DB6EE125680}"/>
          </ac:grpSpMkLst>
        </pc:grpChg>
        <pc:grpChg chg="add del mod">
          <ac:chgData name="Hayashida, Ayaka" userId="14cb5ab0-815a-4b6d-80c2-d4f49147893d" providerId="ADAL" clId="{4E5FC6B4-A1D5-43AE-AB4E-E2E652BA8DC8}" dt="2025-08-25T04:32:46.254" v="34" actId="478"/>
          <ac:grpSpMkLst>
            <pc:docMk/>
            <pc:sldMk cId="3484593726" sldId="272"/>
            <ac:grpSpMk id="28" creationId="{92F653B1-AE5D-E5AA-0FD1-AE35ACAC57F3}"/>
          </ac:grpSpMkLst>
        </pc:grpChg>
        <pc:grpChg chg="add mod">
          <ac:chgData name="Hayashida, Ayaka" userId="14cb5ab0-815a-4b6d-80c2-d4f49147893d" providerId="ADAL" clId="{4E5FC6B4-A1D5-43AE-AB4E-E2E652BA8DC8}" dt="2025-08-25T04:32:43.021" v="32"/>
          <ac:grpSpMkLst>
            <pc:docMk/>
            <pc:sldMk cId="3484593726" sldId="272"/>
            <ac:grpSpMk id="29" creationId="{B53804B6-12B1-7244-D73D-DE17179630C2}"/>
          </ac:grpSpMkLst>
        </pc:grpChg>
        <pc:picChg chg="mod">
          <ac:chgData name="Hayashida, Ayaka" userId="14cb5ab0-815a-4b6d-80c2-d4f49147893d" providerId="ADAL" clId="{4E5FC6B4-A1D5-43AE-AB4E-E2E652BA8DC8}" dt="2025-08-25T04:32:28.097" v="26" actId="164"/>
          <ac:picMkLst>
            <pc:docMk/>
            <pc:sldMk cId="3484593726" sldId="272"/>
            <ac:picMk id="2" creationId="{496C402A-554F-A636-08E0-027E1D991958}"/>
          </ac:picMkLst>
        </pc:picChg>
        <pc:picChg chg="mod">
          <ac:chgData name="Hayashida, Ayaka" userId="14cb5ab0-815a-4b6d-80c2-d4f49147893d" providerId="ADAL" clId="{4E5FC6B4-A1D5-43AE-AB4E-E2E652BA8DC8}" dt="2025-08-25T04:32:41.448" v="31" actId="164"/>
          <ac:picMkLst>
            <pc:docMk/>
            <pc:sldMk cId="3484593726" sldId="272"/>
            <ac:picMk id="3" creationId="{FA82902A-178A-DB6B-3446-B4BB0060CFEC}"/>
          </ac:picMkLst>
        </pc:picChg>
        <pc:picChg chg="mod">
          <ac:chgData name="Hayashida, Ayaka" userId="14cb5ab0-815a-4b6d-80c2-d4f49147893d" providerId="ADAL" clId="{4E5FC6B4-A1D5-43AE-AB4E-E2E652BA8DC8}" dt="2025-08-25T04:32:28.963" v="27"/>
          <ac:picMkLst>
            <pc:docMk/>
            <pc:sldMk cId="3484593726" sldId="272"/>
            <ac:picMk id="9" creationId="{3BBA7968-D0FC-8EF0-709E-D22982F8513C}"/>
          </ac:picMkLst>
        </pc:picChg>
        <pc:picChg chg="mod">
          <ac:chgData name="Hayashida, Ayaka" userId="14cb5ab0-815a-4b6d-80c2-d4f49147893d" providerId="ADAL" clId="{4E5FC6B4-A1D5-43AE-AB4E-E2E652BA8DC8}" dt="2025-08-25T04:32:28.963" v="27"/>
          <ac:picMkLst>
            <pc:docMk/>
            <pc:sldMk cId="3484593726" sldId="272"/>
            <ac:picMk id="11" creationId="{E68C6711-9CB3-956D-B5DB-ECEF6226E2D0}"/>
          </ac:picMkLst>
        </pc:picChg>
        <pc:picChg chg="mod">
          <ac:chgData name="Hayashida, Ayaka" userId="14cb5ab0-815a-4b6d-80c2-d4f49147893d" providerId="ADAL" clId="{4E5FC6B4-A1D5-43AE-AB4E-E2E652BA8DC8}" dt="2025-08-25T04:32:28.097" v="26" actId="164"/>
          <ac:picMkLst>
            <pc:docMk/>
            <pc:sldMk cId="3484593726" sldId="272"/>
            <ac:picMk id="14" creationId="{7AD16473-46A5-447A-4000-17EE97D76763}"/>
          </ac:picMkLst>
        </pc:picChg>
        <pc:picChg chg="mod">
          <ac:chgData name="Hayashida, Ayaka" userId="14cb5ab0-815a-4b6d-80c2-d4f49147893d" providerId="ADAL" clId="{4E5FC6B4-A1D5-43AE-AB4E-E2E652BA8DC8}" dt="2025-08-25T04:32:41.448" v="31" actId="164"/>
          <ac:picMkLst>
            <pc:docMk/>
            <pc:sldMk cId="3484593726" sldId="272"/>
            <ac:picMk id="21" creationId="{1CE6909C-58B9-8CFB-38E7-ED791C098F70}"/>
          </ac:picMkLst>
        </pc:picChg>
        <pc:picChg chg="add mod">
          <ac:chgData name="Hayashida, Ayaka" userId="14cb5ab0-815a-4b6d-80c2-d4f49147893d" providerId="ADAL" clId="{4E5FC6B4-A1D5-43AE-AB4E-E2E652BA8DC8}" dt="2025-08-25T04:32:36.654" v="30" actId="1076"/>
          <ac:picMkLst>
            <pc:docMk/>
            <pc:sldMk cId="3484593726" sldId="272"/>
            <ac:picMk id="27" creationId="{0A62CFA1-DE4A-68EA-F69B-B2729E455B60}"/>
          </ac:picMkLst>
        </pc:picChg>
        <pc:picChg chg="mod">
          <ac:chgData name="Hayashida, Ayaka" userId="14cb5ab0-815a-4b6d-80c2-d4f49147893d" providerId="ADAL" clId="{4E5FC6B4-A1D5-43AE-AB4E-E2E652BA8DC8}" dt="2025-08-25T04:32:43.021" v="32"/>
          <ac:picMkLst>
            <pc:docMk/>
            <pc:sldMk cId="3484593726" sldId="272"/>
            <ac:picMk id="30" creationId="{03E1F45C-3536-4869-3EAB-CB9D40320F81}"/>
          </ac:picMkLst>
        </pc:picChg>
        <pc:picChg chg="mod">
          <ac:chgData name="Hayashida, Ayaka" userId="14cb5ab0-815a-4b6d-80c2-d4f49147893d" providerId="ADAL" clId="{4E5FC6B4-A1D5-43AE-AB4E-E2E652BA8DC8}" dt="2025-08-25T04:32:43.021" v="32"/>
          <ac:picMkLst>
            <pc:docMk/>
            <pc:sldMk cId="3484593726" sldId="272"/>
            <ac:picMk id="34" creationId="{748E7220-49C8-DA49-13E3-9120875684A0}"/>
          </ac:picMkLst>
        </pc:picChg>
        <pc:picChg chg="add mod">
          <ac:chgData name="Hayashida, Ayaka" userId="14cb5ab0-815a-4b6d-80c2-d4f49147893d" providerId="ADAL" clId="{4E5FC6B4-A1D5-43AE-AB4E-E2E652BA8DC8}" dt="2025-08-25T04:32:49.664" v="35" actId="1076"/>
          <ac:picMkLst>
            <pc:docMk/>
            <pc:sldMk cId="3484593726" sldId="272"/>
            <ac:picMk id="37" creationId="{802E69F3-CE67-3807-762A-0B8C2A262AF8}"/>
          </ac:picMkLst>
        </pc:picChg>
        <pc:cxnChg chg="mod">
          <ac:chgData name="Hayashida, Ayaka" userId="14cb5ab0-815a-4b6d-80c2-d4f49147893d" providerId="ADAL" clId="{4E5FC6B4-A1D5-43AE-AB4E-E2E652BA8DC8}" dt="2025-08-25T04:32:28.097" v="26" actId="164"/>
          <ac:cxnSpMkLst>
            <pc:docMk/>
            <pc:sldMk cId="3484593726" sldId="272"/>
            <ac:cxnSpMk id="7" creationId="{7AFAFED4-1672-D26C-AF09-84B2F81B612F}"/>
          </ac:cxnSpMkLst>
        </pc:cxnChg>
        <pc:cxnChg chg="mod">
          <ac:chgData name="Hayashida, Ayaka" userId="14cb5ab0-815a-4b6d-80c2-d4f49147893d" providerId="ADAL" clId="{4E5FC6B4-A1D5-43AE-AB4E-E2E652BA8DC8}" dt="2025-08-25T04:32:28.963" v="27"/>
          <ac:cxnSpMkLst>
            <pc:docMk/>
            <pc:sldMk cId="3484593726" sldId="272"/>
            <ac:cxnSpMk id="10" creationId="{A07A031F-6A4E-0CA1-4822-7505DA5D6311}"/>
          </ac:cxnSpMkLst>
        </pc:cxnChg>
        <pc:cxnChg chg="mod">
          <ac:chgData name="Hayashida, Ayaka" userId="14cb5ab0-815a-4b6d-80c2-d4f49147893d" providerId="ADAL" clId="{4E5FC6B4-A1D5-43AE-AB4E-E2E652BA8DC8}" dt="2025-08-25T04:32:41.448" v="31" actId="164"/>
          <ac:cxnSpMkLst>
            <pc:docMk/>
            <pc:sldMk cId="3484593726" sldId="272"/>
            <ac:cxnSpMk id="12" creationId="{9F514681-590C-1B66-942D-3CBC9280A90E}"/>
          </ac:cxnSpMkLst>
        </pc:cxnChg>
        <pc:cxnChg chg="mod">
          <ac:chgData name="Hayashida, Ayaka" userId="14cb5ab0-815a-4b6d-80c2-d4f49147893d" providerId="ADAL" clId="{4E5FC6B4-A1D5-43AE-AB4E-E2E652BA8DC8}" dt="2025-08-25T04:32:43.021" v="32"/>
          <ac:cxnSpMkLst>
            <pc:docMk/>
            <pc:sldMk cId="3484593726" sldId="272"/>
            <ac:cxnSpMk id="31" creationId="{0F07F286-FD2A-4A1B-1970-03867E53D3C2}"/>
          </ac:cxnSpMkLst>
        </pc:cxnChg>
      </pc:sldChg>
      <pc:sldChg chg="modNotesTx">
        <pc:chgData name="Hayashida, Ayaka" userId="14cb5ab0-815a-4b6d-80c2-d4f49147893d" providerId="ADAL" clId="{4E5FC6B4-A1D5-43AE-AB4E-E2E652BA8DC8}" dt="2025-08-25T04:35:39.702" v="68" actId="20577"/>
        <pc:sldMkLst>
          <pc:docMk/>
          <pc:sldMk cId="2229876628" sldId="273"/>
        </pc:sldMkLst>
      </pc:sldChg>
    </pc:docChg>
  </pc:docChgLst>
  <pc:docChgLst>
    <pc:chgData name="Hayashida, Ayaka" userId="14cb5ab0-815a-4b6d-80c2-d4f49147893d" providerId="ADAL" clId="{280BB9DC-5B1D-4337-8377-0D9B8EBEDA4D}"/>
    <pc:docChg chg="delSld modSld delSection modSection">
      <pc:chgData name="Hayashida, Ayaka" userId="14cb5ab0-815a-4b6d-80c2-d4f49147893d" providerId="ADAL" clId="{280BB9DC-5B1D-4337-8377-0D9B8EBEDA4D}" dt="2025-08-25T04:29:04.947" v="17" actId="20577"/>
      <pc:docMkLst>
        <pc:docMk/>
      </pc:docMkLst>
      <pc:sldChg chg="del">
        <pc:chgData name="Hayashida, Ayaka" userId="14cb5ab0-815a-4b6d-80c2-d4f49147893d" providerId="ADAL" clId="{280BB9DC-5B1D-4337-8377-0D9B8EBEDA4D}" dt="2025-08-25T04:14:02.731" v="0" actId="2696"/>
        <pc:sldMkLst>
          <pc:docMk/>
          <pc:sldMk cId="2460035802" sldId="257"/>
        </pc:sldMkLst>
      </pc:sldChg>
      <pc:sldChg chg="del">
        <pc:chgData name="Hayashida, Ayaka" userId="14cb5ab0-815a-4b6d-80c2-d4f49147893d" providerId="ADAL" clId="{280BB9DC-5B1D-4337-8377-0D9B8EBEDA4D}" dt="2025-08-25T04:14:02.731" v="0" actId="2696"/>
        <pc:sldMkLst>
          <pc:docMk/>
          <pc:sldMk cId="3388433354" sldId="259"/>
        </pc:sldMkLst>
      </pc:sldChg>
      <pc:sldChg chg="del">
        <pc:chgData name="Hayashida, Ayaka" userId="14cb5ab0-815a-4b6d-80c2-d4f49147893d" providerId="ADAL" clId="{280BB9DC-5B1D-4337-8377-0D9B8EBEDA4D}" dt="2025-08-25T04:14:02.731" v="0" actId="2696"/>
        <pc:sldMkLst>
          <pc:docMk/>
          <pc:sldMk cId="4258092019" sldId="260"/>
        </pc:sldMkLst>
      </pc:sldChg>
      <pc:sldChg chg="del">
        <pc:chgData name="Hayashida, Ayaka" userId="14cb5ab0-815a-4b6d-80c2-d4f49147893d" providerId="ADAL" clId="{280BB9DC-5B1D-4337-8377-0D9B8EBEDA4D}" dt="2025-08-25T04:14:02.731" v="0" actId="2696"/>
        <pc:sldMkLst>
          <pc:docMk/>
          <pc:sldMk cId="1553547735" sldId="261"/>
        </pc:sldMkLst>
      </pc:sldChg>
      <pc:sldChg chg="modSp mod">
        <pc:chgData name="Hayashida, Ayaka" userId="14cb5ab0-815a-4b6d-80c2-d4f49147893d" providerId="ADAL" clId="{280BB9DC-5B1D-4337-8377-0D9B8EBEDA4D}" dt="2025-08-25T04:14:20.180" v="2" actId="1076"/>
        <pc:sldMkLst>
          <pc:docMk/>
          <pc:sldMk cId="2777100696" sldId="266"/>
        </pc:sldMkLst>
        <pc:spChg chg="mod">
          <ac:chgData name="Hayashida, Ayaka" userId="14cb5ab0-815a-4b6d-80c2-d4f49147893d" providerId="ADAL" clId="{280BB9DC-5B1D-4337-8377-0D9B8EBEDA4D}" dt="2025-08-25T04:14:20.180" v="2" actId="1076"/>
          <ac:spMkLst>
            <pc:docMk/>
            <pc:sldMk cId="2777100696" sldId="266"/>
            <ac:spMk id="8" creationId="{A0B3BB32-D587-DC69-0838-FFC2DA1CAC05}"/>
          </ac:spMkLst>
        </pc:spChg>
        <pc:spChg chg="mod">
          <ac:chgData name="Hayashida, Ayaka" userId="14cb5ab0-815a-4b6d-80c2-d4f49147893d" providerId="ADAL" clId="{280BB9DC-5B1D-4337-8377-0D9B8EBEDA4D}" dt="2025-08-25T04:14:20.180" v="2" actId="1076"/>
          <ac:spMkLst>
            <pc:docMk/>
            <pc:sldMk cId="2777100696" sldId="266"/>
            <ac:spMk id="9" creationId="{D4175C51-6ECF-F672-27E9-6445E03F33F7}"/>
          </ac:spMkLst>
        </pc:spChg>
        <pc:spChg chg="mod">
          <ac:chgData name="Hayashida, Ayaka" userId="14cb5ab0-815a-4b6d-80c2-d4f49147893d" providerId="ADAL" clId="{280BB9DC-5B1D-4337-8377-0D9B8EBEDA4D}" dt="2025-08-25T04:14:20.180" v="2" actId="1076"/>
          <ac:spMkLst>
            <pc:docMk/>
            <pc:sldMk cId="2777100696" sldId="266"/>
            <ac:spMk id="10" creationId="{F2D468A6-F7D8-A7F4-4BC3-895C150BB0C9}"/>
          </ac:spMkLst>
        </pc:spChg>
      </pc:sldChg>
      <pc:sldChg chg="modNotesTx">
        <pc:chgData name="Hayashida, Ayaka" userId="14cb5ab0-815a-4b6d-80c2-d4f49147893d" providerId="ADAL" clId="{280BB9DC-5B1D-4337-8377-0D9B8EBEDA4D}" dt="2025-08-25T04:29:04.947" v="17" actId="20577"/>
        <pc:sldMkLst>
          <pc:docMk/>
          <pc:sldMk cId="3226107819" sldId="270"/>
        </pc:sldMkLst>
      </pc:sldChg>
      <pc:sldChg chg="del">
        <pc:chgData name="Hayashida, Ayaka" userId="14cb5ab0-815a-4b6d-80c2-d4f49147893d" providerId="ADAL" clId="{280BB9DC-5B1D-4337-8377-0D9B8EBEDA4D}" dt="2025-08-25T04:14:02.731" v="0" actId="2696"/>
        <pc:sldMkLst>
          <pc:docMk/>
          <pc:sldMk cId="2659837790" sldId="27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BCF9D6A-C695-47EE-870D-37D9A121DC5D}" type="datetimeFigureOut">
              <a:rPr lang="en-US" smtClean="0"/>
              <a:t>8/25/2025</a:t>
            </a:fld>
            <a:endParaRPr lang="en-US"/>
          </a:p>
        </p:txBody>
      </p:sp>
      <p:sp>
        <p:nvSpPr>
          <p:cNvPr id="4" name="スライド イメージ プレースホルダー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5BC94F-85FF-4747-A360-38CB959BA2AF}" type="slidenum">
              <a:rPr lang="en-US" smtClean="0"/>
              <a:t>‹#›</a:t>
            </a:fld>
            <a:endParaRPr lang="en-US"/>
          </a:p>
        </p:txBody>
      </p:sp>
    </p:spTree>
    <p:extLst>
      <p:ext uri="{BB962C8B-B14F-4D97-AF65-F5344CB8AC3E}">
        <p14:creationId xmlns:p14="http://schemas.microsoft.com/office/powerpoint/2010/main" val="28989384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Supplementary Table S1 | An overview of TPM and ACM collection.</a:t>
            </a:r>
          </a:p>
          <a:p>
            <a:endParaRPr lang="en-US" dirty="0"/>
          </a:p>
        </p:txBody>
      </p:sp>
      <p:sp>
        <p:nvSpPr>
          <p:cNvPr id="4" name="スライド番号プレースホルダー 3"/>
          <p:cNvSpPr>
            <a:spLocks noGrp="1"/>
          </p:cNvSpPr>
          <p:nvPr>
            <p:ph type="sldNum" sz="quarter" idx="5"/>
          </p:nvPr>
        </p:nvSpPr>
        <p:spPr/>
        <p:txBody>
          <a:bodyPr/>
          <a:lstStyle/>
          <a:p>
            <a:fld id="{7D5BC94F-85FF-4747-A360-38CB959BA2AF}" type="slidenum">
              <a:rPr lang="en-US" smtClean="0"/>
              <a:t>1</a:t>
            </a:fld>
            <a:endParaRPr lang="en-US"/>
          </a:p>
        </p:txBody>
      </p:sp>
    </p:spTree>
    <p:extLst>
      <p:ext uri="{BB962C8B-B14F-4D97-AF65-F5344CB8AC3E}">
        <p14:creationId xmlns:p14="http://schemas.microsoft.com/office/powerpoint/2010/main" val="31591964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1 | A schematic overview of </a:t>
            </a:r>
            <a:r>
              <a:rPr lang="en-US" sz="1200" kern="1200" dirty="0" err="1">
                <a:solidFill>
                  <a:schemeClr val="tx1"/>
                </a:solidFill>
                <a:effectLst/>
                <a:latin typeface="+mn-lt"/>
                <a:ea typeface="+mn-ea"/>
                <a:cs typeface="+mn-cs"/>
              </a:rPr>
              <a:t>OrganoPlate</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3-lane 40.</a:t>
            </a:r>
          </a:p>
          <a:p>
            <a:r>
              <a:rPr lang="en-US" sz="1200" kern="1200" dirty="0">
                <a:solidFill>
                  <a:schemeClr val="tx1"/>
                </a:solidFill>
                <a:effectLst/>
                <a:latin typeface="+mn-lt"/>
                <a:ea typeface="+mn-ea"/>
                <a:cs typeface="+mn-cs"/>
              </a:rPr>
              <a:t>(A) An overview of a chip on the </a:t>
            </a:r>
            <a:r>
              <a:rPr lang="en-US" sz="1200" kern="1200" dirty="0" err="1">
                <a:solidFill>
                  <a:schemeClr val="tx1"/>
                </a:solidFill>
                <a:effectLst/>
                <a:latin typeface="+mn-lt"/>
                <a:ea typeface="+mn-ea"/>
                <a:cs typeface="+mn-cs"/>
              </a:rPr>
              <a:t>OrganoPlate</a:t>
            </a:r>
            <a:r>
              <a:rPr lang="en-US" sz="1200" kern="1200" baseline="300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3-lane 40. A plate contains 40 chips based on the platform of a 384-well plate. Each lane has inlets and outlets to allow the addition of cells or reagents. (B) A schematic view of the tubules of HCAECs from the top and from the side. HCAECs, human coronary artery endothelial cells; ECM, extracellular matrix.</a:t>
            </a:r>
          </a:p>
          <a:p>
            <a:endParaRPr lang="en-US" dirty="0"/>
          </a:p>
        </p:txBody>
      </p:sp>
      <p:sp>
        <p:nvSpPr>
          <p:cNvPr id="4" name="スライド番号プレースホルダー 3"/>
          <p:cNvSpPr>
            <a:spLocks noGrp="1"/>
          </p:cNvSpPr>
          <p:nvPr>
            <p:ph type="sldNum" sz="quarter" idx="5"/>
          </p:nvPr>
        </p:nvSpPr>
        <p:spPr/>
        <p:txBody>
          <a:bodyPr/>
          <a:lstStyle/>
          <a:p>
            <a:fld id="{8556CB2B-08D9-4328-872B-F42897B56352}" type="slidenum">
              <a:rPr lang="en-US" smtClean="0"/>
              <a:t>2</a:t>
            </a:fld>
            <a:endParaRPr lang="en-US" dirty="0"/>
          </a:p>
        </p:txBody>
      </p:sp>
    </p:spTree>
    <p:extLst>
      <p:ext uri="{BB962C8B-B14F-4D97-AF65-F5344CB8AC3E}">
        <p14:creationId xmlns:p14="http://schemas.microsoft.com/office/powerpoint/2010/main" val="40359862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2 | Barrier formation of HCAECs cultured in </a:t>
            </a:r>
            <a:r>
              <a:rPr lang="en-US" sz="1200" kern="1200" dirty="0" err="1">
                <a:solidFill>
                  <a:schemeClr val="tx1"/>
                </a:solidFill>
                <a:effectLst/>
                <a:latin typeface="+mn-lt"/>
                <a:ea typeface="+mn-ea"/>
                <a:cs typeface="+mn-cs"/>
              </a:rPr>
              <a:t>OrganoPlate</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3-lane 40.</a:t>
            </a:r>
          </a:p>
          <a:p>
            <a:r>
              <a:rPr lang="en-US" sz="1200" kern="1200" dirty="0">
                <a:solidFill>
                  <a:schemeClr val="tx1"/>
                </a:solidFill>
                <a:effectLst/>
                <a:latin typeface="+mn-lt"/>
                <a:ea typeface="+mn-ea"/>
                <a:cs typeface="+mn-cs"/>
              </a:rPr>
              <a:t>(A) The TEER of HCAECs seeded in </a:t>
            </a:r>
            <a:r>
              <a:rPr lang="en-US" sz="1200" kern="1200" dirty="0" err="1">
                <a:solidFill>
                  <a:schemeClr val="tx1"/>
                </a:solidFill>
                <a:effectLst/>
                <a:latin typeface="+mn-lt"/>
                <a:ea typeface="+mn-ea"/>
                <a:cs typeface="+mn-cs"/>
              </a:rPr>
              <a:t>OrganoPlate</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on day 5 cultured with MV2 or </a:t>
            </a:r>
            <a:r>
              <a:rPr lang="en-US" sz="1200" kern="1200" dirty="0" err="1">
                <a:solidFill>
                  <a:schemeClr val="tx1"/>
                </a:solidFill>
                <a:effectLst/>
                <a:latin typeface="+mn-lt"/>
                <a:ea typeface="+mn-ea"/>
                <a:cs typeface="+mn-cs"/>
              </a:rPr>
              <a:t>OrganoMedium</a:t>
            </a:r>
            <a:r>
              <a:rPr lang="en-US" sz="1200" kern="1200" dirty="0">
                <a:solidFill>
                  <a:schemeClr val="tx1"/>
                </a:solidFill>
                <a:effectLst/>
                <a:latin typeface="+mn-lt"/>
                <a:ea typeface="+mn-ea"/>
                <a:cs typeface="+mn-cs"/>
              </a:rPr>
              <a:t> (N = 3, n = 6 or 7). Cell-free chips were below the measurement limit of the </a:t>
            </a:r>
            <a:r>
              <a:rPr lang="en-US" sz="1200" kern="1200" dirty="0" err="1">
                <a:solidFill>
                  <a:schemeClr val="tx1"/>
                </a:solidFill>
                <a:effectLst/>
                <a:latin typeface="+mn-lt"/>
                <a:ea typeface="+mn-ea"/>
                <a:cs typeface="+mn-cs"/>
              </a:rPr>
              <a:t>OrganoTEER</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N = 2, n = 3). Open circles in each group represent the value of each biological replicate. Bars represent the mean, and error bars indicate 95%CI. Statistical analysis was performed using the Mann–Whitney </a:t>
            </a:r>
            <a:r>
              <a:rPr lang="en-US" sz="1200" i="1" kern="1200" dirty="0">
                <a:solidFill>
                  <a:schemeClr val="tx1"/>
                </a:solidFill>
                <a:effectLst/>
                <a:latin typeface="+mn-lt"/>
                <a:ea typeface="+mn-ea"/>
                <a:cs typeface="+mn-cs"/>
              </a:rPr>
              <a:t>U</a:t>
            </a:r>
            <a:r>
              <a:rPr lang="en-US" sz="1200" kern="1200" dirty="0">
                <a:solidFill>
                  <a:schemeClr val="tx1"/>
                </a:solidFill>
                <a:effectLst/>
                <a:latin typeface="+mn-lt"/>
                <a:ea typeface="+mn-ea"/>
                <a:cs typeface="+mn-cs"/>
              </a:rPr>
              <a:t>-test. Asterisks indicate a statistically significant difference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01). (B) Representative fluorescence images of </a:t>
            </a:r>
            <a:r>
              <a:rPr lang="en-US" sz="1200" kern="1200" dirty="0" err="1">
                <a:solidFill>
                  <a:schemeClr val="tx1"/>
                </a:solidFill>
                <a:effectLst/>
                <a:latin typeface="+mn-lt"/>
                <a:ea typeface="+mn-ea"/>
                <a:cs typeface="+mn-cs"/>
              </a:rPr>
              <a:t>VoC</a:t>
            </a:r>
            <a:r>
              <a:rPr lang="en-US" sz="1200" kern="1200" dirty="0">
                <a:solidFill>
                  <a:schemeClr val="tx1"/>
                </a:solidFill>
                <a:effectLst/>
                <a:latin typeface="+mn-lt"/>
                <a:ea typeface="+mn-ea"/>
                <a:cs typeface="+mn-cs"/>
              </a:rPr>
              <a:t> on day 5 at the best focused position stained with ZO-1 (orange) and nuclei stained with Hoechst 33342 (blue). TEER, trans-endothelial electrical resistance; HCAEC, human coronary artery endothelial cell; </a:t>
            </a:r>
            <a:r>
              <a:rPr lang="en-US" sz="1200" kern="1200" dirty="0" err="1">
                <a:solidFill>
                  <a:schemeClr val="tx1"/>
                </a:solidFill>
                <a:effectLst/>
                <a:latin typeface="+mn-lt"/>
                <a:ea typeface="+mn-ea"/>
                <a:cs typeface="+mn-cs"/>
              </a:rPr>
              <a:t>VoC</a:t>
            </a:r>
            <a:r>
              <a:rPr lang="en-US" sz="1200" kern="1200" dirty="0">
                <a:solidFill>
                  <a:schemeClr val="tx1"/>
                </a:solidFill>
                <a:effectLst/>
                <a:latin typeface="+mn-lt"/>
                <a:ea typeface="+mn-ea"/>
                <a:cs typeface="+mn-cs"/>
              </a:rPr>
              <a:t>, Vascular-on-a-Chip; ZO-1, Zonula Occludens-1; n.d., not detected; CI, confidence interval.</a:t>
            </a:r>
          </a:p>
          <a:p>
            <a:endParaRPr lang="en-US" dirty="0"/>
          </a:p>
        </p:txBody>
      </p:sp>
      <p:sp>
        <p:nvSpPr>
          <p:cNvPr id="4" name="スライド番号プレースホルダー 3"/>
          <p:cNvSpPr>
            <a:spLocks noGrp="1"/>
          </p:cNvSpPr>
          <p:nvPr>
            <p:ph type="sldNum" sz="quarter" idx="5"/>
          </p:nvPr>
        </p:nvSpPr>
        <p:spPr/>
        <p:txBody>
          <a:bodyPr/>
          <a:lstStyle/>
          <a:p>
            <a:fld id="{8556CB2B-08D9-4328-872B-F42897B56352}" type="slidenum">
              <a:rPr lang="en-US" smtClean="0"/>
              <a:t>3</a:t>
            </a:fld>
            <a:endParaRPr lang="en-US" dirty="0"/>
          </a:p>
        </p:txBody>
      </p:sp>
    </p:spTree>
    <p:extLst>
      <p:ext uri="{BB962C8B-B14F-4D97-AF65-F5344CB8AC3E}">
        <p14:creationId xmlns:p14="http://schemas.microsoft.com/office/powerpoint/2010/main" val="7829862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3 | Dose-response of the TEER, and monocyte adhesion and migration to proinflammatory cytokines under the conditions of MCP-1 addition.</a:t>
            </a:r>
          </a:p>
          <a:p>
            <a:r>
              <a:rPr lang="en-US" sz="1200" kern="1200" dirty="0">
                <a:solidFill>
                  <a:schemeClr val="tx1"/>
                </a:solidFill>
                <a:effectLst/>
                <a:latin typeface="+mn-lt"/>
                <a:ea typeface="+mn-ea"/>
                <a:cs typeface="+mn-cs"/>
              </a:rPr>
              <a:t>(A) The TEER of HCAECs after 24 hours of exposure to proinflammatory cytokines (N = 2, n = 2 or 3). (B) The number of adhered monocytes on HCAECs 2 hours after the addition of monocytes (N = 2, n = 2 or 3). (C) The number of monocytes that migrated through HCAECs with the addition of MCP-1 48 hours after the addition of monocytes (N = 2, n = 2 or 3). Data represent the mean ± 95%CI. Statistical analysis was performed using the Kruskal–Wallis test followed by Dunn’s test with a control for joint rank tests (control: 0 ng/mL of IL-1β or TNF-α) with Bonferroni correction. Asterisks indicate a statistically significant difference compared with respective solvent controls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5,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1,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01). TEER, trans-endothelial electrical resistance; HCAEC, human coronary artery endothelial cell; MCP, monocyte chemotactic protein; IL, interleukin; TNF, tumor necrosis factor; CI, confidence interval.</a:t>
            </a:r>
          </a:p>
          <a:p>
            <a:endParaRPr lang="en-US" dirty="0"/>
          </a:p>
        </p:txBody>
      </p:sp>
      <p:sp>
        <p:nvSpPr>
          <p:cNvPr id="4" name="スライド番号プレースホルダー 3"/>
          <p:cNvSpPr>
            <a:spLocks noGrp="1"/>
          </p:cNvSpPr>
          <p:nvPr>
            <p:ph type="sldNum" sz="quarter" idx="5"/>
          </p:nvPr>
        </p:nvSpPr>
        <p:spPr/>
        <p:txBody>
          <a:bodyPr/>
          <a:lstStyle/>
          <a:p>
            <a:fld id="{7D5BC94F-85FF-4747-A360-38CB959BA2AF}" type="slidenum">
              <a:rPr lang="en-US" smtClean="0"/>
              <a:t>4</a:t>
            </a:fld>
            <a:endParaRPr lang="en-US"/>
          </a:p>
        </p:txBody>
      </p:sp>
    </p:spTree>
    <p:extLst>
      <p:ext uri="{BB962C8B-B14F-4D97-AF65-F5344CB8AC3E}">
        <p14:creationId xmlns:p14="http://schemas.microsoft.com/office/powerpoint/2010/main" val="10337373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4 | Cytotoxicity of unexposed M1 macrophages.</a:t>
            </a:r>
          </a:p>
          <a:p>
            <a:r>
              <a:rPr lang="en-US" sz="1200" kern="1200" dirty="0">
                <a:solidFill>
                  <a:schemeClr val="tx1"/>
                </a:solidFill>
                <a:effectLst/>
                <a:latin typeface="+mn-lt"/>
                <a:ea typeface="+mn-ea"/>
                <a:cs typeface="+mn-cs"/>
              </a:rPr>
              <a:t>(A) IL-1β and (B) TNF-α concentrations secreted from M1MΦ exposed to 1% DMSO or non-treated M1MΦ (non-treatment control) (N = 2, n = 2). (C) Cytotoxicity assay of M1MΦs after exposure to 1% DMSO for 24 hours or unexposed M1MΦs (non-treatment control) (N = 2, n = 3). Data represent the mean ±95%CI, and open circles represent the absorbance value of each biological replicate. Statistical analysis was performed using the Mann–Whitney </a:t>
            </a:r>
            <a:r>
              <a:rPr lang="en-US" sz="1200" i="1" kern="1200" dirty="0">
                <a:solidFill>
                  <a:schemeClr val="tx1"/>
                </a:solidFill>
                <a:effectLst/>
                <a:latin typeface="+mn-lt"/>
                <a:ea typeface="+mn-ea"/>
                <a:cs typeface="+mn-cs"/>
              </a:rPr>
              <a:t>U</a:t>
            </a:r>
            <a:r>
              <a:rPr lang="en-US" sz="1200" kern="1200" dirty="0">
                <a:solidFill>
                  <a:schemeClr val="tx1"/>
                </a:solidFill>
                <a:effectLst/>
                <a:latin typeface="+mn-lt"/>
                <a:ea typeface="+mn-ea"/>
                <a:cs typeface="+mn-cs"/>
              </a:rPr>
              <a:t>-test. Asterisks indicate a statistically significant difference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1). IL, interleukin; TNF, tumor necrosis factor; MΦs, macrophages; DMSO, dimethyl sulfoxide; CI, confidence interval.</a:t>
            </a:r>
          </a:p>
          <a:p>
            <a:endParaRPr lang="en-US" dirty="0"/>
          </a:p>
        </p:txBody>
      </p:sp>
      <p:sp>
        <p:nvSpPr>
          <p:cNvPr id="4" name="スライド番号プレースホルダー 3"/>
          <p:cNvSpPr>
            <a:spLocks noGrp="1"/>
          </p:cNvSpPr>
          <p:nvPr>
            <p:ph type="sldNum" sz="quarter" idx="5"/>
          </p:nvPr>
        </p:nvSpPr>
        <p:spPr/>
        <p:txBody>
          <a:bodyPr/>
          <a:lstStyle/>
          <a:p>
            <a:fld id="{7D5BC94F-85FF-4747-A360-38CB959BA2AF}" type="slidenum">
              <a:rPr lang="en-US" smtClean="0"/>
              <a:t>5</a:t>
            </a:fld>
            <a:endParaRPr lang="en-US"/>
          </a:p>
        </p:txBody>
      </p:sp>
    </p:spTree>
    <p:extLst>
      <p:ext uri="{BB962C8B-B14F-4D97-AF65-F5344CB8AC3E}">
        <p14:creationId xmlns:p14="http://schemas.microsoft.com/office/powerpoint/2010/main" val="14220454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5 | The TEER, and monocyte adhesion and migration of non-treated </a:t>
            </a:r>
            <a:r>
              <a:rPr lang="en-US" sz="1200" kern="1200" dirty="0" err="1">
                <a:solidFill>
                  <a:schemeClr val="tx1"/>
                </a:solidFill>
                <a:effectLst/>
                <a:latin typeface="+mn-lt"/>
                <a:ea typeface="+mn-ea"/>
                <a:cs typeface="+mn-cs"/>
              </a:rPr>
              <a:t>VoCs</a:t>
            </a:r>
            <a:r>
              <a:rPr lang="en-US" sz="1200" kern="1200" dirty="0">
                <a:solidFill>
                  <a:schemeClr val="tx1"/>
                </a:solidFill>
                <a:effectLst/>
                <a:latin typeface="+mn-lt"/>
                <a:ea typeface="+mn-ea"/>
                <a:cs typeface="+mn-cs"/>
              </a:rPr>
              <a:t>.</a:t>
            </a:r>
          </a:p>
          <a:p>
            <a:r>
              <a:rPr lang="en-US" sz="1200" kern="1200" dirty="0">
                <a:solidFill>
                  <a:schemeClr val="tx1"/>
                </a:solidFill>
                <a:effectLst/>
                <a:latin typeface="+mn-lt"/>
                <a:ea typeface="+mn-ea"/>
                <a:cs typeface="+mn-cs"/>
              </a:rPr>
              <a:t>As a non-treatment control, </a:t>
            </a:r>
            <a:r>
              <a:rPr lang="en-US" sz="1200" kern="1200" dirty="0" err="1">
                <a:solidFill>
                  <a:schemeClr val="tx1"/>
                </a:solidFill>
                <a:effectLst/>
                <a:latin typeface="+mn-lt"/>
                <a:ea typeface="+mn-ea"/>
                <a:cs typeface="+mn-cs"/>
              </a:rPr>
              <a:t>VoCs</a:t>
            </a:r>
            <a:r>
              <a:rPr lang="en-US" sz="1200" kern="1200" dirty="0">
                <a:solidFill>
                  <a:schemeClr val="tx1"/>
                </a:solidFill>
                <a:effectLst/>
                <a:latin typeface="+mn-lt"/>
                <a:ea typeface="+mn-ea"/>
                <a:cs typeface="+mn-cs"/>
              </a:rPr>
              <a:t> were cultured with </a:t>
            </a:r>
            <a:r>
              <a:rPr lang="en-US" sz="1200" kern="1200" dirty="0" err="1">
                <a:solidFill>
                  <a:schemeClr val="tx1"/>
                </a:solidFill>
                <a:effectLst/>
                <a:latin typeface="+mn-lt"/>
                <a:ea typeface="+mn-ea"/>
                <a:cs typeface="+mn-cs"/>
              </a:rPr>
              <a:t>OrganoMedium</a:t>
            </a:r>
            <a:r>
              <a:rPr lang="en-US" sz="1200" kern="1200" dirty="0">
                <a:solidFill>
                  <a:schemeClr val="tx1"/>
                </a:solidFill>
                <a:effectLst/>
                <a:latin typeface="+mn-lt"/>
                <a:ea typeface="+mn-ea"/>
                <a:cs typeface="+mn-cs"/>
              </a:rPr>
              <a:t> for 24 hours. (A) The TEER of HCAECs after 24 hours of cultivation (N = 4, n = 5 or 6). (B) Monocyte adhesion to HCAECs 2 hours after the addition of monocytes (N = 4, n = 5 or 6), and (C) monocyte migration through HCAECs 48 hours after the addition of monocytes (N = 4, n = 5 or 6). Four separate experiments with four to six chips in each experiment were performed (n = 17–24). Data represent the mean ± 95%CI, and open circles in each group represent the value of each biological replicate. Statistical analysis was performed using the Mann–Whitney </a:t>
            </a:r>
            <a:r>
              <a:rPr lang="en-US" sz="1200" i="1" kern="1200" dirty="0">
                <a:solidFill>
                  <a:schemeClr val="tx1"/>
                </a:solidFill>
                <a:effectLst/>
                <a:latin typeface="+mn-lt"/>
                <a:ea typeface="+mn-ea"/>
                <a:cs typeface="+mn-cs"/>
              </a:rPr>
              <a:t>U</a:t>
            </a:r>
            <a:r>
              <a:rPr lang="en-US" sz="1200" kern="1200" dirty="0">
                <a:solidFill>
                  <a:schemeClr val="tx1"/>
                </a:solidFill>
                <a:effectLst/>
                <a:latin typeface="+mn-lt"/>
                <a:ea typeface="+mn-ea"/>
                <a:cs typeface="+mn-cs"/>
              </a:rPr>
              <a:t>-test. Asterisks indicate a statistically significant difference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01). </a:t>
            </a:r>
            <a:r>
              <a:rPr lang="en-US" sz="1200" kern="1200" dirty="0" err="1">
                <a:solidFill>
                  <a:schemeClr val="tx1"/>
                </a:solidFill>
                <a:effectLst/>
                <a:latin typeface="+mn-lt"/>
                <a:ea typeface="+mn-ea"/>
                <a:cs typeface="+mn-cs"/>
              </a:rPr>
              <a:t>VoC</a:t>
            </a:r>
            <a:r>
              <a:rPr lang="en-US" sz="1200" kern="1200" dirty="0">
                <a:solidFill>
                  <a:schemeClr val="tx1"/>
                </a:solidFill>
                <a:effectLst/>
                <a:latin typeface="+mn-lt"/>
                <a:ea typeface="+mn-ea"/>
                <a:cs typeface="+mn-cs"/>
              </a:rPr>
              <a:t>, Vascular-on-a-Chip; TEER, trans-endothelial electrical resistance; HCAEC, human coronary artery endothelial cell; DMSO, dimethyl sulfoxide; CI, confidence interval.</a:t>
            </a:r>
          </a:p>
          <a:p>
            <a:endParaRPr lang="en-US" dirty="0"/>
          </a:p>
        </p:txBody>
      </p:sp>
      <p:sp>
        <p:nvSpPr>
          <p:cNvPr id="4" name="スライド番号プレースホルダー 3"/>
          <p:cNvSpPr>
            <a:spLocks noGrp="1"/>
          </p:cNvSpPr>
          <p:nvPr>
            <p:ph type="sldNum" sz="quarter" idx="5"/>
          </p:nvPr>
        </p:nvSpPr>
        <p:spPr/>
        <p:txBody>
          <a:bodyPr/>
          <a:lstStyle/>
          <a:p>
            <a:fld id="{7D5BC94F-85FF-4747-A360-38CB959BA2AF}" type="slidenum">
              <a:rPr lang="en-US" smtClean="0"/>
              <a:t>6</a:t>
            </a:fld>
            <a:endParaRPr lang="en-US"/>
          </a:p>
        </p:txBody>
      </p:sp>
    </p:spTree>
    <p:extLst>
      <p:ext uri="{BB962C8B-B14F-4D97-AF65-F5344CB8AC3E}">
        <p14:creationId xmlns:p14="http://schemas.microsoft.com/office/powerpoint/2010/main" val="35899850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6 | Monocyte adhesion and monocyte migration induced by exposure to LPS-conditioned medium.</a:t>
            </a:r>
          </a:p>
          <a:p>
            <a:r>
              <a:rPr lang="en-US" sz="1200" kern="1200" dirty="0">
                <a:solidFill>
                  <a:schemeClr val="tx1"/>
                </a:solidFill>
                <a:effectLst/>
                <a:latin typeface="+mn-lt"/>
                <a:ea typeface="+mn-ea"/>
                <a:cs typeface="+mn-cs"/>
              </a:rPr>
              <a:t>Representative fluorescence images of (A) monocytes adhered to HCAECs 2 hours after the addition of monocytes, and (B) monocytes migrated through HCAECs 48 hours after the addition of monocytes. White dashed line indicates the boundary between the top and middle lane. Scale bar = 100 </a:t>
            </a:r>
            <a:r>
              <a:rPr lang="en-US" sz="1200" kern="1200" dirty="0" err="1">
                <a:solidFill>
                  <a:schemeClr val="tx1"/>
                </a:solidFill>
                <a:effectLst/>
                <a:latin typeface="+mn-lt"/>
                <a:ea typeface="+mn-ea"/>
                <a:cs typeface="+mn-cs"/>
              </a:rPr>
              <a:t>μm</a:t>
            </a:r>
            <a:r>
              <a:rPr lang="en-US" sz="1200" kern="1200" dirty="0">
                <a:solidFill>
                  <a:schemeClr val="tx1"/>
                </a:solidFill>
                <a:effectLst/>
                <a:latin typeface="+mn-lt"/>
                <a:ea typeface="+mn-ea"/>
                <a:cs typeface="+mn-cs"/>
              </a:rPr>
              <a:t>. HCAEC, human coronary artery endothelial cell; LPS, lipopolysaccharide; DMSO, dimethyl sulfoxide.</a:t>
            </a:r>
          </a:p>
          <a:p>
            <a:endParaRPr lang="en-US" dirty="0"/>
          </a:p>
        </p:txBody>
      </p:sp>
      <p:sp>
        <p:nvSpPr>
          <p:cNvPr id="4" name="スライド番号プレースホルダー 3"/>
          <p:cNvSpPr>
            <a:spLocks noGrp="1"/>
          </p:cNvSpPr>
          <p:nvPr>
            <p:ph type="sldNum" sz="quarter" idx="5"/>
          </p:nvPr>
        </p:nvSpPr>
        <p:spPr/>
        <p:txBody>
          <a:bodyPr/>
          <a:lstStyle/>
          <a:p>
            <a:fld id="{7D5BC94F-85FF-4747-A360-38CB959BA2AF}" type="slidenum">
              <a:rPr lang="en-US" smtClean="0"/>
              <a:t>7</a:t>
            </a:fld>
            <a:endParaRPr lang="en-US"/>
          </a:p>
        </p:txBody>
      </p:sp>
    </p:spTree>
    <p:extLst>
      <p:ext uri="{BB962C8B-B14F-4D97-AF65-F5344CB8AC3E}">
        <p14:creationId xmlns:p14="http://schemas.microsoft.com/office/powerpoint/2010/main" val="172482494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5CE7B85-0EB3-4E68-F7B4-7D19728CCACA}"/>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CF4F40B2-922B-3F75-A7EA-0E9C0AB7EBD0}"/>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332C290E-B195-976A-DFE4-8B04BC28A788}"/>
              </a:ext>
            </a:extLst>
          </p:cNvPr>
          <p:cNvSpPr>
            <a:spLocks noGrp="1"/>
          </p:cNvSpPr>
          <p:nvPr>
            <p:ph type="body" idx="1"/>
          </p:nvPr>
        </p:nvSpPr>
        <p:spPr/>
        <p:txBody>
          <a:bodyPr/>
          <a:lstStyle/>
          <a:p>
            <a:r>
              <a:rPr lang="en-US" sz="1200" kern="1200" dirty="0">
                <a:solidFill>
                  <a:schemeClr val="tx1"/>
                </a:solidFill>
                <a:effectLst/>
                <a:latin typeface="+mn-lt"/>
                <a:ea typeface="+mn-ea"/>
                <a:cs typeface="+mn-cs"/>
              </a:rPr>
              <a:t>Supplementary Figure S7 | Monocyte adhesion and migration induced by exposure to 1R6F TPM- or DT3.0a ACM-conditioned medium.</a:t>
            </a:r>
          </a:p>
          <a:p>
            <a:r>
              <a:rPr lang="en-US" sz="1200" kern="1200" dirty="0">
                <a:solidFill>
                  <a:schemeClr val="tx1"/>
                </a:solidFill>
                <a:effectLst/>
                <a:latin typeface="+mn-lt"/>
                <a:ea typeface="+mn-ea"/>
                <a:cs typeface="+mn-cs"/>
              </a:rPr>
              <a:t>Representative fluorescence images of (A) monocytes adhered to HCAECs 2 hours after the addition of monocytes, and (B) monocytes migrated through HCAECs 48 hours after the addition of monocytes. White dashed line indicates the boundary between the top and middle lane. Scale bar = 100 </a:t>
            </a:r>
            <a:r>
              <a:rPr lang="en-US" sz="1200" kern="1200" dirty="0" err="1">
                <a:solidFill>
                  <a:schemeClr val="tx1"/>
                </a:solidFill>
                <a:effectLst/>
                <a:latin typeface="+mn-lt"/>
                <a:ea typeface="+mn-ea"/>
                <a:cs typeface="+mn-cs"/>
              </a:rPr>
              <a:t>μm</a:t>
            </a:r>
            <a:r>
              <a:rPr lang="en-US" sz="1200" kern="1200" dirty="0">
                <a:solidFill>
                  <a:schemeClr val="tx1"/>
                </a:solidFill>
                <a:effectLst/>
                <a:latin typeface="+mn-lt"/>
                <a:ea typeface="+mn-ea"/>
                <a:cs typeface="+mn-cs"/>
              </a:rPr>
              <a:t>. TPM, total particulate matter; ACM, aerosol collected mass; DT3.0a: Direct Heating Tobacco System Platform 3 Generation 0 version a; HCAEC, human coronary artery endothelial cell; DMSO, dimethyl sulfoxide.</a:t>
            </a:r>
          </a:p>
          <a:p>
            <a:endParaRPr lang="en-US" dirty="0"/>
          </a:p>
        </p:txBody>
      </p:sp>
      <p:sp>
        <p:nvSpPr>
          <p:cNvPr id="4" name="スライド番号プレースホルダー 3">
            <a:extLst>
              <a:ext uri="{FF2B5EF4-FFF2-40B4-BE49-F238E27FC236}">
                <a16:creationId xmlns:a16="http://schemas.microsoft.com/office/drawing/2014/main" id="{80381538-8FE0-01A5-EEB7-B282361102A3}"/>
              </a:ext>
            </a:extLst>
          </p:cNvPr>
          <p:cNvSpPr>
            <a:spLocks noGrp="1"/>
          </p:cNvSpPr>
          <p:nvPr>
            <p:ph type="sldNum" sz="quarter" idx="5"/>
          </p:nvPr>
        </p:nvSpPr>
        <p:spPr/>
        <p:txBody>
          <a:bodyPr/>
          <a:lstStyle/>
          <a:p>
            <a:fld id="{8556CB2B-08D9-4328-872B-F42897B56352}" type="slidenum">
              <a:rPr lang="en-US" smtClean="0"/>
              <a:t>8</a:t>
            </a:fld>
            <a:endParaRPr lang="en-US" dirty="0"/>
          </a:p>
        </p:txBody>
      </p:sp>
    </p:spTree>
    <p:extLst>
      <p:ext uri="{BB962C8B-B14F-4D97-AF65-F5344CB8AC3E}">
        <p14:creationId xmlns:p14="http://schemas.microsoft.com/office/powerpoint/2010/main" val="30466400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4071011A-03B0-4A69-8B1E-7D72C2D4C4EA}" type="datetimeFigureOut">
              <a:rPr lang="en-US" smtClean="0"/>
              <a:t>8/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29030505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71011A-03B0-4A69-8B1E-7D72C2D4C4EA}" type="datetimeFigureOut">
              <a:rPr lang="en-US" smtClean="0"/>
              <a:t>8/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18933410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71011A-03B0-4A69-8B1E-7D72C2D4C4EA}" type="datetimeFigureOut">
              <a:rPr lang="en-US" smtClean="0"/>
              <a:t>8/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4070419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071011A-03B0-4A69-8B1E-7D72C2D4C4EA}" type="datetimeFigureOut">
              <a:rPr lang="en-US" smtClean="0"/>
              <a:t>8/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7460722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4071011A-03B0-4A69-8B1E-7D72C2D4C4EA}" type="datetimeFigureOut">
              <a:rPr lang="en-US" smtClean="0"/>
              <a:t>8/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29990985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071011A-03B0-4A69-8B1E-7D72C2D4C4EA}" type="datetimeFigureOut">
              <a:rPr lang="en-US" smtClean="0"/>
              <a:t>8/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31847433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071011A-03B0-4A69-8B1E-7D72C2D4C4EA}" type="datetimeFigureOut">
              <a:rPr lang="en-US" smtClean="0"/>
              <a:t>8/2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24513567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4071011A-03B0-4A69-8B1E-7D72C2D4C4EA}" type="datetimeFigureOut">
              <a:rPr lang="en-US" smtClean="0"/>
              <a:t>8/2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14437369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71011A-03B0-4A69-8B1E-7D72C2D4C4EA}" type="datetimeFigureOut">
              <a:rPr lang="en-US" smtClean="0"/>
              <a:t>8/2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24030510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71011A-03B0-4A69-8B1E-7D72C2D4C4EA}" type="datetimeFigureOut">
              <a:rPr lang="en-US" smtClean="0"/>
              <a:t>8/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8698620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071011A-03B0-4A69-8B1E-7D72C2D4C4EA}" type="datetimeFigureOut">
              <a:rPr lang="en-US" smtClean="0"/>
              <a:t>8/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C2B034-B131-4D3D-A981-CF06D498F795}" type="slidenum">
              <a:rPr lang="en-US" smtClean="0"/>
              <a:t>‹#›</a:t>
            </a:fld>
            <a:endParaRPr lang="en-US"/>
          </a:p>
        </p:txBody>
      </p:sp>
    </p:spTree>
    <p:extLst>
      <p:ext uri="{BB962C8B-B14F-4D97-AF65-F5344CB8AC3E}">
        <p14:creationId xmlns:p14="http://schemas.microsoft.com/office/powerpoint/2010/main" val="31997687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4071011A-03B0-4A69-8B1E-7D72C2D4C4EA}" type="datetimeFigureOut">
              <a:rPr lang="en-US" smtClean="0"/>
              <a:t>8/25/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61C2B034-B131-4D3D-A981-CF06D498F795}" type="slidenum">
              <a:rPr lang="en-US" smtClean="0"/>
              <a:t>‹#›</a:t>
            </a:fld>
            <a:endParaRPr lang="en-US"/>
          </a:p>
        </p:txBody>
      </p:sp>
    </p:spTree>
    <p:extLst>
      <p:ext uri="{BB962C8B-B14F-4D97-AF65-F5344CB8AC3E}">
        <p14:creationId xmlns:p14="http://schemas.microsoft.com/office/powerpoint/2010/main" val="30914286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11.png"/><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14.png"/><Relationship Id="rId4"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00A6FD3A-9F03-B43B-4C8D-27E2ECBE3D21}"/>
              </a:ext>
            </a:extLst>
          </p:cNvPr>
          <p:cNvPicPr>
            <a:picLocks noChangeAspect="1"/>
          </p:cNvPicPr>
          <p:nvPr/>
        </p:nvPicPr>
        <p:blipFill rotWithShape="1">
          <a:blip r:embed="rId3">
            <a:extLst>
              <a:ext uri="{28A0092B-C50C-407E-A947-70E740481C1C}">
                <a14:useLocalDpi xmlns:a14="http://schemas.microsoft.com/office/drawing/2010/main" val="0"/>
              </a:ext>
            </a:extLst>
          </a:blip>
          <a:srcRect l="9817" t="5237" r="10107"/>
          <a:stretch>
            <a:fillRect/>
          </a:stretch>
        </p:blipFill>
        <p:spPr bwMode="auto">
          <a:xfrm>
            <a:off x="254000" y="1129801"/>
            <a:ext cx="6197600" cy="2009203"/>
          </a:xfrm>
          <a:prstGeom prst="rect">
            <a:avLst/>
          </a:prstGeom>
          <a:noFill/>
          <a:ln>
            <a:noFill/>
          </a:ln>
          <a:extLst>
            <a:ext uri="{53640926-AAD7-44D8-BBD7-CCE9431645EC}">
              <a14:shadowObscured xmlns:a14="http://schemas.microsoft.com/office/drawing/2010/main"/>
            </a:ext>
          </a:extLst>
        </p:spPr>
      </p:pic>
      <p:sp>
        <p:nvSpPr>
          <p:cNvPr id="3" name="テキスト ボックス 2">
            <a:extLst>
              <a:ext uri="{FF2B5EF4-FFF2-40B4-BE49-F238E27FC236}">
                <a16:creationId xmlns:a16="http://schemas.microsoft.com/office/drawing/2014/main" id="{7D6086AA-E371-1FE4-C9F9-A54DD8760962}"/>
              </a:ext>
            </a:extLst>
          </p:cNvPr>
          <p:cNvSpPr txBox="1"/>
          <p:nvPr/>
        </p:nvSpPr>
        <p:spPr>
          <a:xfrm>
            <a:off x="188177" y="661504"/>
            <a:ext cx="6481646"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Supplementary Table S1 </a:t>
            </a:r>
            <a:r>
              <a:rPr lang="en-US" dirty="0">
                <a:latin typeface="Times New Roman" panose="02020603050405020304" pitchFamily="18" charset="0"/>
                <a:cs typeface="Times New Roman" panose="02020603050405020304" pitchFamily="18" charset="0"/>
              </a:rPr>
              <a:t>An overview of TPM or ACM collection. </a:t>
            </a:r>
          </a:p>
        </p:txBody>
      </p:sp>
    </p:spTree>
    <p:extLst>
      <p:ext uri="{BB962C8B-B14F-4D97-AF65-F5344CB8AC3E}">
        <p14:creationId xmlns:p14="http://schemas.microsoft.com/office/powerpoint/2010/main" val="32261078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8" name="図 97">
            <a:extLst>
              <a:ext uri="{FF2B5EF4-FFF2-40B4-BE49-F238E27FC236}">
                <a16:creationId xmlns:a16="http://schemas.microsoft.com/office/drawing/2014/main" id="{4D659FA3-BDAA-0D39-8A10-97CFE990E7A6}"/>
              </a:ext>
            </a:extLst>
          </p:cNvPr>
          <p:cNvPicPr>
            <a:picLocks noChangeAspect="1"/>
          </p:cNvPicPr>
          <p:nvPr/>
        </p:nvPicPr>
        <p:blipFill>
          <a:blip r:embed="rId3"/>
          <a:stretch>
            <a:fillRect/>
          </a:stretch>
        </p:blipFill>
        <p:spPr>
          <a:xfrm>
            <a:off x="414267" y="3854724"/>
            <a:ext cx="6029467" cy="5383235"/>
          </a:xfrm>
          <a:prstGeom prst="rect">
            <a:avLst/>
          </a:prstGeom>
        </p:spPr>
      </p:pic>
      <p:pic>
        <p:nvPicPr>
          <p:cNvPr id="139" name="図 138">
            <a:extLst>
              <a:ext uri="{FF2B5EF4-FFF2-40B4-BE49-F238E27FC236}">
                <a16:creationId xmlns:a16="http://schemas.microsoft.com/office/drawing/2014/main" id="{083DDA6E-3D2C-71A3-4D0A-7E08F29CC401}"/>
              </a:ext>
            </a:extLst>
          </p:cNvPr>
          <p:cNvPicPr>
            <a:picLocks noChangeAspect="1"/>
          </p:cNvPicPr>
          <p:nvPr/>
        </p:nvPicPr>
        <p:blipFill>
          <a:blip r:embed="rId4"/>
          <a:stretch>
            <a:fillRect/>
          </a:stretch>
        </p:blipFill>
        <p:spPr>
          <a:xfrm>
            <a:off x="542819" y="506486"/>
            <a:ext cx="4785775" cy="2853175"/>
          </a:xfrm>
          <a:prstGeom prst="rect">
            <a:avLst/>
          </a:prstGeom>
        </p:spPr>
      </p:pic>
      <p:sp>
        <p:nvSpPr>
          <p:cNvPr id="140" name="テキスト ボックス 139">
            <a:extLst>
              <a:ext uri="{FF2B5EF4-FFF2-40B4-BE49-F238E27FC236}">
                <a16:creationId xmlns:a16="http://schemas.microsoft.com/office/drawing/2014/main" id="{47D81827-6F20-A02A-93C3-8B5C46333D71}"/>
              </a:ext>
            </a:extLst>
          </p:cNvPr>
          <p:cNvSpPr txBox="1"/>
          <p:nvPr/>
        </p:nvSpPr>
        <p:spPr>
          <a:xfrm>
            <a:off x="12825" y="3670057"/>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141" name="テキスト ボックス 140">
            <a:extLst>
              <a:ext uri="{FF2B5EF4-FFF2-40B4-BE49-F238E27FC236}">
                <a16:creationId xmlns:a16="http://schemas.microsoft.com/office/drawing/2014/main" id="{82B53CA1-F498-F86A-7112-17E5530D085F}"/>
              </a:ext>
            </a:extLst>
          </p:cNvPr>
          <p:cNvSpPr txBox="1"/>
          <p:nvPr/>
        </p:nvSpPr>
        <p:spPr>
          <a:xfrm>
            <a:off x="1" y="381000"/>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23056078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47404FE5-4437-4435-8782-6897F69B9C9A}"/>
              </a:ext>
            </a:extLst>
          </p:cNvPr>
          <p:cNvSpPr txBox="1"/>
          <p:nvPr/>
        </p:nvSpPr>
        <p:spPr>
          <a:xfrm>
            <a:off x="60768" y="4583668"/>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17" name="テキスト ボックス 16">
            <a:extLst>
              <a:ext uri="{FF2B5EF4-FFF2-40B4-BE49-F238E27FC236}">
                <a16:creationId xmlns:a16="http://schemas.microsoft.com/office/drawing/2014/main" id="{CED04BB0-3545-13C1-7931-B20C72E3C7FE}"/>
              </a:ext>
            </a:extLst>
          </p:cNvPr>
          <p:cNvSpPr txBox="1"/>
          <p:nvPr/>
        </p:nvSpPr>
        <p:spPr>
          <a:xfrm>
            <a:off x="1" y="381000"/>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pic>
        <p:nvPicPr>
          <p:cNvPr id="6" name="図 5">
            <a:extLst>
              <a:ext uri="{FF2B5EF4-FFF2-40B4-BE49-F238E27FC236}">
                <a16:creationId xmlns:a16="http://schemas.microsoft.com/office/drawing/2014/main" id="{207A7DBF-60BB-3763-AFCB-223D309A74C9}"/>
              </a:ext>
            </a:extLst>
          </p:cNvPr>
          <p:cNvPicPr>
            <a:picLocks noChangeAspect="1"/>
          </p:cNvPicPr>
          <p:nvPr/>
        </p:nvPicPr>
        <p:blipFill>
          <a:blip r:embed="rId3"/>
          <a:stretch>
            <a:fillRect/>
          </a:stretch>
        </p:blipFill>
        <p:spPr>
          <a:xfrm>
            <a:off x="505268" y="728267"/>
            <a:ext cx="3499407" cy="3511600"/>
          </a:xfrm>
          <a:prstGeom prst="rect">
            <a:avLst/>
          </a:prstGeom>
        </p:spPr>
      </p:pic>
      <p:pic>
        <p:nvPicPr>
          <p:cNvPr id="27" name="図 26">
            <a:extLst>
              <a:ext uri="{FF2B5EF4-FFF2-40B4-BE49-F238E27FC236}">
                <a16:creationId xmlns:a16="http://schemas.microsoft.com/office/drawing/2014/main" id="{5BE19124-CE45-F7ED-F6FF-D1438E0FD34E}"/>
              </a:ext>
            </a:extLst>
          </p:cNvPr>
          <p:cNvPicPr>
            <a:picLocks noChangeAspect="1"/>
          </p:cNvPicPr>
          <p:nvPr/>
        </p:nvPicPr>
        <p:blipFill>
          <a:blip r:embed="rId4"/>
          <a:stretch>
            <a:fillRect/>
          </a:stretch>
        </p:blipFill>
        <p:spPr>
          <a:xfrm>
            <a:off x="789153" y="4953000"/>
            <a:ext cx="3371380" cy="4121253"/>
          </a:xfrm>
          <a:prstGeom prst="rect">
            <a:avLst/>
          </a:prstGeom>
        </p:spPr>
      </p:pic>
    </p:spTree>
    <p:extLst>
      <p:ext uri="{BB962C8B-B14F-4D97-AF65-F5344CB8AC3E}">
        <p14:creationId xmlns:p14="http://schemas.microsoft.com/office/powerpoint/2010/main" val="40552720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A0B3BB32-D587-DC69-0838-FFC2DA1CAC05}"/>
              </a:ext>
            </a:extLst>
          </p:cNvPr>
          <p:cNvSpPr txBox="1"/>
          <p:nvPr/>
        </p:nvSpPr>
        <p:spPr>
          <a:xfrm>
            <a:off x="373083" y="3396137"/>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9" name="テキスト ボックス 8">
            <a:extLst>
              <a:ext uri="{FF2B5EF4-FFF2-40B4-BE49-F238E27FC236}">
                <a16:creationId xmlns:a16="http://schemas.microsoft.com/office/drawing/2014/main" id="{D4175C51-6ECF-F672-27E9-6445E03F33F7}"/>
              </a:ext>
            </a:extLst>
          </p:cNvPr>
          <p:cNvSpPr txBox="1"/>
          <p:nvPr/>
        </p:nvSpPr>
        <p:spPr>
          <a:xfrm>
            <a:off x="286076" y="0"/>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10" name="テキスト ボックス 9">
            <a:extLst>
              <a:ext uri="{FF2B5EF4-FFF2-40B4-BE49-F238E27FC236}">
                <a16:creationId xmlns:a16="http://schemas.microsoft.com/office/drawing/2014/main" id="{F2D468A6-F7D8-A7F4-4BC3-895C150BB0C9}"/>
              </a:ext>
            </a:extLst>
          </p:cNvPr>
          <p:cNvSpPr txBox="1"/>
          <p:nvPr/>
        </p:nvSpPr>
        <p:spPr>
          <a:xfrm>
            <a:off x="311911" y="6310068"/>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pic>
        <p:nvPicPr>
          <p:cNvPr id="30" name="図 29">
            <a:extLst>
              <a:ext uri="{FF2B5EF4-FFF2-40B4-BE49-F238E27FC236}">
                <a16:creationId xmlns:a16="http://schemas.microsoft.com/office/drawing/2014/main" id="{A4C44FFB-5258-AE7A-C550-F44EA5BAA0DE}"/>
              </a:ext>
            </a:extLst>
          </p:cNvPr>
          <p:cNvPicPr>
            <a:picLocks noChangeAspect="1"/>
          </p:cNvPicPr>
          <p:nvPr/>
        </p:nvPicPr>
        <p:blipFill>
          <a:blip r:embed="rId3"/>
          <a:stretch>
            <a:fillRect/>
          </a:stretch>
        </p:blipFill>
        <p:spPr>
          <a:xfrm>
            <a:off x="989987" y="168215"/>
            <a:ext cx="3865199" cy="3109229"/>
          </a:xfrm>
          <a:prstGeom prst="rect">
            <a:avLst/>
          </a:prstGeom>
        </p:spPr>
      </p:pic>
      <p:pic>
        <p:nvPicPr>
          <p:cNvPr id="44" name="図 43">
            <a:extLst>
              <a:ext uri="{FF2B5EF4-FFF2-40B4-BE49-F238E27FC236}">
                <a16:creationId xmlns:a16="http://schemas.microsoft.com/office/drawing/2014/main" id="{E0546C3B-788C-2C61-F52D-03CA6D87B4C2}"/>
              </a:ext>
            </a:extLst>
          </p:cNvPr>
          <p:cNvPicPr>
            <a:picLocks noChangeAspect="1"/>
          </p:cNvPicPr>
          <p:nvPr/>
        </p:nvPicPr>
        <p:blipFill>
          <a:blip r:embed="rId4"/>
          <a:stretch>
            <a:fillRect/>
          </a:stretch>
        </p:blipFill>
        <p:spPr>
          <a:xfrm>
            <a:off x="944262" y="3361806"/>
            <a:ext cx="3956647" cy="3182388"/>
          </a:xfrm>
          <a:prstGeom prst="rect">
            <a:avLst/>
          </a:prstGeom>
        </p:spPr>
      </p:pic>
      <p:pic>
        <p:nvPicPr>
          <p:cNvPr id="53" name="図 52">
            <a:extLst>
              <a:ext uri="{FF2B5EF4-FFF2-40B4-BE49-F238E27FC236}">
                <a16:creationId xmlns:a16="http://schemas.microsoft.com/office/drawing/2014/main" id="{75AE9F69-D628-8C99-C444-920D14336D3A}"/>
              </a:ext>
            </a:extLst>
          </p:cNvPr>
          <p:cNvPicPr>
            <a:picLocks noChangeAspect="1"/>
          </p:cNvPicPr>
          <p:nvPr/>
        </p:nvPicPr>
        <p:blipFill>
          <a:blip r:embed="rId5"/>
          <a:stretch>
            <a:fillRect/>
          </a:stretch>
        </p:blipFill>
        <p:spPr>
          <a:xfrm>
            <a:off x="989987" y="6821157"/>
            <a:ext cx="3956647" cy="3084843"/>
          </a:xfrm>
          <a:prstGeom prst="rect">
            <a:avLst/>
          </a:prstGeom>
        </p:spPr>
      </p:pic>
    </p:spTree>
    <p:extLst>
      <p:ext uri="{BB962C8B-B14F-4D97-AF65-F5344CB8AC3E}">
        <p14:creationId xmlns:p14="http://schemas.microsoft.com/office/powerpoint/2010/main" val="27771006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95A5EBB-D79F-C5E4-086D-EE88F4C2DF4A}"/>
              </a:ext>
            </a:extLst>
          </p:cNvPr>
          <p:cNvPicPr>
            <a:picLocks noChangeAspect="1"/>
          </p:cNvPicPr>
          <p:nvPr/>
        </p:nvPicPr>
        <p:blipFill>
          <a:blip r:embed="rId3"/>
          <a:stretch>
            <a:fillRect/>
          </a:stretch>
        </p:blipFill>
        <p:spPr>
          <a:xfrm>
            <a:off x="0" y="1168400"/>
            <a:ext cx="3323772" cy="3323772"/>
          </a:xfrm>
          <a:prstGeom prst="rect">
            <a:avLst/>
          </a:prstGeom>
        </p:spPr>
      </p:pic>
      <p:pic>
        <p:nvPicPr>
          <p:cNvPr id="5" name="図 4">
            <a:extLst>
              <a:ext uri="{FF2B5EF4-FFF2-40B4-BE49-F238E27FC236}">
                <a16:creationId xmlns:a16="http://schemas.microsoft.com/office/drawing/2014/main" id="{09F4AD35-507B-4D18-E78D-51AFD588D979}"/>
              </a:ext>
            </a:extLst>
          </p:cNvPr>
          <p:cNvPicPr>
            <a:picLocks noChangeAspect="1"/>
          </p:cNvPicPr>
          <p:nvPr/>
        </p:nvPicPr>
        <p:blipFill>
          <a:blip r:embed="rId4"/>
          <a:stretch>
            <a:fillRect/>
          </a:stretch>
        </p:blipFill>
        <p:spPr>
          <a:xfrm>
            <a:off x="3288006" y="1168400"/>
            <a:ext cx="3323772" cy="3323772"/>
          </a:xfrm>
          <a:prstGeom prst="rect">
            <a:avLst/>
          </a:prstGeom>
        </p:spPr>
      </p:pic>
      <p:sp>
        <p:nvSpPr>
          <p:cNvPr id="10" name="テキスト ボックス 9">
            <a:extLst>
              <a:ext uri="{FF2B5EF4-FFF2-40B4-BE49-F238E27FC236}">
                <a16:creationId xmlns:a16="http://schemas.microsoft.com/office/drawing/2014/main" id="{3B3717BA-D34E-EF69-31CD-2F2AD13FD2D9}"/>
              </a:ext>
            </a:extLst>
          </p:cNvPr>
          <p:cNvSpPr txBox="1"/>
          <p:nvPr/>
        </p:nvSpPr>
        <p:spPr>
          <a:xfrm>
            <a:off x="3323772" y="265279"/>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11" name="テキスト ボックス 10">
            <a:extLst>
              <a:ext uri="{FF2B5EF4-FFF2-40B4-BE49-F238E27FC236}">
                <a16:creationId xmlns:a16="http://schemas.microsoft.com/office/drawing/2014/main" id="{B7E4552F-BBDB-6468-ACB2-605B36997CA4}"/>
              </a:ext>
            </a:extLst>
          </p:cNvPr>
          <p:cNvSpPr txBox="1"/>
          <p:nvPr/>
        </p:nvSpPr>
        <p:spPr>
          <a:xfrm>
            <a:off x="-25835" y="255175"/>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12" name="テキスト ボックス 11">
            <a:extLst>
              <a:ext uri="{FF2B5EF4-FFF2-40B4-BE49-F238E27FC236}">
                <a16:creationId xmlns:a16="http://schemas.microsoft.com/office/drawing/2014/main" id="{C9A9496A-890A-E602-D1F0-77BBD2014E6B}"/>
              </a:ext>
            </a:extLst>
          </p:cNvPr>
          <p:cNvSpPr txBox="1"/>
          <p:nvPr/>
        </p:nvSpPr>
        <p:spPr>
          <a:xfrm>
            <a:off x="-25835" y="4666733"/>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pic>
        <p:nvPicPr>
          <p:cNvPr id="13" name="図 12">
            <a:extLst>
              <a:ext uri="{FF2B5EF4-FFF2-40B4-BE49-F238E27FC236}">
                <a16:creationId xmlns:a16="http://schemas.microsoft.com/office/drawing/2014/main" id="{B1B43D1E-B00A-2BFB-24B4-8EB429D19101}"/>
              </a:ext>
            </a:extLst>
          </p:cNvPr>
          <p:cNvPicPr>
            <a:picLocks noChangeAspect="1"/>
          </p:cNvPicPr>
          <p:nvPr/>
        </p:nvPicPr>
        <p:blipFill>
          <a:blip r:embed="rId5"/>
          <a:stretch>
            <a:fillRect/>
          </a:stretch>
        </p:blipFill>
        <p:spPr>
          <a:xfrm>
            <a:off x="50070" y="5597574"/>
            <a:ext cx="3322608" cy="3322608"/>
          </a:xfrm>
          <a:prstGeom prst="rect">
            <a:avLst/>
          </a:prstGeom>
        </p:spPr>
      </p:pic>
    </p:spTree>
    <p:extLst>
      <p:ext uri="{BB962C8B-B14F-4D97-AF65-F5344CB8AC3E}">
        <p14:creationId xmlns:p14="http://schemas.microsoft.com/office/powerpoint/2010/main" val="32639444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5243D70B-5192-01BF-87C3-D87F0FDFA0D1}"/>
              </a:ext>
            </a:extLst>
          </p:cNvPr>
          <p:cNvPicPr>
            <a:picLocks noChangeAspect="1"/>
          </p:cNvPicPr>
          <p:nvPr/>
        </p:nvPicPr>
        <p:blipFill>
          <a:blip r:embed="rId3"/>
          <a:stretch>
            <a:fillRect/>
          </a:stretch>
        </p:blipFill>
        <p:spPr>
          <a:xfrm>
            <a:off x="3487057" y="1190170"/>
            <a:ext cx="3269343" cy="4086678"/>
          </a:xfrm>
          <a:prstGeom prst="rect">
            <a:avLst/>
          </a:prstGeom>
        </p:spPr>
      </p:pic>
      <p:pic>
        <p:nvPicPr>
          <p:cNvPr id="7" name="図 6">
            <a:extLst>
              <a:ext uri="{FF2B5EF4-FFF2-40B4-BE49-F238E27FC236}">
                <a16:creationId xmlns:a16="http://schemas.microsoft.com/office/drawing/2014/main" id="{2765A21C-D493-A377-AE31-DCE7F4D2571B}"/>
              </a:ext>
            </a:extLst>
          </p:cNvPr>
          <p:cNvPicPr>
            <a:picLocks noChangeAspect="1"/>
          </p:cNvPicPr>
          <p:nvPr/>
        </p:nvPicPr>
        <p:blipFill>
          <a:blip r:embed="rId4"/>
          <a:stretch>
            <a:fillRect/>
          </a:stretch>
        </p:blipFill>
        <p:spPr>
          <a:xfrm>
            <a:off x="0" y="5819320"/>
            <a:ext cx="3269344" cy="4086680"/>
          </a:xfrm>
          <a:prstGeom prst="rect">
            <a:avLst/>
          </a:prstGeom>
        </p:spPr>
      </p:pic>
      <p:sp>
        <p:nvSpPr>
          <p:cNvPr id="8" name="テキスト ボックス 7">
            <a:extLst>
              <a:ext uri="{FF2B5EF4-FFF2-40B4-BE49-F238E27FC236}">
                <a16:creationId xmlns:a16="http://schemas.microsoft.com/office/drawing/2014/main" id="{65BCA6E9-AB37-451A-3678-08A9B321DCA4}"/>
              </a:ext>
            </a:extLst>
          </p:cNvPr>
          <p:cNvSpPr txBox="1"/>
          <p:nvPr/>
        </p:nvSpPr>
        <p:spPr>
          <a:xfrm>
            <a:off x="3370943" y="255175"/>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9" name="テキスト ボックス 8">
            <a:extLst>
              <a:ext uri="{FF2B5EF4-FFF2-40B4-BE49-F238E27FC236}">
                <a16:creationId xmlns:a16="http://schemas.microsoft.com/office/drawing/2014/main" id="{1DD47988-2807-0FE3-3C72-D05FB8674CBA}"/>
              </a:ext>
            </a:extLst>
          </p:cNvPr>
          <p:cNvSpPr txBox="1"/>
          <p:nvPr/>
        </p:nvSpPr>
        <p:spPr>
          <a:xfrm>
            <a:off x="-25835" y="255175"/>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10" name="テキスト ボックス 9">
            <a:extLst>
              <a:ext uri="{FF2B5EF4-FFF2-40B4-BE49-F238E27FC236}">
                <a16:creationId xmlns:a16="http://schemas.microsoft.com/office/drawing/2014/main" id="{3D93F1B5-9D8F-894E-677F-C98D40A23B6B}"/>
              </a:ext>
            </a:extLst>
          </p:cNvPr>
          <p:cNvSpPr txBox="1"/>
          <p:nvPr/>
        </p:nvSpPr>
        <p:spPr>
          <a:xfrm>
            <a:off x="0" y="5276848"/>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pic>
        <p:nvPicPr>
          <p:cNvPr id="13" name="図 12">
            <a:extLst>
              <a:ext uri="{FF2B5EF4-FFF2-40B4-BE49-F238E27FC236}">
                <a16:creationId xmlns:a16="http://schemas.microsoft.com/office/drawing/2014/main" id="{4A10FC01-7598-B481-7858-B5DD516C5EF6}"/>
              </a:ext>
            </a:extLst>
          </p:cNvPr>
          <p:cNvPicPr>
            <a:picLocks noChangeAspect="1"/>
          </p:cNvPicPr>
          <p:nvPr/>
        </p:nvPicPr>
        <p:blipFill>
          <a:blip r:embed="rId5"/>
          <a:stretch>
            <a:fillRect/>
          </a:stretch>
        </p:blipFill>
        <p:spPr>
          <a:xfrm>
            <a:off x="88751" y="1186077"/>
            <a:ext cx="3267739" cy="4090771"/>
          </a:xfrm>
          <a:prstGeom prst="rect">
            <a:avLst/>
          </a:prstGeom>
        </p:spPr>
      </p:pic>
    </p:spTree>
    <p:extLst>
      <p:ext uri="{BB962C8B-B14F-4D97-AF65-F5344CB8AC3E}">
        <p14:creationId xmlns:p14="http://schemas.microsoft.com/office/powerpoint/2010/main" val="26978233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5ADCA62F-3B56-440E-B621-143CB2945D74}"/>
              </a:ext>
            </a:extLst>
          </p:cNvPr>
          <p:cNvSpPr txBox="1"/>
          <p:nvPr/>
        </p:nvSpPr>
        <p:spPr>
          <a:xfrm>
            <a:off x="242321" y="3803494"/>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5" name="テキスト ボックス 4">
            <a:extLst>
              <a:ext uri="{FF2B5EF4-FFF2-40B4-BE49-F238E27FC236}">
                <a16:creationId xmlns:a16="http://schemas.microsoft.com/office/drawing/2014/main" id="{A2876FB1-A988-22D9-6EF7-5EFFD5AA07F7}"/>
              </a:ext>
            </a:extLst>
          </p:cNvPr>
          <p:cNvSpPr txBox="1"/>
          <p:nvPr/>
        </p:nvSpPr>
        <p:spPr>
          <a:xfrm>
            <a:off x="243720" y="192505"/>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pic>
        <p:nvPicPr>
          <p:cNvPr id="27" name="図 26">
            <a:extLst>
              <a:ext uri="{FF2B5EF4-FFF2-40B4-BE49-F238E27FC236}">
                <a16:creationId xmlns:a16="http://schemas.microsoft.com/office/drawing/2014/main" id="{0A62CFA1-DE4A-68EA-F69B-B2729E455B60}"/>
              </a:ext>
            </a:extLst>
          </p:cNvPr>
          <p:cNvPicPr>
            <a:picLocks noChangeAspect="1"/>
          </p:cNvPicPr>
          <p:nvPr/>
        </p:nvPicPr>
        <p:blipFill>
          <a:blip r:embed="rId3"/>
          <a:stretch>
            <a:fillRect/>
          </a:stretch>
        </p:blipFill>
        <p:spPr>
          <a:xfrm>
            <a:off x="582351" y="1002470"/>
            <a:ext cx="4304149" cy="2432515"/>
          </a:xfrm>
          <a:prstGeom prst="rect">
            <a:avLst/>
          </a:prstGeom>
        </p:spPr>
      </p:pic>
      <p:pic>
        <p:nvPicPr>
          <p:cNvPr id="37" name="図 36">
            <a:extLst>
              <a:ext uri="{FF2B5EF4-FFF2-40B4-BE49-F238E27FC236}">
                <a16:creationId xmlns:a16="http://schemas.microsoft.com/office/drawing/2014/main" id="{802E69F3-CE67-3807-762A-0B8C2A262AF8}"/>
              </a:ext>
            </a:extLst>
          </p:cNvPr>
          <p:cNvPicPr>
            <a:picLocks noChangeAspect="1"/>
          </p:cNvPicPr>
          <p:nvPr/>
        </p:nvPicPr>
        <p:blipFill>
          <a:blip r:embed="rId4"/>
          <a:stretch>
            <a:fillRect/>
          </a:stretch>
        </p:blipFill>
        <p:spPr>
          <a:xfrm>
            <a:off x="539675" y="4541335"/>
            <a:ext cx="4346825" cy="2389839"/>
          </a:xfrm>
          <a:prstGeom prst="rect">
            <a:avLst/>
          </a:prstGeom>
        </p:spPr>
      </p:pic>
    </p:spTree>
    <p:extLst>
      <p:ext uri="{BB962C8B-B14F-4D97-AF65-F5344CB8AC3E}">
        <p14:creationId xmlns:p14="http://schemas.microsoft.com/office/powerpoint/2010/main" val="34845937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68F1A93-3EF0-CB74-796C-642DE31DD097}"/>
            </a:ext>
          </a:extLst>
        </p:cNvPr>
        <p:cNvGrpSpPr/>
        <p:nvPr/>
      </p:nvGrpSpPr>
      <p:grpSpPr>
        <a:xfrm>
          <a:off x="0" y="0"/>
          <a:ext cx="0" cy="0"/>
          <a:chOff x="0" y="0"/>
          <a:chExt cx="0" cy="0"/>
        </a:xfrm>
      </p:grpSpPr>
      <p:sp>
        <p:nvSpPr>
          <p:cNvPr id="31" name="テキスト ボックス 30">
            <a:extLst>
              <a:ext uri="{FF2B5EF4-FFF2-40B4-BE49-F238E27FC236}">
                <a16:creationId xmlns:a16="http://schemas.microsoft.com/office/drawing/2014/main" id="{763359D6-16AF-7C21-0AD7-D7EC807D70CD}"/>
              </a:ext>
            </a:extLst>
          </p:cNvPr>
          <p:cNvSpPr txBox="1"/>
          <p:nvPr/>
        </p:nvSpPr>
        <p:spPr>
          <a:xfrm>
            <a:off x="427223" y="4633459"/>
            <a:ext cx="492443"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32" name="テキスト ボックス 31">
            <a:extLst>
              <a:ext uri="{FF2B5EF4-FFF2-40B4-BE49-F238E27FC236}">
                <a16:creationId xmlns:a16="http://schemas.microsoft.com/office/drawing/2014/main" id="{D149AC5B-FDAF-87B5-BB1E-F91D9238686F}"/>
              </a:ext>
            </a:extLst>
          </p:cNvPr>
          <p:cNvSpPr txBox="1"/>
          <p:nvPr/>
        </p:nvSpPr>
        <p:spPr>
          <a:xfrm>
            <a:off x="427223" y="573505"/>
            <a:ext cx="50526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pic>
        <p:nvPicPr>
          <p:cNvPr id="11" name="図 10">
            <a:extLst>
              <a:ext uri="{FF2B5EF4-FFF2-40B4-BE49-F238E27FC236}">
                <a16:creationId xmlns:a16="http://schemas.microsoft.com/office/drawing/2014/main" id="{201DBED5-7166-0AC5-2062-17D158827DDB}"/>
              </a:ext>
            </a:extLst>
          </p:cNvPr>
          <p:cNvPicPr>
            <a:picLocks noChangeAspect="1"/>
          </p:cNvPicPr>
          <p:nvPr/>
        </p:nvPicPr>
        <p:blipFill>
          <a:blip r:embed="rId3"/>
          <a:srcRect l="41972" t="9510"/>
          <a:stretch>
            <a:fillRect/>
          </a:stretch>
        </p:blipFill>
        <p:spPr>
          <a:xfrm>
            <a:off x="2501900" y="1558301"/>
            <a:ext cx="2444547" cy="2979046"/>
          </a:xfrm>
          <a:prstGeom prst="rect">
            <a:avLst/>
          </a:prstGeom>
        </p:spPr>
      </p:pic>
      <p:pic>
        <p:nvPicPr>
          <p:cNvPr id="18" name="図 17">
            <a:extLst>
              <a:ext uri="{FF2B5EF4-FFF2-40B4-BE49-F238E27FC236}">
                <a16:creationId xmlns:a16="http://schemas.microsoft.com/office/drawing/2014/main" id="{F6FC8C82-9E62-5DFA-82C3-5DA526E57AC2}"/>
              </a:ext>
            </a:extLst>
          </p:cNvPr>
          <p:cNvPicPr>
            <a:picLocks noChangeAspect="1"/>
          </p:cNvPicPr>
          <p:nvPr/>
        </p:nvPicPr>
        <p:blipFill>
          <a:blip r:embed="rId4"/>
          <a:srcRect l="42941" t="8834"/>
          <a:stretch>
            <a:fillRect/>
          </a:stretch>
        </p:blipFill>
        <p:spPr>
          <a:xfrm>
            <a:off x="2501899" y="5714368"/>
            <a:ext cx="2421139" cy="2979046"/>
          </a:xfrm>
          <a:prstGeom prst="rect">
            <a:avLst/>
          </a:prstGeom>
        </p:spPr>
      </p:pic>
      <p:sp>
        <p:nvSpPr>
          <p:cNvPr id="13" name="テキスト ボックス 12">
            <a:extLst>
              <a:ext uri="{FF2B5EF4-FFF2-40B4-BE49-F238E27FC236}">
                <a16:creationId xmlns:a16="http://schemas.microsoft.com/office/drawing/2014/main" id="{AB19B139-68B7-0062-7612-4D7541108EB3}"/>
              </a:ext>
            </a:extLst>
          </p:cNvPr>
          <p:cNvSpPr txBox="1"/>
          <p:nvPr/>
        </p:nvSpPr>
        <p:spPr>
          <a:xfrm>
            <a:off x="674955" y="1808653"/>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1% DMSO-</a:t>
            </a:r>
          </a:p>
          <a:p>
            <a:pPr algn="ctr"/>
            <a:r>
              <a:rPr lang="en-US" sz="1400" u="sng" dirty="0">
                <a:latin typeface="Times New Roman" panose="02020603050405020304" pitchFamily="18" charset="0"/>
                <a:cs typeface="Times New Roman" panose="02020603050405020304" pitchFamily="18" charset="0"/>
              </a:rPr>
              <a:t>conditioned medium</a:t>
            </a:r>
          </a:p>
        </p:txBody>
      </p:sp>
      <p:sp>
        <p:nvSpPr>
          <p:cNvPr id="14" name="テキスト ボックス 13">
            <a:extLst>
              <a:ext uri="{FF2B5EF4-FFF2-40B4-BE49-F238E27FC236}">
                <a16:creationId xmlns:a16="http://schemas.microsoft.com/office/drawing/2014/main" id="{D6981E5A-5760-EBBF-C8A1-B4E9070BF6D9}"/>
              </a:ext>
            </a:extLst>
          </p:cNvPr>
          <p:cNvSpPr txBox="1"/>
          <p:nvPr/>
        </p:nvSpPr>
        <p:spPr>
          <a:xfrm>
            <a:off x="674955" y="2780937"/>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1R6F TPM-</a:t>
            </a:r>
          </a:p>
          <a:p>
            <a:pPr algn="ctr"/>
            <a:r>
              <a:rPr lang="en-US" sz="1400" u="sng" dirty="0">
                <a:latin typeface="Times New Roman" panose="02020603050405020304" pitchFamily="18" charset="0"/>
                <a:cs typeface="Times New Roman" panose="02020603050405020304" pitchFamily="18" charset="0"/>
              </a:rPr>
              <a:t>conditioned medium</a:t>
            </a:r>
          </a:p>
        </p:txBody>
      </p:sp>
      <p:sp>
        <p:nvSpPr>
          <p:cNvPr id="15" name="テキスト ボックス 14">
            <a:extLst>
              <a:ext uri="{FF2B5EF4-FFF2-40B4-BE49-F238E27FC236}">
                <a16:creationId xmlns:a16="http://schemas.microsoft.com/office/drawing/2014/main" id="{071AAB12-D032-5B76-B5FE-2092E0E04E6B}"/>
              </a:ext>
            </a:extLst>
          </p:cNvPr>
          <p:cNvSpPr txBox="1"/>
          <p:nvPr/>
        </p:nvSpPr>
        <p:spPr>
          <a:xfrm>
            <a:off x="742136" y="5920204"/>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1% DMSO-</a:t>
            </a:r>
          </a:p>
          <a:p>
            <a:pPr algn="ctr"/>
            <a:r>
              <a:rPr lang="en-US" sz="1400" u="sng" dirty="0">
                <a:latin typeface="Times New Roman" panose="02020603050405020304" pitchFamily="18" charset="0"/>
                <a:cs typeface="Times New Roman" panose="02020603050405020304" pitchFamily="18" charset="0"/>
              </a:rPr>
              <a:t>conditioned medium</a:t>
            </a:r>
          </a:p>
        </p:txBody>
      </p:sp>
      <p:pic>
        <p:nvPicPr>
          <p:cNvPr id="17" name="図 16">
            <a:extLst>
              <a:ext uri="{FF2B5EF4-FFF2-40B4-BE49-F238E27FC236}">
                <a16:creationId xmlns:a16="http://schemas.microsoft.com/office/drawing/2014/main" id="{FC86DC75-9D60-87CF-828E-552997E55B84}"/>
              </a:ext>
            </a:extLst>
          </p:cNvPr>
          <p:cNvPicPr>
            <a:picLocks noChangeAspect="1"/>
          </p:cNvPicPr>
          <p:nvPr/>
        </p:nvPicPr>
        <p:blipFill>
          <a:blip r:embed="rId5"/>
          <a:srcRect b="83220"/>
          <a:stretch>
            <a:fillRect/>
          </a:stretch>
        </p:blipFill>
        <p:spPr>
          <a:xfrm>
            <a:off x="513855" y="1171144"/>
            <a:ext cx="4170025" cy="409202"/>
          </a:xfrm>
          <a:prstGeom prst="rect">
            <a:avLst/>
          </a:prstGeom>
        </p:spPr>
      </p:pic>
      <p:sp>
        <p:nvSpPr>
          <p:cNvPr id="19" name="テキスト ボックス 18">
            <a:extLst>
              <a:ext uri="{FF2B5EF4-FFF2-40B4-BE49-F238E27FC236}">
                <a16:creationId xmlns:a16="http://schemas.microsoft.com/office/drawing/2014/main" id="{02B89F3B-0C47-907D-9832-CC10FB8AEA94}"/>
              </a:ext>
            </a:extLst>
          </p:cNvPr>
          <p:cNvSpPr txBox="1"/>
          <p:nvPr/>
        </p:nvSpPr>
        <p:spPr>
          <a:xfrm>
            <a:off x="674955" y="3771929"/>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DT3.0a ACM-</a:t>
            </a:r>
          </a:p>
          <a:p>
            <a:pPr algn="ctr"/>
            <a:r>
              <a:rPr lang="en-US" sz="1400" u="sng" dirty="0">
                <a:latin typeface="Times New Roman" panose="02020603050405020304" pitchFamily="18" charset="0"/>
                <a:cs typeface="Times New Roman" panose="02020603050405020304" pitchFamily="18" charset="0"/>
              </a:rPr>
              <a:t>conditioned medium</a:t>
            </a:r>
          </a:p>
        </p:txBody>
      </p:sp>
      <p:sp>
        <p:nvSpPr>
          <p:cNvPr id="20" name="テキスト ボックス 19">
            <a:extLst>
              <a:ext uri="{FF2B5EF4-FFF2-40B4-BE49-F238E27FC236}">
                <a16:creationId xmlns:a16="http://schemas.microsoft.com/office/drawing/2014/main" id="{0DC4B7BF-F856-264E-A658-A4C2BD8B7B07}"/>
              </a:ext>
            </a:extLst>
          </p:cNvPr>
          <p:cNvSpPr txBox="1"/>
          <p:nvPr/>
        </p:nvSpPr>
        <p:spPr>
          <a:xfrm>
            <a:off x="742136" y="6944283"/>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1R6F TPM-</a:t>
            </a:r>
          </a:p>
          <a:p>
            <a:pPr algn="ctr"/>
            <a:r>
              <a:rPr lang="en-US" sz="1400" u="sng" dirty="0">
                <a:latin typeface="Times New Roman" panose="02020603050405020304" pitchFamily="18" charset="0"/>
                <a:cs typeface="Times New Roman" panose="02020603050405020304" pitchFamily="18" charset="0"/>
              </a:rPr>
              <a:t>conditioned medium</a:t>
            </a:r>
          </a:p>
        </p:txBody>
      </p:sp>
      <p:sp>
        <p:nvSpPr>
          <p:cNvPr id="21" name="テキスト ボックス 20">
            <a:extLst>
              <a:ext uri="{FF2B5EF4-FFF2-40B4-BE49-F238E27FC236}">
                <a16:creationId xmlns:a16="http://schemas.microsoft.com/office/drawing/2014/main" id="{E0AA0534-A4E0-5631-F8CD-26223CECDBE9}"/>
              </a:ext>
            </a:extLst>
          </p:cNvPr>
          <p:cNvSpPr txBox="1"/>
          <p:nvPr/>
        </p:nvSpPr>
        <p:spPr>
          <a:xfrm>
            <a:off x="742136" y="7873710"/>
            <a:ext cx="1665841" cy="523220"/>
          </a:xfrm>
          <a:prstGeom prst="rect">
            <a:avLst/>
          </a:prstGeom>
          <a:noFill/>
        </p:spPr>
        <p:txBody>
          <a:bodyPr wrap="none" rtlCol="0">
            <a:spAutoFit/>
          </a:bodyPr>
          <a:lstStyle/>
          <a:p>
            <a:pPr algn="ctr"/>
            <a:r>
              <a:rPr lang="en-US" sz="1400" u="sng" dirty="0">
                <a:latin typeface="Times New Roman" panose="02020603050405020304" pitchFamily="18" charset="0"/>
                <a:cs typeface="Times New Roman" panose="02020603050405020304" pitchFamily="18" charset="0"/>
              </a:rPr>
              <a:t>DT3.0a ACM-</a:t>
            </a:r>
          </a:p>
          <a:p>
            <a:pPr algn="ctr"/>
            <a:r>
              <a:rPr lang="en-US" sz="1400" u="sng" dirty="0">
                <a:latin typeface="Times New Roman" panose="02020603050405020304" pitchFamily="18" charset="0"/>
                <a:cs typeface="Times New Roman" panose="02020603050405020304" pitchFamily="18" charset="0"/>
              </a:rPr>
              <a:t>conditioned medium</a:t>
            </a:r>
          </a:p>
        </p:txBody>
      </p:sp>
      <p:pic>
        <p:nvPicPr>
          <p:cNvPr id="22" name="図 21">
            <a:extLst>
              <a:ext uri="{FF2B5EF4-FFF2-40B4-BE49-F238E27FC236}">
                <a16:creationId xmlns:a16="http://schemas.microsoft.com/office/drawing/2014/main" id="{E996CF46-709A-E015-F356-E09C738FB27D}"/>
              </a:ext>
            </a:extLst>
          </p:cNvPr>
          <p:cNvPicPr>
            <a:picLocks noChangeAspect="1"/>
          </p:cNvPicPr>
          <p:nvPr/>
        </p:nvPicPr>
        <p:blipFill>
          <a:blip r:embed="rId5"/>
          <a:srcRect b="83220"/>
          <a:stretch>
            <a:fillRect/>
          </a:stretch>
        </p:blipFill>
        <p:spPr>
          <a:xfrm>
            <a:off x="513855" y="5415115"/>
            <a:ext cx="4170025" cy="409202"/>
          </a:xfrm>
          <a:prstGeom prst="rect">
            <a:avLst/>
          </a:prstGeom>
        </p:spPr>
      </p:pic>
      <p:sp>
        <p:nvSpPr>
          <p:cNvPr id="23" name="テキスト ボックス 22">
            <a:extLst>
              <a:ext uri="{FF2B5EF4-FFF2-40B4-BE49-F238E27FC236}">
                <a16:creationId xmlns:a16="http://schemas.microsoft.com/office/drawing/2014/main" id="{7116F165-9BD8-9443-63F0-32663A1AB97C}"/>
              </a:ext>
            </a:extLst>
          </p:cNvPr>
          <p:cNvSpPr txBox="1"/>
          <p:nvPr/>
        </p:nvSpPr>
        <p:spPr>
          <a:xfrm>
            <a:off x="2580754" y="2260639"/>
            <a:ext cx="1657826"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Adhered monocytes: 87</a:t>
            </a:r>
          </a:p>
        </p:txBody>
      </p:sp>
      <p:sp>
        <p:nvSpPr>
          <p:cNvPr id="24" name="テキスト ボックス 23">
            <a:extLst>
              <a:ext uri="{FF2B5EF4-FFF2-40B4-BE49-F238E27FC236}">
                <a16:creationId xmlns:a16="http://schemas.microsoft.com/office/drawing/2014/main" id="{6A1CE780-9327-0A6C-F8DF-0169629E7F9D}"/>
              </a:ext>
            </a:extLst>
          </p:cNvPr>
          <p:cNvSpPr txBox="1"/>
          <p:nvPr/>
        </p:nvSpPr>
        <p:spPr>
          <a:xfrm>
            <a:off x="2561615" y="3260493"/>
            <a:ext cx="1734770"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Adhered monocytes: 122</a:t>
            </a:r>
          </a:p>
        </p:txBody>
      </p:sp>
      <p:sp>
        <p:nvSpPr>
          <p:cNvPr id="25" name="テキスト ボックス 24">
            <a:extLst>
              <a:ext uri="{FF2B5EF4-FFF2-40B4-BE49-F238E27FC236}">
                <a16:creationId xmlns:a16="http://schemas.microsoft.com/office/drawing/2014/main" id="{2A5EAC31-5674-D85D-0119-457C36BC7EAD}"/>
              </a:ext>
            </a:extLst>
          </p:cNvPr>
          <p:cNvSpPr txBox="1"/>
          <p:nvPr/>
        </p:nvSpPr>
        <p:spPr>
          <a:xfrm>
            <a:off x="2561615" y="4260347"/>
            <a:ext cx="1657826"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Adhered monocytes: 72</a:t>
            </a:r>
          </a:p>
        </p:txBody>
      </p:sp>
      <p:sp>
        <p:nvSpPr>
          <p:cNvPr id="26" name="テキスト ボックス 25">
            <a:extLst>
              <a:ext uri="{FF2B5EF4-FFF2-40B4-BE49-F238E27FC236}">
                <a16:creationId xmlns:a16="http://schemas.microsoft.com/office/drawing/2014/main" id="{BE54283E-8525-BFBB-7EDA-7CABB5EBF6BD}"/>
              </a:ext>
            </a:extLst>
          </p:cNvPr>
          <p:cNvSpPr txBox="1"/>
          <p:nvPr/>
        </p:nvSpPr>
        <p:spPr>
          <a:xfrm>
            <a:off x="2580754" y="5797067"/>
            <a:ext cx="1616148"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Migrated monocytes: 8</a:t>
            </a:r>
          </a:p>
        </p:txBody>
      </p:sp>
      <p:sp>
        <p:nvSpPr>
          <p:cNvPr id="27" name="テキスト ボックス 26">
            <a:extLst>
              <a:ext uri="{FF2B5EF4-FFF2-40B4-BE49-F238E27FC236}">
                <a16:creationId xmlns:a16="http://schemas.microsoft.com/office/drawing/2014/main" id="{8BECB7C2-396D-85F4-215B-94914178E85D}"/>
              </a:ext>
            </a:extLst>
          </p:cNvPr>
          <p:cNvSpPr txBox="1"/>
          <p:nvPr/>
        </p:nvSpPr>
        <p:spPr>
          <a:xfrm>
            <a:off x="2561615" y="6796921"/>
            <a:ext cx="1693092"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Migrated monocytes: 27</a:t>
            </a:r>
          </a:p>
        </p:txBody>
      </p:sp>
      <p:sp>
        <p:nvSpPr>
          <p:cNvPr id="28" name="テキスト ボックス 27">
            <a:extLst>
              <a:ext uri="{FF2B5EF4-FFF2-40B4-BE49-F238E27FC236}">
                <a16:creationId xmlns:a16="http://schemas.microsoft.com/office/drawing/2014/main" id="{EC08BA99-8D2B-823F-C9FD-A1DFE4F1875D}"/>
              </a:ext>
            </a:extLst>
          </p:cNvPr>
          <p:cNvSpPr txBox="1"/>
          <p:nvPr/>
        </p:nvSpPr>
        <p:spPr>
          <a:xfrm>
            <a:off x="2561615" y="7796775"/>
            <a:ext cx="1693092" cy="276999"/>
          </a:xfrm>
          <a:prstGeom prst="rect">
            <a:avLst/>
          </a:prstGeom>
          <a:noFill/>
        </p:spPr>
        <p:txBody>
          <a:bodyPr wrap="none" rtlCol="0">
            <a:spAutoFit/>
          </a:bodyPr>
          <a:lstStyle/>
          <a:p>
            <a:r>
              <a:rPr lang="en-US" sz="1200" dirty="0">
                <a:solidFill>
                  <a:schemeClr val="bg1"/>
                </a:solidFill>
                <a:latin typeface="Times New Roman" panose="02020603050405020304" pitchFamily="18" charset="0"/>
                <a:cs typeface="Times New Roman" panose="02020603050405020304" pitchFamily="18" charset="0"/>
              </a:rPr>
              <a:t>Migrated monocytes: 10</a:t>
            </a:r>
          </a:p>
        </p:txBody>
      </p:sp>
    </p:spTree>
    <p:extLst>
      <p:ext uri="{BB962C8B-B14F-4D97-AF65-F5344CB8AC3E}">
        <p14:creationId xmlns:p14="http://schemas.microsoft.com/office/powerpoint/2010/main" val="222987662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7dc4a216-e2a0-4ad6-a279-b8d2b2a31381" xsi:nil="true"/>
    <lcf76f155ced4ddcb4097134ff3c332f xmlns="c6d5703c-c057-4ed0-b4dd-802d19e4db58">
      <Terms xmlns="http://schemas.microsoft.com/office/infopath/2007/PartnerControls"/>
    </lcf76f155ced4ddcb4097134ff3c332f>
    <Thumbnail xmlns="c6d5703c-c057-4ed0-b4dd-802d19e4db58" xsi:nil="true"/>
    <_Flow_SignoffStatus xmlns="c6d5703c-c057-4ed0-b4dd-802d19e4db58" xsi:nil="true"/>
    <_x30ea__x30f3__x30af__x5148_ xmlns="c6d5703c-c057-4ed0-b4dd-802d19e4db58">
      <Url xsi:nil="true"/>
      <Description xsi:nil="true"/>
    </_x30ea__x30f3__x30af__x5148_>
    <_x753b__x50cf_ xmlns="c6d5703c-c057-4ed0-b4dd-802d19e4db58" xsi:nil="true"/>
    <_dlc_DocId xmlns="7dc4a216-e2a0-4ad6-a279-b8d2b2a31381">S2646E5R4Z5P-1853182900-2672440</_dlc_DocId>
    <_dlc_DocIdUrl xmlns="7dc4a216-e2a0-4ad6-a279-b8d2b2a31381">
      <Url>https://jticorp.sharepoint.com/sites/int_20200134/_layouts/15/DocIdRedir.aspx?ID=S2646E5R4Z5P-1853182900-2672440</Url>
      <Description>S2646E5R4Z5P-1853182900-2672440</Description>
    </_dlc_DocIdUrl>
  </documentManagement>
</p:properties>
</file>

<file path=customXml/item2.xml><?xml version="1.0" encoding="utf-8"?>
<ct:contentTypeSchema xmlns:ct="http://schemas.microsoft.com/office/2006/metadata/contentType" xmlns:ma="http://schemas.microsoft.com/office/2006/metadata/properties/metaAttributes" ct:_="" ma:_="" ma:contentTypeName="ドキュメント" ma:contentTypeID="0x010100398BA57FD6505B47A44500DC1496B414" ma:contentTypeVersion="31" ma:contentTypeDescription="新しいドキュメントを作成します。" ma:contentTypeScope="" ma:versionID="dcf5ce51731f16698374917b451ad73f">
  <xsd:schema xmlns:xsd="http://www.w3.org/2001/XMLSchema" xmlns:xs="http://www.w3.org/2001/XMLSchema" xmlns:p="http://schemas.microsoft.com/office/2006/metadata/properties" xmlns:ns2="c6d5703c-c057-4ed0-b4dd-802d19e4db58" xmlns:ns3="7dc4a216-e2a0-4ad6-a279-b8d2b2a31381" targetNamespace="http://schemas.microsoft.com/office/2006/metadata/properties" ma:root="true" ma:fieldsID="d32f1e51dda9be641f605fc2ab274985" ns2:_="" ns3:_="">
    <xsd:import namespace="c6d5703c-c057-4ed0-b4dd-802d19e4db58"/>
    <xsd:import namespace="7dc4a216-e2a0-4ad6-a279-b8d2b2a31381"/>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DateTaken" minOccurs="0"/>
                <xsd:element ref="ns2:MediaServiceOCR" minOccurs="0"/>
                <xsd:element ref="ns2:MediaLengthInSeconds" minOccurs="0"/>
                <xsd:element ref="ns2:MediaServiceLocation" minOccurs="0"/>
                <xsd:element ref="ns2:_Flow_SignoffStatus" minOccurs="0"/>
                <xsd:element ref="ns2:_x30ea__x30f3__x30af__x5148_" minOccurs="0"/>
                <xsd:element ref="ns2:lcf76f155ced4ddcb4097134ff3c332f" minOccurs="0"/>
                <xsd:element ref="ns3:TaxCatchAll" minOccurs="0"/>
                <xsd:element ref="ns2:_x753b__x50cf_" minOccurs="0"/>
                <xsd:element ref="ns2:MediaServiceObjectDetectorVersions" minOccurs="0"/>
                <xsd:element ref="ns2:Thumbnail" minOccurs="0"/>
                <xsd:element ref="ns2:MediaServiceSearchProperties" minOccurs="0"/>
                <xsd:element ref="ns3:_dlc_DocId" minOccurs="0"/>
                <xsd:element ref="ns3:_dlc_DocIdUrl" minOccurs="0"/>
                <xsd:element ref="ns3:_dlc_DocIdPersistId"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6d5703c-c057-4ed0-b4dd-802d19e4db58" elementFormDefault="qualified">
    <xsd:import namespace="http://schemas.microsoft.com/office/2006/documentManagement/types"/>
    <xsd:import namespace="http://schemas.microsoft.com/office/infopath/2007/PartnerControls"/>
    <xsd:element name="MediaServiceMetadata" ma:index="4" nillable="true" ma:displayName="MediaServiceMetadata" ma:hidden="true" ma:internalName="MediaServiceMetadata" ma:readOnly="true">
      <xsd:simpleType>
        <xsd:restriction base="dms:Note"/>
      </xsd:simpleType>
    </xsd:element>
    <xsd:element name="MediaServiceFastMetadata" ma:index="5" nillable="true" ma:displayName="MediaServiceFastMetadata" ma:hidden="true" ma:internalName="MediaServiceFastMetadata" ma:readOnly="true">
      <xsd:simpleType>
        <xsd:restriction base="dms:Note"/>
      </xsd:simpleType>
    </xsd:element>
    <xsd:element name="MediaServiceAutoKeyPoints" ma:index="6" nillable="true" ma:displayName="MediaServiceAutoKeyPoints" ma:hidden="true" ma:internalName="MediaServiceAutoKeyPoints" ma:readOnly="true">
      <xsd:simpleType>
        <xsd:restriction base="dms:Note"/>
      </xsd:simpleType>
    </xsd:element>
    <xsd:element name="MediaServiceKeyPoints" ma:index="7" nillable="true" ma:displayName="KeyPoints" ma:internalName="MediaServiceKeyPoints" ma:readOnly="true">
      <xsd:simpleType>
        <xsd:restriction base="dms:Note">
          <xsd:maxLength value="255"/>
        </xsd:restriction>
      </xsd:simpleType>
    </xsd:element>
    <xsd:element name="MediaServiceAutoTags" ma:index="8" nillable="true" ma:displayName="Tags" ma:internalName="MediaServiceAutoTags" ma:readOnly="true">
      <xsd:simpleType>
        <xsd:restriction base="dms:Text"/>
      </xsd:simpleType>
    </xsd:element>
    <xsd:element name="MediaServiceGenerationTime" ma:index="9" nillable="true" ma:displayName="MediaServiceGenerationTime" ma:hidden="true" ma:internalName="MediaServiceGenerationTime" ma:readOnly="true">
      <xsd:simpleType>
        <xsd:restriction base="dms:Text"/>
      </xsd:simpleType>
    </xsd:element>
    <xsd:element name="MediaServiceEventHashCode" ma:index="10" nillable="true" ma:displayName="MediaServiceEventHashCode" ma:hidden="true" ma:internalName="MediaServiceEventHashCode" ma:readOnly="true">
      <xsd:simpleType>
        <xsd:restriction base="dms:Text"/>
      </xsd:simpleType>
    </xsd:element>
    <xsd:element name="MediaServiceDateTaken" ma:index="11" nillable="true" ma:displayName="MediaServiceDateTaken" ma:hidden="true" ma:internalName="MediaServiceDateTaken" ma:readOnly="true">
      <xsd:simpleType>
        <xsd:restriction base="dms:Text"/>
      </xsd:simpleType>
    </xsd:element>
    <xsd:element name="MediaServiceOCR" ma:index="12" nillable="true" ma:displayName="Extracted Text" ma:internalName="MediaServiceOCR" ma:readOnly="true">
      <xsd:simpleType>
        <xsd:restriction base="dms:Note">
          <xsd:maxLength value="255"/>
        </xsd:restriction>
      </xsd:simpleType>
    </xsd:element>
    <xsd:element name="MediaLengthInSeconds" ma:index="13" nillable="true" ma:displayName="MediaLengthInSeconds" ma:description="" ma:internalName="MediaLengthInSeconds" ma:readOnly="true">
      <xsd:simpleType>
        <xsd:restriction base="dms:Unknown"/>
      </xsd:simpleType>
    </xsd:element>
    <xsd:element name="MediaServiceLocation" ma:index="14" nillable="true" ma:displayName="Location" ma:internalName="MediaServiceLocation" ma:readOnly="true">
      <xsd:simpleType>
        <xsd:restriction base="dms:Text"/>
      </xsd:simpleType>
    </xsd:element>
    <xsd:element name="_Flow_SignoffStatus" ma:index="15" nillable="true" ma:displayName="承認の状態" ma:internalName="_x627f__x8a8d__x306e__x72b6__x614b_" ma:readOnly="false">
      <xsd:simpleType>
        <xsd:restriction base="dms:Text"/>
      </xsd:simpleType>
    </xsd:element>
    <xsd:element name="_x30ea__x30f3__x30af__x5148_" ma:index="16" nillable="true" ma:displayName="リンク先" ma:format="Hyperlink" ma:internalName="_x30ea__x30f3__x30af__x5148_" ma:readOnly="false">
      <xsd:complexType>
        <xsd:complexContent>
          <xsd:extension base="dms:URL">
            <xsd:sequence>
              <xsd:element name="Url" type="dms:ValidUrl" minOccurs="0" nillable="true"/>
              <xsd:element name="Description" type="xsd:string" nillable="true"/>
            </xsd:sequence>
          </xsd:extension>
        </xsd:complexContent>
      </xsd:complexType>
    </xsd:element>
    <xsd:element name="lcf76f155ced4ddcb4097134ff3c332f" ma:index="22" nillable="true" ma:taxonomy="true" ma:internalName="lcf76f155ced4ddcb4097134ff3c332f" ma:taxonomyFieldName="MediaServiceImageTags" ma:displayName="画像タグ" ma:readOnly="false" ma:fieldId="{5cf76f15-5ced-4ddc-b409-7134ff3c332f}" ma:taxonomyMulti="true" ma:sspId="c3dfe741-475c-44cf-bcd4-46bfd3fd0691" ma:termSetId="09814cd3-568e-fe90-9814-8d621ff8fb84" ma:anchorId="fba54fb3-c3e1-fe81-a776-ca4b69148c4d" ma:open="true" ma:isKeyword="false">
      <xsd:complexType>
        <xsd:sequence>
          <xsd:element ref="pc:Terms" minOccurs="0" maxOccurs="1"/>
        </xsd:sequence>
      </xsd:complexType>
    </xsd:element>
    <xsd:element name="_x753b__x50cf_" ma:index="24" nillable="true" ma:displayName="画像" ma:format="Thumbnail" ma:internalName="_x753b__x50cf_">
      <xsd:simpleType>
        <xsd:restriction base="dms:Unknown"/>
      </xsd:simpleType>
    </xsd:element>
    <xsd:element name="MediaServiceObjectDetectorVersions" ma:index="25" nillable="true" ma:displayName="MediaServiceObjectDetectorVersions" ma:description="" ma:hidden="true" ma:indexed="true" ma:internalName="MediaServiceObjectDetectorVersions" ma:readOnly="true">
      <xsd:simpleType>
        <xsd:restriction base="dms:Text"/>
      </xsd:simpleType>
    </xsd:element>
    <xsd:element name="Thumbnail" ma:index="26" nillable="true" ma:displayName="Thumbnail" ma:format="Dropdown" ma:internalName="Thumbnail">
      <xsd:simpleType>
        <xsd:restriction base="dms:Text">
          <xsd:maxLength value="255"/>
        </xsd:restriction>
      </xsd:simpleType>
    </xsd:element>
    <xsd:element name="MediaServiceSearchProperties" ma:index="27" nillable="true" ma:displayName="MediaServiceSearchProperties" ma:hidden="true" ma:internalName="MediaServiceSearchProperties" ma:readOnly="true">
      <xsd:simpleType>
        <xsd:restriction base="dms:Note"/>
      </xsd:simpleType>
    </xsd:element>
    <xsd:element name="MediaServiceBillingMetadata" ma:index="31"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c4a216-e2a0-4ad6-a279-b8d2b2a31381" elementFormDefault="qualified">
    <xsd:import namespace="http://schemas.microsoft.com/office/2006/documentManagement/types"/>
    <xsd:import namespace="http://schemas.microsoft.com/office/infopath/2007/PartnerControls"/>
    <xsd:element name="TaxCatchAll" ma:index="23" nillable="true" ma:displayName="Taxonomy Catch All Column" ma:hidden="true" ma:list="{3c8caa68-1861-4169-bfa1-4e47408c27ba}" ma:internalName="TaxCatchAll" ma:showField="CatchAllData" ma:web="7dc4a216-e2a0-4ad6-a279-b8d2b2a31381">
      <xsd:complexType>
        <xsd:complexContent>
          <xsd:extension base="dms:MultiChoiceLookup">
            <xsd:sequence>
              <xsd:element name="Value" type="dms:Lookup" maxOccurs="unbounded" minOccurs="0" nillable="true"/>
            </xsd:sequence>
          </xsd:extension>
        </xsd:complexContent>
      </xsd:complexType>
    </xsd:element>
    <xsd:element name="_dlc_DocId" ma:index="28" nillable="true" ma:displayName="ドキュメント ID 値" ma:description="このアイテムに割り当てられているドキュメント ID の値です。" ma:indexed="true" ma:internalName="_dlc_DocId" ma:readOnly="true">
      <xsd:simpleType>
        <xsd:restriction base="dms:Text"/>
      </xsd:simpleType>
    </xsd:element>
    <xsd:element name="_dlc_DocIdUrl" ma:index="29" nillable="true" ma:displayName="ドキュメントID:" ma:description="このドキュメントへの常時接続リンクです。"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30" nillable="true" ma:displayName="ID を保持" ma:description="追加時に ID を保持します。"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17" ma:displayName="コンテンツ タイプ"/>
        <xsd:element ref="dc:title" minOccurs="0" maxOccurs="1" ma:index="3"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spe:Receivers xmlns:spe="http://schemas.microsoft.com/sharepoint/events">
  <Receiver>
    <Name>Document ID Generator</Name>
    <Synchronization>Synchronous</Synchronization>
    <Type>10001</Type>
    <SequenceNumber>1000</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2</Type>
    <SequenceNumber>1001</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4</Type>
    <SequenceNumber>1002</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6</Type>
    <SequenceNumber>1003</SequenceNumber>
    <Url/>
    <Assembly>Microsoft.Office.DocumentManagement, Version=16.0.0.0, Culture=neutral, PublicKeyToken=71e9bce111e9429c</Assembly>
    <Class>Microsoft.Office.DocumentManagement.Internal.DocIdHandler</Class>
    <Data/>
    <Filter/>
  </Receiver>
</spe:Receivers>
</file>

<file path=customXml/item4.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A91773B-595D-42F3-AF98-CFED6A4EC8A7}">
  <ds:schemaRefs>
    <ds:schemaRef ds:uri="7dc4a216-e2a0-4ad6-a279-b8d2b2a31381"/>
    <ds:schemaRef ds:uri="http://www.w3.org/XML/1998/namespace"/>
    <ds:schemaRef ds:uri="http://purl.org/dc/elements/1.1/"/>
    <ds:schemaRef ds:uri="http://schemas.microsoft.com/office/2006/metadata/properties"/>
    <ds:schemaRef ds:uri="http://purl.org/dc/dcmitype/"/>
    <ds:schemaRef ds:uri="http://schemas.microsoft.com/office/2006/documentManagement/types"/>
    <ds:schemaRef ds:uri="http://schemas.microsoft.com/office/infopath/2007/PartnerControls"/>
    <ds:schemaRef ds:uri="http://schemas.openxmlformats.org/package/2006/metadata/core-properties"/>
    <ds:schemaRef ds:uri="c6d5703c-c057-4ed0-b4dd-802d19e4db58"/>
    <ds:schemaRef ds:uri="http://purl.org/dc/terms/"/>
  </ds:schemaRefs>
</ds:datastoreItem>
</file>

<file path=customXml/itemProps2.xml><?xml version="1.0" encoding="utf-8"?>
<ds:datastoreItem xmlns:ds="http://schemas.openxmlformats.org/officeDocument/2006/customXml" ds:itemID="{F5F8D8EE-7786-4D53-A95E-490715FE94E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6d5703c-c057-4ed0-b4dd-802d19e4db58"/>
    <ds:schemaRef ds:uri="7dc4a216-e2a0-4ad6-a279-b8d2b2a3138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02CFB50F-8D4D-4548-A359-062464F4861B}">
  <ds:schemaRefs>
    <ds:schemaRef ds:uri="http://schemas.microsoft.com/sharepoint/events"/>
  </ds:schemaRefs>
</ds:datastoreItem>
</file>

<file path=customXml/itemProps4.xml><?xml version="1.0" encoding="utf-8"?>
<ds:datastoreItem xmlns:ds="http://schemas.openxmlformats.org/officeDocument/2006/customXml" ds:itemID="{A038B5D2-5121-4473-9C91-888847AB46DC}">
  <ds:schemaRefs>
    <ds:schemaRef ds:uri="http://schemas.microsoft.com/sharepoint/v3/contenttype/forms"/>
  </ds:schemaRefs>
</ds:datastoreItem>
</file>

<file path=docMetadata/LabelInfo.xml><?xml version="1.0" encoding="utf-8"?>
<clbl:labelList xmlns:clbl="http://schemas.microsoft.com/office/2020/mipLabelMetadata">
  <clbl:label id="{b020b37f-db72-473e-ae54-fb16df408069}" enabled="1" method="Standard" siteId="{705d07a3-2eea-4f3b-ab59-65ca29abeb26}" contentBits="0" removed="0"/>
</clbl:labelList>
</file>

<file path=docProps/app.xml><?xml version="1.0" encoding="utf-8"?>
<Properties xmlns="http://schemas.openxmlformats.org/officeDocument/2006/extended-properties" xmlns:vt="http://schemas.openxmlformats.org/officeDocument/2006/docPropsVTypes">
  <Template>Office Theme</Template>
  <TotalTime>1541</TotalTime>
  <Words>1155</Words>
  <Application>Microsoft Office PowerPoint</Application>
  <PresentationFormat>A4 210 x 297 mm</PresentationFormat>
  <Paragraphs>59</Paragraphs>
  <Slides>8</Slides>
  <Notes>8</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8</vt:i4>
      </vt:variant>
    </vt:vector>
  </HeadingPairs>
  <TitlesOfParts>
    <vt:vector size="13" baseType="lpstr">
      <vt:lpstr>Aptos</vt:lpstr>
      <vt:lpstr>Aptos Display</vt:lpstr>
      <vt:lpstr>Aria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ayashida, Ayaka</dc:creator>
  <cp:lastModifiedBy>Hayashida, Ayaka</cp:lastModifiedBy>
  <cp:revision>4</cp:revision>
  <dcterms:created xsi:type="dcterms:W3CDTF">2025-08-18T01:30:01Z</dcterms:created>
  <dcterms:modified xsi:type="dcterms:W3CDTF">2025-08-25T04:36:5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98BA57FD6505B47A44500DC1496B414</vt:lpwstr>
  </property>
  <property fmtid="{D5CDD505-2E9C-101B-9397-08002B2CF9AE}" pid="3" name="_dlc_DocIdItemGuid">
    <vt:lpwstr>fb37f6a7-11a5-4a8c-a205-e9aebc480531</vt:lpwstr>
  </property>
  <property fmtid="{D5CDD505-2E9C-101B-9397-08002B2CF9AE}" pid="4" name="MediaServiceImageTags">
    <vt:lpwstr/>
  </property>
</Properties>
</file>